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6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5E5E3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23"/>
    <p:restoredTop sz="94646"/>
  </p:normalViewPr>
  <p:slideViewPr>
    <p:cSldViewPr snapToGrid="0">
      <p:cViewPr varScale="1">
        <p:scale>
          <a:sx n="75" d="100"/>
          <a:sy n="75" d="100"/>
        </p:scale>
        <p:origin x="3416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ivalingam, Jeyaluxmy" userId="96f68579-a127-49fa-9da1-6d3ea75fe666" providerId="ADAL" clId="{3D8F079B-8C18-4C6D-B251-354CC8A72358}"/>
    <pc:docChg chg="undo redo custSel addSld delSld modSld sldOrd">
      <pc:chgData name="Sivalingam, Jeyaluxmy" userId="96f68579-a127-49fa-9da1-6d3ea75fe666" providerId="ADAL" clId="{3D8F079B-8C18-4C6D-B251-354CC8A72358}" dt="2025-12-23T08:29:52.220" v="14921" actId="14100"/>
      <pc:docMkLst>
        <pc:docMk/>
      </pc:docMkLst>
      <pc:sldChg chg="addSp delSp modSp mod">
        <pc:chgData name="Sivalingam, Jeyaluxmy" userId="96f68579-a127-49fa-9da1-6d3ea75fe666" providerId="ADAL" clId="{3D8F079B-8C18-4C6D-B251-354CC8A72358}" dt="2025-12-13T07:03:55.283" v="10548" actId="1035"/>
        <pc:sldMkLst>
          <pc:docMk/>
          <pc:sldMk cId="3347007978" sldId="257"/>
        </pc:sldMkLst>
        <pc:spChg chg="mod">
          <ac:chgData name="Sivalingam, Jeyaluxmy" userId="96f68579-a127-49fa-9da1-6d3ea75fe666" providerId="ADAL" clId="{3D8F079B-8C18-4C6D-B251-354CC8A72358}" dt="2025-11-27T21:40:39.822" v="4010" actId="1038"/>
          <ac:spMkLst>
            <pc:docMk/>
            <pc:sldMk cId="3347007978" sldId="257"/>
            <ac:spMk id="4" creationId="{62D1526C-1239-E591-7F2B-E73BE58F6559}"/>
          </ac:spMkLst>
        </pc:spChg>
        <pc:spChg chg="mod">
          <ac:chgData name="Sivalingam, Jeyaluxmy" userId="96f68579-a127-49fa-9da1-6d3ea75fe666" providerId="ADAL" clId="{3D8F079B-8C18-4C6D-B251-354CC8A72358}" dt="2025-11-27T21:41:17.961" v="4023" actId="554"/>
          <ac:spMkLst>
            <pc:docMk/>
            <pc:sldMk cId="3347007978" sldId="257"/>
            <ac:spMk id="7" creationId="{6F60B9DB-09A3-7351-E8F8-83953ECF5196}"/>
          </ac:spMkLst>
        </pc:spChg>
        <pc:spChg chg="mod">
          <ac:chgData name="Sivalingam, Jeyaluxmy" userId="96f68579-a127-49fa-9da1-6d3ea75fe666" providerId="ADAL" clId="{3D8F079B-8C18-4C6D-B251-354CC8A72358}" dt="2025-11-27T21:40:39.822" v="4010" actId="1038"/>
          <ac:spMkLst>
            <pc:docMk/>
            <pc:sldMk cId="3347007978" sldId="257"/>
            <ac:spMk id="8" creationId="{CC1E0210-E442-EB54-801F-33B025CF7D16}"/>
          </ac:spMkLst>
        </pc:spChg>
        <pc:spChg chg="mod">
          <ac:chgData name="Sivalingam, Jeyaluxmy" userId="96f68579-a127-49fa-9da1-6d3ea75fe666" providerId="ADAL" clId="{3D8F079B-8C18-4C6D-B251-354CC8A72358}" dt="2025-11-27T21:42:04.301" v="4029" actId="552"/>
          <ac:spMkLst>
            <pc:docMk/>
            <pc:sldMk cId="3347007978" sldId="257"/>
            <ac:spMk id="13" creationId="{F6DC2DC4-1CA8-1BC7-3CA9-C4C22290DF71}"/>
          </ac:spMkLst>
        </pc:spChg>
        <pc:spChg chg="mod">
          <ac:chgData name="Sivalingam, Jeyaluxmy" userId="96f68579-a127-49fa-9da1-6d3ea75fe666" providerId="ADAL" clId="{3D8F079B-8C18-4C6D-B251-354CC8A72358}" dt="2025-11-27T20:34:44.499" v="2752" actId="2711"/>
          <ac:spMkLst>
            <pc:docMk/>
            <pc:sldMk cId="3347007978" sldId="257"/>
            <ac:spMk id="14" creationId="{CE436304-7634-42E6-16A6-87BCDE9C0364}"/>
          </ac:spMkLst>
        </pc:spChg>
        <pc:spChg chg="mod">
          <ac:chgData name="Sivalingam, Jeyaluxmy" userId="96f68579-a127-49fa-9da1-6d3ea75fe666" providerId="ADAL" clId="{3D8F079B-8C18-4C6D-B251-354CC8A72358}" dt="2025-11-27T21:40:39.822" v="4010" actId="1038"/>
          <ac:spMkLst>
            <pc:docMk/>
            <pc:sldMk cId="3347007978" sldId="257"/>
            <ac:spMk id="15" creationId="{96988B4E-A235-939E-3BC1-E4380F85C3C1}"/>
          </ac:spMkLst>
        </pc:spChg>
        <pc:spChg chg="mod">
          <ac:chgData name="Sivalingam, Jeyaluxmy" userId="96f68579-a127-49fa-9da1-6d3ea75fe666" providerId="ADAL" clId="{3D8F079B-8C18-4C6D-B251-354CC8A72358}" dt="2025-11-27T20:34:44.499" v="2752" actId="2711"/>
          <ac:spMkLst>
            <pc:docMk/>
            <pc:sldMk cId="3347007978" sldId="257"/>
            <ac:spMk id="16" creationId="{72331516-7DB5-3127-F778-5B61BF46A69B}"/>
          </ac:spMkLst>
        </pc:spChg>
        <pc:spChg chg="mod">
          <ac:chgData name="Sivalingam, Jeyaluxmy" userId="96f68579-a127-49fa-9da1-6d3ea75fe666" providerId="ADAL" clId="{3D8F079B-8C18-4C6D-B251-354CC8A72358}" dt="2025-11-27T21:41:17.961" v="4023" actId="554"/>
          <ac:spMkLst>
            <pc:docMk/>
            <pc:sldMk cId="3347007978" sldId="257"/>
            <ac:spMk id="19" creationId="{BEDDD868-A360-CA36-B3F0-38E395C4DF6A}"/>
          </ac:spMkLst>
        </pc:spChg>
        <pc:spChg chg="mod">
          <ac:chgData name="Sivalingam, Jeyaluxmy" userId="96f68579-a127-49fa-9da1-6d3ea75fe666" providerId="ADAL" clId="{3D8F079B-8C18-4C6D-B251-354CC8A72358}" dt="2025-11-27T21:42:04.301" v="4029" actId="552"/>
          <ac:spMkLst>
            <pc:docMk/>
            <pc:sldMk cId="3347007978" sldId="257"/>
            <ac:spMk id="20" creationId="{C537E5FC-FAC7-5183-E73D-3A00C5E9D341}"/>
          </ac:spMkLst>
        </pc:spChg>
        <pc:spChg chg="mod">
          <ac:chgData name="Sivalingam, Jeyaluxmy" userId="96f68579-a127-49fa-9da1-6d3ea75fe666" providerId="ADAL" clId="{3D8F079B-8C18-4C6D-B251-354CC8A72358}" dt="2025-11-27T20:58:48.369" v="3908" actId="554"/>
          <ac:spMkLst>
            <pc:docMk/>
            <pc:sldMk cId="3347007978" sldId="257"/>
            <ac:spMk id="21" creationId="{0B6D9C70-E9CF-919D-4A3B-F7B693FF3747}"/>
          </ac:spMkLst>
        </pc:spChg>
        <pc:spChg chg="mod topLvl">
          <ac:chgData name="Sivalingam, Jeyaluxmy" userId="96f68579-a127-49fa-9da1-6d3ea75fe666" providerId="ADAL" clId="{3D8F079B-8C18-4C6D-B251-354CC8A72358}" dt="2025-12-13T05:46:05.459" v="9591" actId="165"/>
          <ac:spMkLst>
            <pc:docMk/>
            <pc:sldMk cId="3347007978" sldId="257"/>
            <ac:spMk id="24" creationId="{76DE4CDF-8705-B499-99CE-2BA1BD6E3241}"/>
          </ac:spMkLst>
        </pc:spChg>
        <pc:spChg chg="mod topLvl">
          <ac:chgData name="Sivalingam, Jeyaluxmy" userId="96f68579-a127-49fa-9da1-6d3ea75fe666" providerId="ADAL" clId="{3D8F079B-8C18-4C6D-B251-354CC8A72358}" dt="2025-12-13T05:46:05.459" v="9591" actId="165"/>
          <ac:spMkLst>
            <pc:docMk/>
            <pc:sldMk cId="3347007978" sldId="257"/>
            <ac:spMk id="34" creationId="{28E01ECB-F906-8B71-2D61-D86A2F1BCE33}"/>
          </ac:spMkLst>
        </pc:spChg>
        <pc:spChg chg="mod topLvl">
          <ac:chgData name="Sivalingam, Jeyaluxmy" userId="96f68579-a127-49fa-9da1-6d3ea75fe666" providerId="ADAL" clId="{3D8F079B-8C18-4C6D-B251-354CC8A72358}" dt="2025-12-13T05:46:05.459" v="9591" actId="165"/>
          <ac:spMkLst>
            <pc:docMk/>
            <pc:sldMk cId="3347007978" sldId="257"/>
            <ac:spMk id="37" creationId="{5790DB67-0E91-EB05-D3EA-D0529804FB89}"/>
          </ac:spMkLst>
        </pc:spChg>
        <pc:spChg chg="mod topLvl">
          <ac:chgData name="Sivalingam, Jeyaluxmy" userId="96f68579-a127-49fa-9da1-6d3ea75fe666" providerId="ADAL" clId="{3D8F079B-8C18-4C6D-B251-354CC8A72358}" dt="2025-12-13T05:46:05.459" v="9591" actId="165"/>
          <ac:spMkLst>
            <pc:docMk/>
            <pc:sldMk cId="3347007978" sldId="257"/>
            <ac:spMk id="39" creationId="{1D1C1B22-91A1-63A2-E883-8791B90277F5}"/>
          </ac:spMkLst>
        </pc:spChg>
        <pc:spChg chg="mod topLvl">
          <ac:chgData name="Sivalingam, Jeyaluxmy" userId="96f68579-a127-49fa-9da1-6d3ea75fe666" providerId="ADAL" clId="{3D8F079B-8C18-4C6D-B251-354CC8A72358}" dt="2025-12-13T05:46:44.238" v="9598" actId="1076"/>
          <ac:spMkLst>
            <pc:docMk/>
            <pc:sldMk cId="3347007978" sldId="257"/>
            <ac:spMk id="40" creationId="{42647501-4CF2-01D4-D524-446F4DE62153}"/>
          </ac:spMkLst>
        </pc:spChg>
        <pc:picChg chg="add mod modCrop">
          <ac:chgData name="Sivalingam, Jeyaluxmy" userId="96f68579-a127-49fa-9da1-6d3ea75fe666" providerId="ADAL" clId="{3D8F079B-8C18-4C6D-B251-354CC8A72358}" dt="2025-12-13T05:46:28.362" v="9595" actId="14100"/>
          <ac:picMkLst>
            <pc:docMk/>
            <pc:sldMk cId="3347007978" sldId="257"/>
            <ac:picMk id="5" creationId="{3BCBC92C-50C3-F2ED-18D7-C7D37DDD7CEC}"/>
          </ac:picMkLst>
        </pc:picChg>
        <pc:picChg chg="mod">
          <ac:chgData name="Sivalingam, Jeyaluxmy" userId="96f68579-a127-49fa-9da1-6d3ea75fe666" providerId="ADAL" clId="{3D8F079B-8C18-4C6D-B251-354CC8A72358}" dt="2025-11-27T21:40:15.984" v="4001" actId="554"/>
          <ac:picMkLst>
            <pc:docMk/>
            <pc:sldMk cId="3347007978" sldId="257"/>
            <ac:picMk id="12" creationId="{2B7B6AB4-6583-43AA-D4D4-DE9DFF9CFE28}"/>
          </ac:picMkLst>
        </pc:picChg>
        <pc:picChg chg="mod">
          <ac:chgData name="Sivalingam, Jeyaluxmy" userId="96f68579-a127-49fa-9da1-6d3ea75fe666" providerId="ADAL" clId="{3D8F079B-8C18-4C6D-B251-354CC8A72358}" dt="2025-11-27T21:39:36.376" v="3980" actId="554"/>
          <ac:picMkLst>
            <pc:docMk/>
            <pc:sldMk cId="3347007978" sldId="257"/>
            <ac:picMk id="17" creationId="{36935CA6-FB3A-D4D9-713F-6A92603E7C55}"/>
          </ac:picMkLst>
        </pc:picChg>
        <pc:picChg chg="mod">
          <ac:chgData name="Sivalingam, Jeyaluxmy" userId="96f68579-a127-49fa-9da1-6d3ea75fe666" providerId="ADAL" clId="{3D8F079B-8C18-4C6D-B251-354CC8A72358}" dt="2025-11-27T21:41:05.620" v="4022" actId="1036"/>
          <ac:picMkLst>
            <pc:docMk/>
            <pc:sldMk cId="3347007978" sldId="257"/>
            <ac:picMk id="25" creationId="{971694A4-76DF-9538-9824-17DAA4D95FAE}"/>
          </ac:picMkLst>
        </pc:picChg>
        <pc:picChg chg="mod topLvl">
          <ac:chgData name="Sivalingam, Jeyaluxmy" userId="96f68579-a127-49fa-9da1-6d3ea75fe666" providerId="ADAL" clId="{3D8F079B-8C18-4C6D-B251-354CC8A72358}" dt="2025-12-13T05:46:38.594" v="9597" actId="1036"/>
          <ac:picMkLst>
            <pc:docMk/>
            <pc:sldMk cId="3347007978" sldId="257"/>
            <ac:picMk id="29" creationId="{0D190A63-A591-08CE-DD66-A93EA96EED59}"/>
          </ac:picMkLst>
        </pc:picChg>
        <pc:picChg chg="mod">
          <ac:chgData name="Sivalingam, Jeyaluxmy" userId="96f68579-a127-49fa-9da1-6d3ea75fe666" providerId="ADAL" clId="{3D8F079B-8C18-4C6D-B251-354CC8A72358}" dt="2025-11-27T21:39:24.962" v="3979" actId="1035"/>
          <ac:picMkLst>
            <pc:docMk/>
            <pc:sldMk cId="3347007978" sldId="257"/>
            <ac:picMk id="30" creationId="{E4985357-6B56-66FF-224E-4D58EC11DD66}"/>
          </ac:picMkLst>
        </pc:picChg>
        <pc:picChg chg="add mod modCrop">
          <ac:chgData name="Sivalingam, Jeyaluxmy" userId="96f68579-a127-49fa-9da1-6d3ea75fe666" providerId="ADAL" clId="{3D8F079B-8C18-4C6D-B251-354CC8A72358}" dt="2025-11-27T21:39:36.376" v="3980" actId="554"/>
          <ac:picMkLst>
            <pc:docMk/>
            <pc:sldMk cId="3347007978" sldId="257"/>
            <ac:picMk id="32" creationId="{F79842A3-5617-082A-25AF-D68C55E07D5B}"/>
          </ac:picMkLst>
        </pc:picChg>
        <pc:picChg chg="mod topLvl modCrop">
          <ac:chgData name="Sivalingam, Jeyaluxmy" userId="96f68579-a127-49fa-9da1-6d3ea75fe666" providerId="ADAL" clId="{3D8F079B-8C18-4C6D-B251-354CC8A72358}" dt="2025-12-13T05:46:19.595" v="9594" actId="552"/>
          <ac:picMkLst>
            <pc:docMk/>
            <pc:sldMk cId="3347007978" sldId="257"/>
            <ac:picMk id="33" creationId="{0C5A5264-877C-3AF0-2E81-78B861377F0C}"/>
          </ac:picMkLst>
        </pc:picChg>
        <pc:picChg chg="mod">
          <ac:chgData name="Sivalingam, Jeyaluxmy" userId="96f68579-a127-49fa-9da1-6d3ea75fe666" providerId="ADAL" clId="{3D8F079B-8C18-4C6D-B251-354CC8A72358}" dt="2025-11-27T21:39:36.376" v="3980" actId="554"/>
          <ac:picMkLst>
            <pc:docMk/>
            <pc:sldMk cId="3347007978" sldId="257"/>
            <ac:picMk id="35" creationId="{3B6DD371-760C-AA50-E5DF-CF2E88BE9CE9}"/>
          </ac:picMkLst>
        </pc:picChg>
        <pc:picChg chg="mod">
          <ac:chgData name="Sivalingam, Jeyaluxmy" userId="96f68579-a127-49fa-9da1-6d3ea75fe666" providerId="ADAL" clId="{3D8F079B-8C18-4C6D-B251-354CC8A72358}" dt="2025-11-27T21:41:29.561" v="4027" actId="1038"/>
          <ac:picMkLst>
            <pc:docMk/>
            <pc:sldMk cId="3347007978" sldId="257"/>
            <ac:picMk id="36" creationId="{53A5DF70-A228-0BEE-9C62-A0CB57FEEA10}"/>
          </ac:picMkLst>
        </pc:picChg>
        <pc:picChg chg="mod">
          <ac:chgData name="Sivalingam, Jeyaluxmy" userId="96f68579-a127-49fa-9da1-6d3ea75fe666" providerId="ADAL" clId="{3D8F079B-8C18-4C6D-B251-354CC8A72358}" dt="2025-12-13T07:03:35.257" v="10520" actId="552"/>
          <ac:picMkLst>
            <pc:docMk/>
            <pc:sldMk cId="3347007978" sldId="257"/>
            <ac:picMk id="38" creationId="{7325FB4D-B787-1997-7593-79AFF5C2DFC3}"/>
          </ac:picMkLst>
        </pc:picChg>
        <pc:picChg chg="add mod topLvl">
          <ac:chgData name="Sivalingam, Jeyaluxmy" userId="96f68579-a127-49fa-9da1-6d3ea75fe666" providerId="ADAL" clId="{3D8F079B-8C18-4C6D-B251-354CC8A72358}" dt="2025-12-13T05:46:19.595" v="9594" actId="552"/>
          <ac:picMkLst>
            <pc:docMk/>
            <pc:sldMk cId="3347007978" sldId="257"/>
            <ac:picMk id="41" creationId="{1898528B-78E5-19E4-ECC6-8F24415C61B9}"/>
          </ac:picMkLst>
        </pc:picChg>
        <pc:picChg chg="mod">
          <ac:chgData name="Sivalingam, Jeyaluxmy" userId="96f68579-a127-49fa-9da1-6d3ea75fe666" providerId="ADAL" clId="{3D8F079B-8C18-4C6D-B251-354CC8A72358}" dt="2025-11-27T21:41:05.620" v="4022" actId="1036"/>
          <ac:picMkLst>
            <pc:docMk/>
            <pc:sldMk cId="3347007978" sldId="257"/>
            <ac:picMk id="55" creationId="{09D5457B-7CA8-D07F-CC1C-5990BA7588C9}"/>
          </ac:picMkLst>
        </pc:picChg>
        <pc:picChg chg="add mod">
          <ac:chgData name="Sivalingam, Jeyaluxmy" userId="96f68579-a127-49fa-9da1-6d3ea75fe666" providerId="ADAL" clId="{3D8F079B-8C18-4C6D-B251-354CC8A72358}" dt="2025-12-13T07:03:55.283" v="10548" actId="1035"/>
          <ac:picMkLst>
            <pc:docMk/>
            <pc:sldMk cId="3347007978" sldId="257"/>
            <ac:picMk id="57" creationId="{A1BD5E5B-DE95-D491-D569-05A2C28EA0EF}"/>
          </ac:picMkLst>
        </pc:picChg>
      </pc:sldChg>
      <pc:sldChg chg="addSp delSp modSp mod">
        <pc:chgData name="Sivalingam, Jeyaluxmy" userId="96f68579-a127-49fa-9da1-6d3ea75fe666" providerId="ADAL" clId="{3D8F079B-8C18-4C6D-B251-354CC8A72358}" dt="2025-12-19T07:19:11.037" v="12503" actId="1035"/>
        <pc:sldMkLst>
          <pc:docMk/>
          <pc:sldMk cId="488044088" sldId="258"/>
        </pc:sldMkLst>
        <pc:spChg chg="add mod">
          <ac:chgData name="Sivalingam, Jeyaluxmy" userId="96f68579-a127-49fa-9da1-6d3ea75fe666" providerId="ADAL" clId="{3D8F079B-8C18-4C6D-B251-354CC8A72358}" dt="2025-11-27T14:42:12.800" v="1484" actId="164"/>
          <ac:spMkLst>
            <pc:docMk/>
            <pc:sldMk cId="488044088" sldId="258"/>
            <ac:spMk id="22" creationId="{922D5AA3-AAFC-CA31-FC3E-28D0CE6126E4}"/>
          </ac:spMkLst>
        </pc:spChg>
        <pc:spChg chg="add mod">
          <ac:chgData name="Sivalingam, Jeyaluxmy" userId="96f68579-a127-49fa-9da1-6d3ea75fe666" providerId="ADAL" clId="{3D8F079B-8C18-4C6D-B251-354CC8A72358}" dt="2025-11-27T14:42:12.800" v="1484" actId="164"/>
          <ac:spMkLst>
            <pc:docMk/>
            <pc:sldMk cId="488044088" sldId="258"/>
            <ac:spMk id="23" creationId="{C38C6728-CAFB-FC20-62EE-2FBE29C6D0F2}"/>
          </ac:spMkLst>
        </pc:spChg>
        <pc:spChg chg="add mod">
          <ac:chgData name="Sivalingam, Jeyaluxmy" userId="96f68579-a127-49fa-9da1-6d3ea75fe666" providerId="ADAL" clId="{3D8F079B-8C18-4C6D-B251-354CC8A72358}" dt="2025-11-27T14:42:12.800" v="1484" actId="164"/>
          <ac:spMkLst>
            <pc:docMk/>
            <pc:sldMk cId="488044088" sldId="258"/>
            <ac:spMk id="24" creationId="{3572EF59-8959-55C2-FA83-0E946770983E}"/>
          </ac:spMkLst>
        </pc:spChg>
        <pc:grpChg chg="add mod ord topLvl">
          <ac:chgData name="Sivalingam, Jeyaluxmy" userId="96f68579-a127-49fa-9da1-6d3ea75fe666" providerId="ADAL" clId="{3D8F079B-8C18-4C6D-B251-354CC8A72358}" dt="2025-11-27T14:42:12.800" v="1484" actId="164"/>
          <ac:grpSpMkLst>
            <pc:docMk/>
            <pc:sldMk cId="488044088" sldId="258"/>
            <ac:grpSpMk id="14" creationId="{2B177C7C-7984-DDD9-AE5C-E55000701648}"/>
          </ac:grpSpMkLst>
        </pc:grpChg>
        <pc:grpChg chg="mod">
          <ac:chgData name="Sivalingam, Jeyaluxmy" userId="96f68579-a127-49fa-9da1-6d3ea75fe666" providerId="ADAL" clId="{3D8F079B-8C18-4C6D-B251-354CC8A72358}" dt="2025-12-19T07:18:33.810" v="12477" actId="1076"/>
          <ac:grpSpMkLst>
            <pc:docMk/>
            <pc:sldMk cId="488044088" sldId="258"/>
            <ac:grpSpMk id="20" creationId="{326EEA94-D8A2-F957-D129-141AD6BACBE5}"/>
          </ac:grpSpMkLst>
        </pc:grpChg>
        <pc:grpChg chg="add mod">
          <ac:chgData name="Sivalingam, Jeyaluxmy" userId="96f68579-a127-49fa-9da1-6d3ea75fe666" providerId="ADAL" clId="{3D8F079B-8C18-4C6D-B251-354CC8A72358}" dt="2025-12-13T07:00:12.847" v="10444" actId="14100"/>
          <ac:grpSpMkLst>
            <pc:docMk/>
            <pc:sldMk cId="488044088" sldId="258"/>
            <ac:grpSpMk id="25" creationId="{0E1DA5F7-63D5-9F37-0A59-6BF4E5A12AD3}"/>
          </ac:grpSpMkLst>
        </pc:grpChg>
        <pc:graphicFrameChg chg="mod">
          <ac:chgData name="Sivalingam, Jeyaluxmy" userId="96f68579-a127-49fa-9da1-6d3ea75fe666" providerId="ADAL" clId="{3D8F079B-8C18-4C6D-B251-354CC8A72358}" dt="2025-12-19T07:18:30.003" v="12476" actId="1076"/>
          <ac:graphicFrameMkLst>
            <pc:docMk/>
            <pc:sldMk cId="488044088" sldId="258"/>
            <ac:graphicFrameMk id="2" creationId="{323AE648-BAB4-629C-940C-8A29F3160276}"/>
          </ac:graphicFrameMkLst>
        </pc:graphicFrameChg>
        <pc:graphicFrameChg chg="add mod topLvl">
          <ac:chgData name="Sivalingam, Jeyaluxmy" userId="96f68579-a127-49fa-9da1-6d3ea75fe666" providerId="ADAL" clId="{3D8F079B-8C18-4C6D-B251-354CC8A72358}" dt="2025-12-13T06:59:21" v="10436" actId="1076"/>
          <ac:graphicFrameMkLst>
            <pc:docMk/>
            <pc:sldMk cId="488044088" sldId="258"/>
            <ac:graphicFrameMk id="4" creationId="{E99B5106-C6E7-4B76-A766-6897D9567D43}"/>
          </ac:graphicFrameMkLst>
        </pc:graphicFrameChg>
        <pc:graphicFrameChg chg="add mod topLvl">
          <ac:chgData name="Sivalingam, Jeyaluxmy" userId="96f68579-a127-49fa-9da1-6d3ea75fe666" providerId="ADAL" clId="{3D8F079B-8C18-4C6D-B251-354CC8A72358}" dt="2025-11-27T14:42:12.800" v="1484" actId="164"/>
          <ac:graphicFrameMkLst>
            <pc:docMk/>
            <pc:sldMk cId="488044088" sldId="258"/>
            <ac:graphicFrameMk id="5" creationId="{55445A86-CF4C-4A0A-900B-886443E5AAF5}"/>
          </ac:graphicFrameMkLst>
        </pc:graphicFrameChg>
        <pc:graphicFrameChg chg="add mod topLvl">
          <ac:chgData name="Sivalingam, Jeyaluxmy" userId="96f68579-a127-49fa-9da1-6d3ea75fe666" providerId="ADAL" clId="{3D8F079B-8C18-4C6D-B251-354CC8A72358}" dt="2025-11-27T14:42:12.800" v="1484" actId="164"/>
          <ac:graphicFrameMkLst>
            <pc:docMk/>
            <pc:sldMk cId="488044088" sldId="258"/>
            <ac:graphicFrameMk id="9" creationId="{78647C1F-24D4-456F-816A-6AA8D8896C56}"/>
          </ac:graphicFrameMkLst>
        </pc:graphicFrameChg>
        <pc:graphicFrameChg chg="add mod topLvl">
          <ac:chgData name="Sivalingam, Jeyaluxmy" userId="96f68579-a127-49fa-9da1-6d3ea75fe666" providerId="ADAL" clId="{3D8F079B-8C18-4C6D-B251-354CC8A72358}" dt="2025-12-19T07:18:58.344" v="12493" actId="1036"/>
          <ac:graphicFrameMkLst>
            <pc:docMk/>
            <pc:sldMk cId="488044088" sldId="258"/>
            <ac:graphicFrameMk id="12" creationId="{1216A40C-B77D-4968-952D-DFA53640890F}"/>
          </ac:graphicFrameMkLst>
        </pc:graphicFrameChg>
        <pc:cxnChg chg="add mod">
          <ac:chgData name="Sivalingam, Jeyaluxmy" userId="96f68579-a127-49fa-9da1-6d3ea75fe666" providerId="ADAL" clId="{3D8F079B-8C18-4C6D-B251-354CC8A72358}" dt="2025-12-19T07:19:11.037" v="12503" actId="1035"/>
          <ac:cxnSpMkLst>
            <pc:docMk/>
            <pc:sldMk cId="488044088" sldId="258"/>
            <ac:cxnSpMk id="15" creationId="{AC2141BE-3776-6517-0237-B15B24CA70C5}"/>
          </ac:cxnSpMkLst>
        </pc:cxnChg>
        <pc:cxnChg chg="add mod">
          <ac:chgData name="Sivalingam, Jeyaluxmy" userId="96f68579-a127-49fa-9da1-6d3ea75fe666" providerId="ADAL" clId="{3D8F079B-8C18-4C6D-B251-354CC8A72358}" dt="2025-12-19T07:19:11.037" v="12503" actId="1035"/>
          <ac:cxnSpMkLst>
            <pc:docMk/>
            <pc:sldMk cId="488044088" sldId="258"/>
            <ac:cxnSpMk id="18" creationId="{D3E63EB0-58F9-BDB7-EF36-184150762D79}"/>
          </ac:cxnSpMkLst>
        </pc:cxnChg>
      </pc:sldChg>
      <pc:sldChg chg="delSp modSp add mod">
        <pc:chgData name="Sivalingam, Jeyaluxmy" userId="96f68579-a127-49fa-9da1-6d3ea75fe666" providerId="ADAL" clId="{3D8F079B-8C18-4C6D-B251-354CC8A72358}" dt="2025-12-21T22:05:33.911" v="14273" actId="478"/>
        <pc:sldMkLst>
          <pc:docMk/>
          <pc:sldMk cId="2753984768" sldId="259"/>
        </pc:sldMkLst>
        <pc:grpChg chg="mod">
          <ac:chgData name="Sivalingam, Jeyaluxmy" userId="96f68579-a127-49fa-9da1-6d3ea75fe666" providerId="ADAL" clId="{3D8F079B-8C18-4C6D-B251-354CC8A72358}" dt="2025-12-21T22:03:37.041" v="14263" actId="14100"/>
          <ac:grpSpMkLst>
            <pc:docMk/>
            <pc:sldMk cId="2753984768" sldId="259"/>
            <ac:grpSpMk id="2" creationId="{1B993D81-8575-EF91-99CB-4A4EC9B3A88C}"/>
          </ac:grpSpMkLst>
        </pc:grpChg>
        <pc:graphicFrameChg chg="mod">
          <ac:chgData name="Sivalingam, Jeyaluxmy" userId="96f68579-a127-49fa-9da1-6d3ea75fe666" providerId="ADAL" clId="{3D8F079B-8C18-4C6D-B251-354CC8A72358}" dt="2025-12-21T22:03:44.426" v="14264"/>
          <ac:graphicFrameMkLst>
            <pc:docMk/>
            <pc:sldMk cId="2753984768" sldId="259"/>
            <ac:graphicFrameMk id="12" creationId="{AA47C14A-893E-7A6D-D815-EC28870C102F}"/>
          </ac:graphicFrameMkLst>
        </pc:graphicFrameChg>
      </pc:sldChg>
      <pc:sldChg chg="addSp modSp mod">
        <pc:chgData name="Sivalingam, Jeyaluxmy" userId="96f68579-a127-49fa-9da1-6d3ea75fe666" providerId="ADAL" clId="{3D8F079B-8C18-4C6D-B251-354CC8A72358}" dt="2025-12-21T22:05:25.889" v="14270" actId="14100"/>
        <pc:sldMkLst>
          <pc:docMk/>
          <pc:sldMk cId="1614047336" sldId="263"/>
        </pc:sldMkLst>
        <pc:picChg chg="add mod">
          <ac:chgData name="Sivalingam, Jeyaluxmy" userId="96f68579-a127-49fa-9da1-6d3ea75fe666" providerId="ADAL" clId="{3D8F079B-8C18-4C6D-B251-354CC8A72358}" dt="2025-12-13T06:59:11.571" v="10434" actId="1076"/>
          <ac:picMkLst>
            <pc:docMk/>
            <pc:sldMk cId="1614047336" sldId="263"/>
            <ac:picMk id="2" creationId="{55680E3B-5FF4-8678-F495-4F3358231DB1}"/>
          </ac:picMkLst>
        </pc:picChg>
        <pc:picChg chg="mod">
          <ac:chgData name="Sivalingam, Jeyaluxmy" userId="96f68579-a127-49fa-9da1-6d3ea75fe666" providerId="ADAL" clId="{3D8F079B-8C18-4C6D-B251-354CC8A72358}" dt="2025-12-21T22:05:25.889" v="14270" actId="14100"/>
          <ac:picMkLst>
            <pc:docMk/>
            <pc:sldMk cId="1614047336" sldId="263"/>
            <ac:picMk id="4" creationId="{23D3DA49-3855-9EEC-36B4-4EB8719BF8C9}"/>
          </ac:picMkLst>
        </pc:picChg>
        <pc:picChg chg="mod">
          <ac:chgData name="Sivalingam, Jeyaluxmy" userId="96f68579-a127-49fa-9da1-6d3ea75fe666" providerId="ADAL" clId="{3D8F079B-8C18-4C6D-B251-354CC8A72358}" dt="2025-12-08T03:13:32.992" v="6324" actId="1076"/>
          <ac:picMkLst>
            <pc:docMk/>
            <pc:sldMk cId="1614047336" sldId="263"/>
            <ac:picMk id="5" creationId="{BDA7D22F-62D3-E02E-CD14-9CFF6233A0E0}"/>
          </ac:picMkLst>
        </pc:picChg>
      </pc:sldChg>
      <pc:sldChg chg="addSp modSp mod">
        <pc:chgData name="Sivalingam, Jeyaluxmy" userId="96f68579-a127-49fa-9da1-6d3ea75fe666" providerId="ADAL" clId="{3D8F079B-8C18-4C6D-B251-354CC8A72358}" dt="2025-12-05T06:26:18.666" v="5673" actId="1076"/>
        <pc:sldMkLst>
          <pc:docMk/>
          <pc:sldMk cId="3943996364" sldId="267"/>
        </pc:sldMkLst>
        <pc:picChg chg="add mod">
          <ac:chgData name="Sivalingam, Jeyaluxmy" userId="96f68579-a127-49fa-9da1-6d3ea75fe666" providerId="ADAL" clId="{3D8F079B-8C18-4C6D-B251-354CC8A72358}" dt="2025-12-05T06:25:58.484" v="5668" actId="14100"/>
          <ac:picMkLst>
            <pc:docMk/>
            <pc:sldMk cId="3943996364" sldId="267"/>
            <ac:picMk id="3" creationId="{7AF901BA-14F7-AE10-3024-F34EE0E39C3C}"/>
          </ac:picMkLst>
        </pc:picChg>
        <pc:picChg chg="mod">
          <ac:chgData name="Sivalingam, Jeyaluxmy" userId="96f68579-a127-49fa-9da1-6d3ea75fe666" providerId="ADAL" clId="{3D8F079B-8C18-4C6D-B251-354CC8A72358}" dt="2025-12-05T06:24:49.084" v="5661" actId="1076"/>
          <ac:picMkLst>
            <pc:docMk/>
            <pc:sldMk cId="3943996364" sldId="267"/>
            <ac:picMk id="6" creationId="{3DFCCEC5-C990-27C3-9C48-BE2C26FA4468}"/>
          </ac:picMkLst>
        </pc:picChg>
        <pc:picChg chg="add mod">
          <ac:chgData name="Sivalingam, Jeyaluxmy" userId="96f68579-a127-49fa-9da1-6d3ea75fe666" providerId="ADAL" clId="{3D8F079B-8C18-4C6D-B251-354CC8A72358}" dt="2025-12-05T06:26:18.666" v="5673" actId="1076"/>
          <ac:picMkLst>
            <pc:docMk/>
            <pc:sldMk cId="3943996364" sldId="267"/>
            <ac:picMk id="7" creationId="{9142EA44-FCE1-0B83-812B-63F0E11B46DC}"/>
          </ac:picMkLst>
        </pc:picChg>
        <pc:picChg chg="mod">
          <ac:chgData name="Sivalingam, Jeyaluxmy" userId="96f68579-a127-49fa-9da1-6d3ea75fe666" providerId="ADAL" clId="{3D8F079B-8C18-4C6D-B251-354CC8A72358}" dt="2025-12-05T06:24:55.407" v="5663" actId="1076"/>
          <ac:picMkLst>
            <pc:docMk/>
            <pc:sldMk cId="3943996364" sldId="267"/>
            <ac:picMk id="8" creationId="{B6779870-596C-D3F7-5F15-D91E2256D72A}"/>
          </ac:picMkLst>
        </pc:picChg>
        <pc:picChg chg="mod">
          <ac:chgData name="Sivalingam, Jeyaluxmy" userId="96f68579-a127-49fa-9da1-6d3ea75fe666" providerId="ADAL" clId="{3D8F079B-8C18-4C6D-B251-354CC8A72358}" dt="2025-12-05T06:24:51.937" v="5662" actId="1076"/>
          <ac:picMkLst>
            <pc:docMk/>
            <pc:sldMk cId="3943996364" sldId="267"/>
            <ac:picMk id="12" creationId="{24AF34B8-DB79-55F4-45CB-D09CF3B37D74}"/>
          </ac:picMkLst>
        </pc:picChg>
      </pc:sldChg>
      <pc:sldChg chg="addSp modSp mod">
        <pc:chgData name="Sivalingam, Jeyaluxmy" userId="96f68579-a127-49fa-9da1-6d3ea75fe666" providerId="ADAL" clId="{3D8F079B-8C18-4C6D-B251-354CC8A72358}" dt="2025-12-17T05:22:31.247" v="12068" actId="1076"/>
        <pc:sldMkLst>
          <pc:docMk/>
          <pc:sldMk cId="3020779692" sldId="269"/>
        </pc:sldMkLst>
        <pc:grpChg chg="add mod">
          <ac:chgData name="Sivalingam, Jeyaluxmy" userId="96f68579-a127-49fa-9da1-6d3ea75fe666" providerId="ADAL" clId="{3D8F079B-8C18-4C6D-B251-354CC8A72358}" dt="2025-12-14T19:34:41.666" v="11225" actId="1076"/>
          <ac:grpSpMkLst>
            <pc:docMk/>
            <pc:sldMk cId="3020779692" sldId="269"/>
            <ac:grpSpMk id="2" creationId="{4DE55E3D-F095-447B-4029-23C4F9E4E3C6}"/>
          </ac:grpSpMkLst>
        </pc:grpChg>
        <pc:picChg chg="mod">
          <ac:chgData name="Sivalingam, Jeyaluxmy" userId="96f68579-a127-49fa-9da1-6d3ea75fe666" providerId="ADAL" clId="{3D8F079B-8C18-4C6D-B251-354CC8A72358}" dt="2025-12-15T05:37:21.940" v="11638" actId="1076"/>
          <ac:picMkLst>
            <pc:docMk/>
            <pc:sldMk cId="3020779692" sldId="269"/>
            <ac:picMk id="3" creationId="{BDEBDFDD-0ECB-E549-E722-0031B247886C}"/>
          </ac:picMkLst>
        </pc:picChg>
        <pc:picChg chg="mod">
          <ac:chgData name="Sivalingam, Jeyaluxmy" userId="96f68579-a127-49fa-9da1-6d3ea75fe666" providerId="ADAL" clId="{3D8F079B-8C18-4C6D-B251-354CC8A72358}" dt="2025-12-14T19:34:37.671" v="11224"/>
          <ac:picMkLst>
            <pc:docMk/>
            <pc:sldMk cId="3020779692" sldId="269"/>
            <ac:picMk id="4" creationId="{1DF7F662-212A-7BAD-5C9C-43DAA7545355}"/>
          </ac:picMkLst>
        </pc:picChg>
        <pc:picChg chg="mod">
          <ac:chgData name="Sivalingam, Jeyaluxmy" userId="96f68579-a127-49fa-9da1-6d3ea75fe666" providerId="ADAL" clId="{3D8F079B-8C18-4C6D-B251-354CC8A72358}" dt="2025-12-14T19:34:37.671" v="11224"/>
          <ac:picMkLst>
            <pc:docMk/>
            <pc:sldMk cId="3020779692" sldId="269"/>
            <ac:picMk id="6" creationId="{599C5C4D-0056-550C-4708-430BB8726DCD}"/>
          </ac:picMkLst>
        </pc:picChg>
        <pc:picChg chg="mod">
          <ac:chgData name="Sivalingam, Jeyaluxmy" userId="96f68579-a127-49fa-9da1-6d3ea75fe666" providerId="ADAL" clId="{3D8F079B-8C18-4C6D-B251-354CC8A72358}" dt="2025-12-08T03:13:22.917" v="6323" actId="1076"/>
          <ac:picMkLst>
            <pc:docMk/>
            <pc:sldMk cId="3020779692" sldId="269"/>
            <ac:picMk id="7" creationId="{58A09450-97BA-8049-BC69-27C004994B05}"/>
          </ac:picMkLst>
        </pc:picChg>
        <pc:picChg chg="mod">
          <ac:chgData name="Sivalingam, Jeyaluxmy" userId="96f68579-a127-49fa-9da1-6d3ea75fe666" providerId="ADAL" clId="{3D8F079B-8C18-4C6D-B251-354CC8A72358}" dt="2025-12-14T19:34:37.671" v="11224"/>
          <ac:picMkLst>
            <pc:docMk/>
            <pc:sldMk cId="3020779692" sldId="269"/>
            <ac:picMk id="9" creationId="{111A5FA5-B865-8D52-D96E-C12244EB4B92}"/>
          </ac:picMkLst>
        </pc:picChg>
        <pc:picChg chg="mod">
          <ac:chgData name="Sivalingam, Jeyaluxmy" userId="96f68579-a127-49fa-9da1-6d3ea75fe666" providerId="ADAL" clId="{3D8F079B-8C18-4C6D-B251-354CC8A72358}" dt="2025-12-17T05:22:31.247" v="12068" actId="1076"/>
          <ac:picMkLst>
            <pc:docMk/>
            <pc:sldMk cId="3020779692" sldId="269"/>
            <ac:picMk id="10" creationId="{F9AB6F49-4C26-DBFA-3A41-1D4DC983338B}"/>
          </ac:picMkLst>
        </pc:picChg>
      </pc:sldChg>
      <pc:sldChg chg="addSp modSp mod">
        <pc:chgData name="Sivalingam, Jeyaluxmy" userId="96f68579-a127-49fa-9da1-6d3ea75fe666" providerId="ADAL" clId="{3D8F079B-8C18-4C6D-B251-354CC8A72358}" dt="2025-12-14T19:34:16.126" v="11220" actId="1076"/>
        <pc:sldMkLst>
          <pc:docMk/>
          <pc:sldMk cId="2013092284" sldId="271"/>
        </pc:sldMkLst>
        <pc:picChg chg="add mod">
          <ac:chgData name="Sivalingam, Jeyaluxmy" userId="96f68579-a127-49fa-9da1-6d3ea75fe666" providerId="ADAL" clId="{3D8F079B-8C18-4C6D-B251-354CC8A72358}" dt="2025-12-14T19:34:16.126" v="11220" actId="1076"/>
          <ac:picMkLst>
            <pc:docMk/>
            <pc:sldMk cId="2013092284" sldId="271"/>
            <ac:picMk id="4" creationId="{2C8892A2-C46A-0F82-B1D3-B209F5A98F04}"/>
          </ac:picMkLst>
        </pc:picChg>
      </pc:sldChg>
      <pc:sldChg chg="addSp delSp modSp mod">
        <pc:chgData name="Sivalingam, Jeyaluxmy" userId="96f68579-a127-49fa-9da1-6d3ea75fe666" providerId="ADAL" clId="{3D8F079B-8C18-4C6D-B251-354CC8A72358}" dt="2025-12-16T05:25:07.045" v="11990"/>
        <pc:sldMkLst>
          <pc:docMk/>
          <pc:sldMk cId="203407010" sldId="273"/>
        </pc:sldMkLst>
        <pc:spChg chg="add mod">
          <ac:chgData name="Sivalingam, Jeyaluxmy" userId="96f68579-a127-49fa-9da1-6d3ea75fe666" providerId="ADAL" clId="{3D8F079B-8C18-4C6D-B251-354CC8A72358}" dt="2025-12-16T05:25:07.045" v="11990"/>
          <ac:spMkLst>
            <pc:docMk/>
            <pc:sldMk cId="203407010" sldId="273"/>
            <ac:spMk id="8" creationId="{55517494-143E-A7F8-FA8A-885B3F029E44}"/>
          </ac:spMkLst>
        </pc:spChg>
        <pc:grpChg chg="mod">
          <ac:chgData name="Sivalingam, Jeyaluxmy" userId="96f68579-a127-49fa-9da1-6d3ea75fe666" providerId="ADAL" clId="{3D8F079B-8C18-4C6D-B251-354CC8A72358}" dt="2025-12-14T19:10:00.137" v="11216" actId="1076"/>
          <ac:grpSpMkLst>
            <pc:docMk/>
            <pc:sldMk cId="203407010" sldId="273"/>
            <ac:grpSpMk id="49" creationId="{32D723EB-A70C-EDE6-A895-2FCF6435536F}"/>
          </ac:grpSpMkLst>
        </pc:grpChg>
        <pc:picChg chg="mod">
          <ac:chgData name="Sivalingam, Jeyaluxmy" userId="96f68579-a127-49fa-9da1-6d3ea75fe666" providerId="ADAL" clId="{3D8F079B-8C18-4C6D-B251-354CC8A72358}" dt="2025-12-14T19:09:23.590" v="11205" actId="1076"/>
          <ac:picMkLst>
            <pc:docMk/>
            <pc:sldMk cId="203407010" sldId="273"/>
            <ac:picMk id="5" creationId="{D9397D4D-87F8-4211-8F72-9AC9FC259FA5}"/>
          </ac:picMkLst>
        </pc:picChg>
        <pc:picChg chg="mod">
          <ac:chgData name="Sivalingam, Jeyaluxmy" userId="96f68579-a127-49fa-9da1-6d3ea75fe666" providerId="ADAL" clId="{3D8F079B-8C18-4C6D-B251-354CC8A72358}" dt="2025-12-14T19:09:48.163" v="11210" actId="1076"/>
          <ac:picMkLst>
            <pc:docMk/>
            <pc:sldMk cId="203407010" sldId="273"/>
            <ac:picMk id="11" creationId="{0D643C9D-75A4-82F7-4435-7CD4A5DAEAF9}"/>
          </ac:picMkLst>
        </pc:picChg>
        <pc:picChg chg="add mod">
          <ac:chgData name="Sivalingam, Jeyaluxmy" userId="96f68579-a127-49fa-9da1-6d3ea75fe666" providerId="ADAL" clId="{3D8F079B-8C18-4C6D-B251-354CC8A72358}" dt="2025-12-16T05:24:51.602" v="11988" actId="1076"/>
          <ac:picMkLst>
            <pc:docMk/>
            <pc:sldMk cId="203407010" sldId="273"/>
            <ac:picMk id="18" creationId="{4A7DE2AE-A6E1-66E4-23CC-733AA7731806}"/>
          </ac:picMkLst>
        </pc:picChg>
        <pc:picChg chg="add mod">
          <ac:chgData name="Sivalingam, Jeyaluxmy" userId="96f68579-a127-49fa-9da1-6d3ea75fe666" providerId="ADAL" clId="{3D8F079B-8C18-4C6D-B251-354CC8A72358}" dt="2025-12-16T05:24:51.602" v="11988" actId="1076"/>
          <ac:picMkLst>
            <pc:docMk/>
            <pc:sldMk cId="203407010" sldId="273"/>
            <ac:picMk id="19" creationId="{7AAD757D-A5F0-F283-19F7-F6FB5A3BBB10}"/>
          </ac:picMkLst>
        </pc:picChg>
        <pc:picChg chg="mod">
          <ac:chgData name="Sivalingam, Jeyaluxmy" userId="96f68579-a127-49fa-9da1-6d3ea75fe666" providerId="ADAL" clId="{3D8F079B-8C18-4C6D-B251-354CC8A72358}" dt="2025-12-13T06:36:42.501" v="10424" actId="14100"/>
          <ac:picMkLst>
            <pc:docMk/>
            <pc:sldMk cId="203407010" sldId="273"/>
            <ac:picMk id="47" creationId="{0219B86B-CB6D-4547-28C2-09EC6C6ECB9C}"/>
          </ac:picMkLst>
        </pc:picChg>
        <pc:picChg chg="mod">
          <ac:chgData name="Sivalingam, Jeyaluxmy" userId="96f68579-a127-49fa-9da1-6d3ea75fe666" providerId="ADAL" clId="{3D8F079B-8C18-4C6D-B251-354CC8A72358}" dt="2025-12-14T19:09:53.761" v="11214" actId="1076"/>
          <ac:picMkLst>
            <pc:docMk/>
            <pc:sldMk cId="203407010" sldId="273"/>
            <ac:picMk id="50" creationId="{AF52F8A8-080B-9AFD-CA92-B259BCBA4A9A}"/>
          </ac:picMkLst>
        </pc:picChg>
        <pc:picChg chg="mod">
          <ac:chgData name="Sivalingam, Jeyaluxmy" userId="96f68579-a127-49fa-9da1-6d3ea75fe666" providerId="ADAL" clId="{3D8F079B-8C18-4C6D-B251-354CC8A72358}" dt="2025-12-14T19:09:39.147" v="11206" actId="1076"/>
          <ac:picMkLst>
            <pc:docMk/>
            <pc:sldMk cId="203407010" sldId="273"/>
            <ac:picMk id="63" creationId="{757F3791-6830-6506-99BF-2F348551FCA9}"/>
          </ac:picMkLst>
        </pc:picChg>
        <pc:picChg chg="mod">
          <ac:chgData name="Sivalingam, Jeyaluxmy" userId="96f68579-a127-49fa-9da1-6d3ea75fe666" providerId="ADAL" clId="{3D8F079B-8C18-4C6D-B251-354CC8A72358}" dt="2025-12-14T19:09:51.359" v="11212" actId="1076"/>
          <ac:picMkLst>
            <pc:docMk/>
            <pc:sldMk cId="203407010" sldId="273"/>
            <ac:picMk id="65" creationId="{3DFCF779-4E00-6010-152D-9944D89BEC49}"/>
          </ac:picMkLst>
        </pc:picChg>
        <pc:picChg chg="mod">
          <ac:chgData name="Sivalingam, Jeyaluxmy" userId="96f68579-a127-49fa-9da1-6d3ea75fe666" providerId="ADAL" clId="{3D8F079B-8C18-4C6D-B251-354CC8A72358}" dt="2025-12-14T19:09:49.917" v="11211" actId="1076"/>
          <ac:picMkLst>
            <pc:docMk/>
            <pc:sldMk cId="203407010" sldId="273"/>
            <ac:picMk id="66" creationId="{8BB8E043-81CE-2D55-C3B5-6493EAB0D14E}"/>
          </ac:picMkLst>
        </pc:picChg>
        <pc:picChg chg="mod">
          <ac:chgData name="Sivalingam, Jeyaluxmy" userId="96f68579-a127-49fa-9da1-6d3ea75fe666" providerId="ADAL" clId="{3D8F079B-8C18-4C6D-B251-354CC8A72358}" dt="2025-12-14T19:09:52.750" v="11213" actId="1076"/>
          <ac:picMkLst>
            <pc:docMk/>
            <pc:sldMk cId="203407010" sldId="273"/>
            <ac:picMk id="67" creationId="{199BEDDD-576B-BA58-56AB-61926DFAAED5}"/>
          </ac:picMkLst>
        </pc:picChg>
        <pc:picChg chg="mod">
          <ac:chgData name="Sivalingam, Jeyaluxmy" userId="96f68579-a127-49fa-9da1-6d3ea75fe666" providerId="ADAL" clId="{3D8F079B-8C18-4C6D-B251-354CC8A72358}" dt="2025-12-14T19:09:39.147" v="11206" actId="1076"/>
          <ac:picMkLst>
            <pc:docMk/>
            <pc:sldMk cId="203407010" sldId="273"/>
            <ac:picMk id="68" creationId="{870E731E-842D-C453-8AE3-1AB65BD29A16}"/>
          </ac:picMkLst>
        </pc:picChg>
        <pc:picChg chg="add del">
          <ac:chgData name="Sivalingam, Jeyaluxmy" userId="96f68579-a127-49fa-9da1-6d3ea75fe666" providerId="ADAL" clId="{3D8F079B-8C18-4C6D-B251-354CC8A72358}" dt="2025-12-13T06:36:33.248" v="10420" actId="21"/>
          <ac:picMkLst>
            <pc:docMk/>
            <pc:sldMk cId="203407010" sldId="273"/>
            <ac:picMk id="73" creationId="{81B407D3-61CA-30D8-3622-26BB8FDFCA83}"/>
          </ac:picMkLst>
        </pc:picChg>
      </pc:sldChg>
      <pc:sldChg chg="addSp delSp modSp mod ord">
        <pc:chgData name="Sivalingam, Jeyaluxmy" userId="96f68579-a127-49fa-9da1-6d3ea75fe666" providerId="ADAL" clId="{3D8F079B-8C18-4C6D-B251-354CC8A72358}" dt="2025-12-14T19:08:28.131" v="11180" actId="1076"/>
        <pc:sldMkLst>
          <pc:docMk/>
          <pc:sldMk cId="626141910" sldId="274"/>
        </pc:sldMkLst>
        <pc:picChg chg="add mod">
          <ac:chgData name="Sivalingam, Jeyaluxmy" userId="96f68579-a127-49fa-9da1-6d3ea75fe666" providerId="ADAL" clId="{3D8F079B-8C18-4C6D-B251-354CC8A72358}" dt="2025-12-14T19:08:28.131" v="11180" actId="1076"/>
          <ac:picMkLst>
            <pc:docMk/>
            <pc:sldMk cId="626141910" sldId="274"/>
            <ac:picMk id="57" creationId="{F6CA0B47-980F-9C1D-008B-F32607E25F4D}"/>
          </ac:picMkLst>
        </pc:picChg>
        <pc:picChg chg="add mod">
          <ac:chgData name="Sivalingam, Jeyaluxmy" userId="96f68579-a127-49fa-9da1-6d3ea75fe666" providerId="ADAL" clId="{3D8F079B-8C18-4C6D-B251-354CC8A72358}" dt="2025-12-14T19:08:28.131" v="11180" actId="1076"/>
          <ac:picMkLst>
            <pc:docMk/>
            <pc:sldMk cId="626141910" sldId="274"/>
            <ac:picMk id="59" creationId="{E5487AC8-F473-6D59-B877-14ACBF508815}"/>
          </ac:picMkLst>
        </pc:picChg>
        <pc:picChg chg="add mod">
          <ac:chgData name="Sivalingam, Jeyaluxmy" userId="96f68579-a127-49fa-9da1-6d3ea75fe666" providerId="ADAL" clId="{3D8F079B-8C18-4C6D-B251-354CC8A72358}" dt="2025-12-14T19:08:28.131" v="11180" actId="1076"/>
          <ac:picMkLst>
            <pc:docMk/>
            <pc:sldMk cId="626141910" sldId="274"/>
            <ac:picMk id="64" creationId="{0EF2C077-0B5E-B916-27CA-04B9A6953222}"/>
          </ac:picMkLst>
        </pc:picChg>
      </pc:sldChg>
      <pc:sldChg chg="addSp delSp modSp add mod modShow">
        <pc:chgData name="Sivalingam, Jeyaluxmy" userId="96f68579-a127-49fa-9da1-6d3ea75fe666" providerId="ADAL" clId="{3D8F079B-8C18-4C6D-B251-354CC8A72358}" dt="2025-12-21T22:00:39.379" v="14257" actId="729"/>
        <pc:sldMkLst>
          <pc:docMk/>
          <pc:sldMk cId="3675010219" sldId="280"/>
        </pc:sldMkLst>
        <pc:spChg chg="mod">
          <ac:chgData name="Sivalingam, Jeyaluxmy" userId="96f68579-a127-49fa-9da1-6d3ea75fe666" providerId="ADAL" clId="{3D8F079B-8C18-4C6D-B251-354CC8A72358}" dt="2025-12-13T06:14:02.691" v="9981" actId="554"/>
          <ac:spMkLst>
            <pc:docMk/>
            <pc:sldMk cId="3675010219" sldId="280"/>
            <ac:spMk id="4" creationId="{B0C1C88A-773E-F225-8029-4BAC4815EB33}"/>
          </ac:spMkLst>
        </pc:spChg>
        <pc:spChg chg="mod">
          <ac:chgData name="Sivalingam, Jeyaluxmy" userId="96f68579-a127-49fa-9da1-6d3ea75fe666" providerId="ADAL" clId="{3D8F079B-8C18-4C6D-B251-354CC8A72358}" dt="2025-12-13T06:14:02.691" v="9981" actId="554"/>
          <ac:spMkLst>
            <pc:docMk/>
            <pc:sldMk cId="3675010219" sldId="280"/>
            <ac:spMk id="15" creationId="{8A2580D3-D7BC-41F9-9C09-8BFA4DC263F5}"/>
          </ac:spMkLst>
        </pc:spChg>
        <pc:spChg chg="mod">
          <ac:chgData name="Sivalingam, Jeyaluxmy" userId="96f68579-a127-49fa-9da1-6d3ea75fe666" providerId="ADAL" clId="{3D8F079B-8C18-4C6D-B251-354CC8A72358}" dt="2025-12-13T06:14:02.691" v="9981" actId="554"/>
          <ac:spMkLst>
            <pc:docMk/>
            <pc:sldMk cId="3675010219" sldId="280"/>
            <ac:spMk id="18" creationId="{97705E72-E866-A21E-0E0D-D7F25A37DA66}"/>
          </ac:spMkLst>
        </pc:spChg>
        <pc:picChg chg="mod">
          <ac:chgData name="Sivalingam, Jeyaluxmy" userId="96f68579-a127-49fa-9da1-6d3ea75fe666" providerId="ADAL" clId="{3D8F079B-8C18-4C6D-B251-354CC8A72358}" dt="2025-12-13T06:12:50.385" v="9964" actId="408"/>
          <ac:picMkLst>
            <pc:docMk/>
            <pc:sldMk cId="3675010219" sldId="280"/>
            <ac:picMk id="5" creationId="{0BA8F0F7-E9B7-45FB-0901-734DA387683A}"/>
          </ac:picMkLst>
        </pc:picChg>
        <pc:picChg chg="mod">
          <ac:chgData name="Sivalingam, Jeyaluxmy" userId="96f68579-a127-49fa-9da1-6d3ea75fe666" providerId="ADAL" clId="{3D8F079B-8C18-4C6D-B251-354CC8A72358}" dt="2025-12-13T06:12:50.385" v="9964" actId="408"/>
          <ac:picMkLst>
            <pc:docMk/>
            <pc:sldMk cId="3675010219" sldId="280"/>
            <ac:picMk id="91" creationId="{6022D6EA-B55D-B7DB-0D29-F13393216A73}"/>
          </ac:picMkLst>
        </pc:picChg>
      </pc:sldChg>
      <pc:sldChg chg="add">
        <pc:chgData name="Sivalingam, Jeyaluxmy" userId="96f68579-a127-49fa-9da1-6d3ea75fe666" providerId="ADAL" clId="{3D8F079B-8C18-4C6D-B251-354CC8A72358}" dt="2025-12-19T07:23:01.338" v="12531"/>
        <pc:sldMkLst>
          <pc:docMk/>
          <pc:sldMk cId="713100700" sldId="282"/>
        </pc:sldMkLst>
      </pc:sldChg>
      <pc:sldChg chg="addSp delSp modSp add mod ord">
        <pc:chgData name="Sivalingam, Jeyaluxmy" userId="96f68579-a127-49fa-9da1-6d3ea75fe666" providerId="ADAL" clId="{3D8F079B-8C18-4C6D-B251-354CC8A72358}" dt="2025-12-15T06:44:43.076" v="11707" actId="1076"/>
        <pc:sldMkLst>
          <pc:docMk/>
          <pc:sldMk cId="3181386242" sldId="284"/>
        </pc:sldMkLst>
        <pc:spChg chg="mod">
          <ac:chgData name="Sivalingam, Jeyaluxmy" userId="96f68579-a127-49fa-9da1-6d3ea75fe666" providerId="ADAL" clId="{3D8F079B-8C18-4C6D-B251-354CC8A72358}" dt="2025-12-14T19:49:29.206" v="11344" actId="554"/>
          <ac:spMkLst>
            <pc:docMk/>
            <pc:sldMk cId="3181386242" sldId="284"/>
            <ac:spMk id="12" creationId="{4C4AD228-B281-44C3-FF0D-C694301BE9BD}"/>
          </ac:spMkLst>
        </pc:spChg>
        <pc:spChg chg="mod">
          <ac:chgData name="Sivalingam, Jeyaluxmy" userId="96f68579-a127-49fa-9da1-6d3ea75fe666" providerId="ADAL" clId="{3D8F079B-8C18-4C6D-B251-354CC8A72358}" dt="2025-12-14T19:49:29.206" v="11344" actId="554"/>
          <ac:spMkLst>
            <pc:docMk/>
            <pc:sldMk cId="3181386242" sldId="284"/>
            <ac:spMk id="13" creationId="{953C52AF-3348-4894-C59C-EFD7D3CF3565}"/>
          </ac:spMkLst>
        </pc:spChg>
        <pc:spChg chg="mod">
          <ac:chgData name="Sivalingam, Jeyaluxmy" userId="96f68579-a127-49fa-9da1-6d3ea75fe666" providerId="ADAL" clId="{3D8F079B-8C18-4C6D-B251-354CC8A72358}" dt="2025-12-14T19:49:29.206" v="11344" actId="554"/>
          <ac:spMkLst>
            <pc:docMk/>
            <pc:sldMk cId="3181386242" sldId="284"/>
            <ac:spMk id="14" creationId="{E48DF86E-E2F8-6889-10C2-F29C7BE58CA7}"/>
          </ac:spMkLst>
        </pc:spChg>
        <pc:spChg chg="mod">
          <ac:chgData name="Sivalingam, Jeyaluxmy" userId="96f68579-a127-49fa-9da1-6d3ea75fe666" providerId="ADAL" clId="{3D8F079B-8C18-4C6D-B251-354CC8A72358}" dt="2025-12-14T19:48:58.521" v="11336" actId="1036"/>
          <ac:spMkLst>
            <pc:docMk/>
            <pc:sldMk cId="3181386242" sldId="284"/>
            <ac:spMk id="15" creationId="{7D3886CA-3949-49B1-C919-9E783AC6D5A0}"/>
          </ac:spMkLst>
        </pc:spChg>
        <pc:spChg chg="mod">
          <ac:chgData name="Sivalingam, Jeyaluxmy" userId="96f68579-a127-49fa-9da1-6d3ea75fe666" providerId="ADAL" clId="{3D8F079B-8C18-4C6D-B251-354CC8A72358}" dt="2025-12-14T19:48:13.477" v="11300" actId="1038"/>
          <ac:spMkLst>
            <pc:docMk/>
            <pc:sldMk cId="3181386242" sldId="284"/>
            <ac:spMk id="32" creationId="{9B0D246E-143A-01E1-DC81-945198BE8D30}"/>
          </ac:spMkLst>
        </pc:spChg>
        <pc:spChg chg="mod">
          <ac:chgData name="Sivalingam, Jeyaluxmy" userId="96f68579-a127-49fa-9da1-6d3ea75fe666" providerId="ADAL" clId="{3D8F079B-8C18-4C6D-B251-354CC8A72358}" dt="2025-12-14T19:48:39.390" v="11314" actId="552"/>
          <ac:spMkLst>
            <pc:docMk/>
            <pc:sldMk cId="3181386242" sldId="284"/>
            <ac:spMk id="33" creationId="{C4584907-98F2-5AEE-B6AE-D3EC0C136676}"/>
          </ac:spMkLst>
        </pc:spChg>
        <pc:spChg chg="mod">
          <ac:chgData name="Sivalingam, Jeyaluxmy" userId="96f68579-a127-49fa-9da1-6d3ea75fe666" providerId="ADAL" clId="{3D8F079B-8C18-4C6D-B251-354CC8A72358}" dt="2025-12-14T19:48:18.903" v="11312" actId="1038"/>
          <ac:spMkLst>
            <pc:docMk/>
            <pc:sldMk cId="3181386242" sldId="284"/>
            <ac:spMk id="71" creationId="{4DD70385-7D95-21A3-60E8-76AADD6C8F32}"/>
          </ac:spMkLst>
        </pc:spChg>
        <pc:spChg chg="mod">
          <ac:chgData name="Sivalingam, Jeyaluxmy" userId="96f68579-a127-49fa-9da1-6d3ea75fe666" providerId="ADAL" clId="{3D8F079B-8C18-4C6D-B251-354CC8A72358}" dt="2025-12-14T19:48:52.461" v="11330" actId="1035"/>
          <ac:spMkLst>
            <pc:docMk/>
            <pc:sldMk cId="3181386242" sldId="284"/>
            <ac:spMk id="72" creationId="{FEAD5DC1-5F36-EC9F-9360-41F70992227A}"/>
          </ac:spMkLst>
        </pc:spChg>
        <pc:spChg chg="mod">
          <ac:chgData name="Sivalingam, Jeyaluxmy" userId="96f68579-a127-49fa-9da1-6d3ea75fe666" providerId="ADAL" clId="{3D8F079B-8C18-4C6D-B251-354CC8A72358}" dt="2025-12-14T19:49:40.312" v="11346" actId="554"/>
          <ac:spMkLst>
            <pc:docMk/>
            <pc:sldMk cId="3181386242" sldId="284"/>
            <ac:spMk id="74" creationId="{6CCC5A26-D076-113D-BFF9-C4C38CD30132}"/>
          </ac:spMkLst>
        </pc:spChg>
        <pc:spChg chg="mod">
          <ac:chgData name="Sivalingam, Jeyaluxmy" userId="96f68579-a127-49fa-9da1-6d3ea75fe666" providerId="ADAL" clId="{3D8F079B-8C18-4C6D-B251-354CC8A72358}" dt="2025-12-14T19:49:40.312" v="11346" actId="554"/>
          <ac:spMkLst>
            <pc:docMk/>
            <pc:sldMk cId="3181386242" sldId="284"/>
            <ac:spMk id="75" creationId="{4A515E7B-C013-CC98-02FD-1EC237E7AD77}"/>
          </ac:spMkLst>
        </pc:spChg>
        <pc:spChg chg="mod">
          <ac:chgData name="Sivalingam, Jeyaluxmy" userId="96f68579-a127-49fa-9da1-6d3ea75fe666" providerId="ADAL" clId="{3D8F079B-8C18-4C6D-B251-354CC8A72358}" dt="2025-12-14T19:49:40.312" v="11346" actId="554"/>
          <ac:spMkLst>
            <pc:docMk/>
            <pc:sldMk cId="3181386242" sldId="284"/>
            <ac:spMk id="76" creationId="{337044E1-9468-AD1E-4FEB-C658E1705DE4}"/>
          </ac:spMkLst>
        </pc:spChg>
        <pc:grpChg chg="add mod">
          <ac:chgData name="Sivalingam, Jeyaluxmy" userId="96f68579-a127-49fa-9da1-6d3ea75fe666" providerId="ADAL" clId="{3D8F079B-8C18-4C6D-B251-354CC8A72358}" dt="2025-12-14T19:47:22.536" v="11273" actId="1037"/>
          <ac:grpSpMkLst>
            <pc:docMk/>
            <pc:sldMk cId="3181386242" sldId="284"/>
            <ac:grpSpMk id="5" creationId="{3D2CE4E9-6239-9FBB-C984-EF98C647E41F}"/>
          </ac:grpSpMkLst>
        </pc:grpChg>
        <pc:grpChg chg="mod">
          <ac:chgData name="Sivalingam, Jeyaluxmy" userId="96f68579-a127-49fa-9da1-6d3ea75fe666" providerId="ADAL" clId="{3D8F079B-8C18-4C6D-B251-354CC8A72358}" dt="2025-12-14T19:47:45.524" v="11293" actId="1037"/>
          <ac:grpSpMkLst>
            <pc:docMk/>
            <pc:sldMk cId="3181386242" sldId="284"/>
            <ac:grpSpMk id="6" creationId="{A222ADA6-F3D7-EFCD-53BA-9FB11FA93175}"/>
          </ac:grpSpMkLst>
        </pc:grpChg>
        <pc:grpChg chg="mod">
          <ac:chgData name="Sivalingam, Jeyaluxmy" userId="96f68579-a127-49fa-9da1-6d3ea75fe666" providerId="ADAL" clId="{3D8F079B-8C18-4C6D-B251-354CC8A72358}" dt="2025-12-14T19:47:17.204" v="11258" actId="164"/>
          <ac:grpSpMkLst>
            <pc:docMk/>
            <pc:sldMk cId="3181386242" sldId="284"/>
            <ac:grpSpMk id="10" creationId="{F533EFC4-B106-5CD4-0AE6-67823DF9C83E}"/>
          </ac:grpSpMkLst>
        </pc:grpChg>
        <pc:grpChg chg="mod">
          <ac:chgData name="Sivalingam, Jeyaluxmy" userId="96f68579-a127-49fa-9da1-6d3ea75fe666" providerId="ADAL" clId="{3D8F079B-8C18-4C6D-B251-354CC8A72358}" dt="2025-12-14T19:46:52.531" v="11256" actId="554"/>
          <ac:grpSpMkLst>
            <pc:docMk/>
            <pc:sldMk cId="3181386242" sldId="284"/>
            <ac:grpSpMk id="29" creationId="{CD70DFD6-A115-543D-E749-01475EB8FD38}"/>
          </ac:grpSpMkLst>
        </pc:grpChg>
        <pc:graphicFrameChg chg="add mod">
          <ac:chgData name="Sivalingam, Jeyaluxmy" userId="96f68579-a127-49fa-9da1-6d3ea75fe666" providerId="ADAL" clId="{3D8F079B-8C18-4C6D-B251-354CC8A72358}" dt="2025-12-14T19:50:22.272" v="11358" actId="554"/>
          <ac:graphicFrameMkLst>
            <pc:docMk/>
            <pc:sldMk cId="3181386242" sldId="284"/>
            <ac:graphicFrameMk id="8" creationId="{4AD206B4-246B-8B1F-C2E7-D61FC98BD79F}"/>
          </ac:graphicFrameMkLst>
        </pc:graphicFrameChg>
        <pc:picChg chg="add mod modCrop">
          <ac:chgData name="Sivalingam, Jeyaluxmy" userId="96f68579-a127-49fa-9da1-6d3ea75fe666" providerId="ADAL" clId="{3D8F079B-8C18-4C6D-B251-354CC8A72358}" dt="2025-12-15T06:44:43.076" v="11707" actId="1076"/>
          <ac:picMkLst>
            <pc:docMk/>
            <pc:sldMk cId="3181386242" sldId="284"/>
            <ac:picMk id="20" creationId="{41ADCC1E-BAEC-E5BE-8A0F-DC39CD5D98E7}"/>
          </ac:picMkLst>
        </pc:picChg>
        <pc:picChg chg="mod">
          <ac:chgData name="Sivalingam, Jeyaluxmy" userId="96f68579-a127-49fa-9da1-6d3ea75fe666" providerId="ADAL" clId="{3D8F079B-8C18-4C6D-B251-354CC8A72358}" dt="2025-12-14T19:49:58.136" v="11352" actId="12789"/>
          <ac:picMkLst>
            <pc:docMk/>
            <pc:sldMk cId="3181386242" sldId="284"/>
            <ac:picMk id="22" creationId="{168D3900-D55D-FC1B-5896-4D2E9C599ECC}"/>
          </ac:picMkLst>
        </pc:picChg>
        <pc:picChg chg="mod">
          <ac:chgData name="Sivalingam, Jeyaluxmy" userId="96f68579-a127-49fa-9da1-6d3ea75fe666" providerId="ADAL" clId="{3D8F079B-8C18-4C6D-B251-354CC8A72358}" dt="2025-12-14T19:49:58.136" v="11352" actId="12789"/>
          <ac:picMkLst>
            <pc:docMk/>
            <pc:sldMk cId="3181386242" sldId="284"/>
            <ac:picMk id="26" creationId="{A1089752-FB5F-2AFF-2F07-8A43CB77EB1E}"/>
          </ac:picMkLst>
        </pc:picChg>
        <pc:picChg chg="mod">
          <ac:chgData name="Sivalingam, Jeyaluxmy" userId="96f68579-a127-49fa-9da1-6d3ea75fe666" providerId="ADAL" clId="{3D8F079B-8C18-4C6D-B251-354CC8A72358}" dt="2025-12-14T19:49:58.136" v="11352" actId="12789"/>
          <ac:picMkLst>
            <pc:docMk/>
            <pc:sldMk cId="3181386242" sldId="284"/>
            <ac:picMk id="27" creationId="{9E52D79E-5FB5-E390-C32B-F6F0708A417C}"/>
          </ac:picMkLst>
        </pc:picChg>
        <pc:picChg chg="mod">
          <ac:chgData name="Sivalingam, Jeyaluxmy" userId="96f68579-a127-49fa-9da1-6d3ea75fe666" providerId="ADAL" clId="{3D8F079B-8C18-4C6D-B251-354CC8A72358}" dt="2025-12-14T19:47:17.204" v="11258" actId="164"/>
          <ac:picMkLst>
            <pc:docMk/>
            <pc:sldMk cId="3181386242" sldId="284"/>
            <ac:picMk id="35" creationId="{26703421-038C-FF06-0529-9C177D96D9C1}"/>
          </ac:picMkLst>
        </pc:picChg>
        <pc:picChg chg="mod">
          <ac:chgData name="Sivalingam, Jeyaluxmy" userId="96f68579-a127-49fa-9da1-6d3ea75fe666" providerId="ADAL" clId="{3D8F079B-8C18-4C6D-B251-354CC8A72358}" dt="2025-12-14T19:47:17.204" v="11258" actId="164"/>
          <ac:picMkLst>
            <pc:docMk/>
            <pc:sldMk cId="3181386242" sldId="284"/>
            <ac:picMk id="36" creationId="{B24713B2-93AD-502F-B57F-5296E3EB5AF2}"/>
          </ac:picMkLst>
        </pc:picChg>
      </pc:sldChg>
      <pc:sldChg chg="add">
        <pc:chgData name="Sivalingam, Jeyaluxmy" userId="96f68579-a127-49fa-9da1-6d3ea75fe666" providerId="ADAL" clId="{3D8F079B-8C18-4C6D-B251-354CC8A72358}" dt="2025-12-20T04:08:02.287" v="13014"/>
        <pc:sldMkLst>
          <pc:docMk/>
          <pc:sldMk cId="3585903552" sldId="287"/>
        </pc:sldMkLst>
      </pc:sldChg>
      <pc:sldChg chg="addSp modSp add mod modShow">
        <pc:chgData name="Sivalingam, Jeyaluxmy" userId="96f68579-a127-49fa-9da1-6d3ea75fe666" providerId="ADAL" clId="{3D8F079B-8C18-4C6D-B251-354CC8A72358}" dt="2025-12-16T03:22:02.659" v="11738" actId="729"/>
        <pc:sldMkLst>
          <pc:docMk/>
          <pc:sldMk cId="1516006560" sldId="288"/>
        </pc:sldMkLst>
        <pc:spChg chg="mod">
          <ac:chgData name="Sivalingam, Jeyaluxmy" userId="96f68579-a127-49fa-9da1-6d3ea75fe666" providerId="ADAL" clId="{3D8F079B-8C18-4C6D-B251-354CC8A72358}" dt="2025-12-16T02:14:05.773" v="11731" actId="1076"/>
          <ac:spMkLst>
            <pc:docMk/>
            <pc:sldMk cId="1516006560" sldId="288"/>
            <ac:spMk id="6" creationId="{71B60F61-4BED-06B2-CFC7-D7786ECF1FCA}"/>
          </ac:spMkLst>
        </pc:spChg>
        <pc:picChg chg="mod">
          <ac:chgData name="Sivalingam, Jeyaluxmy" userId="96f68579-a127-49fa-9da1-6d3ea75fe666" providerId="ADAL" clId="{3D8F079B-8C18-4C6D-B251-354CC8A72358}" dt="2025-12-16T02:13:30.948" v="11726" actId="1076"/>
          <ac:picMkLst>
            <pc:docMk/>
            <pc:sldMk cId="1516006560" sldId="288"/>
            <ac:picMk id="3" creationId="{5E903E0F-B5C1-60FF-EB3F-96A4F00836B3}"/>
          </ac:picMkLst>
        </pc:picChg>
        <pc:picChg chg="add mod">
          <ac:chgData name="Sivalingam, Jeyaluxmy" userId="96f68579-a127-49fa-9da1-6d3ea75fe666" providerId="ADAL" clId="{3D8F079B-8C18-4C6D-B251-354CC8A72358}" dt="2025-12-16T02:13:19.113" v="11724" actId="208"/>
          <ac:picMkLst>
            <pc:docMk/>
            <pc:sldMk cId="1516006560" sldId="288"/>
            <ac:picMk id="7" creationId="{7833AA2A-7FC9-E890-9FB8-48BA46752072}"/>
          </ac:picMkLst>
        </pc:picChg>
      </pc:sldChg>
      <pc:sldChg chg="addSp delSp modSp new mod modShow">
        <pc:chgData name="Sivalingam, Jeyaluxmy" userId="96f68579-a127-49fa-9da1-6d3ea75fe666" providerId="ADAL" clId="{3D8F079B-8C18-4C6D-B251-354CC8A72358}" dt="2025-12-21T22:00:39.379" v="14257" actId="729"/>
        <pc:sldMkLst>
          <pc:docMk/>
          <pc:sldMk cId="3947205316" sldId="289"/>
        </pc:sldMkLst>
        <pc:picChg chg="add mod">
          <ac:chgData name="Sivalingam, Jeyaluxmy" userId="96f68579-a127-49fa-9da1-6d3ea75fe666" providerId="ADAL" clId="{3D8F079B-8C18-4C6D-B251-354CC8A72358}" dt="2025-12-16T07:49:58.364" v="12056" actId="1076"/>
          <ac:picMkLst>
            <pc:docMk/>
            <pc:sldMk cId="3947205316" sldId="289"/>
            <ac:picMk id="4" creationId="{DCC46BC6-4600-922E-AD67-D97945897438}"/>
          </ac:picMkLst>
        </pc:picChg>
        <pc:picChg chg="add mod modCrop">
          <ac:chgData name="Sivalingam, Jeyaluxmy" userId="96f68579-a127-49fa-9da1-6d3ea75fe666" providerId="ADAL" clId="{3D8F079B-8C18-4C6D-B251-354CC8A72358}" dt="2025-12-16T07:49:48.892" v="12052" actId="1076"/>
          <ac:picMkLst>
            <pc:docMk/>
            <pc:sldMk cId="3947205316" sldId="289"/>
            <ac:picMk id="5" creationId="{0A75D71E-EAA2-E2A5-1DA8-6BCA0BB4E632}"/>
          </ac:picMkLst>
        </pc:picChg>
        <pc:picChg chg="add mod modCrop">
          <ac:chgData name="Sivalingam, Jeyaluxmy" userId="96f68579-a127-49fa-9da1-6d3ea75fe666" providerId="ADAL" clId="{3D8F079B-8C18-4C6D-B251-354CC8A72358}" dt="2025-12-16T07:49:51.544" v="12053" actId="1076"/>
          <ac:picMkLst>
            <pc:docMk/>
            <pc:sldMk cId="3947205316" sldId="289"/>
            <ac:picMk id="6" creationId="{B207B5A8-4EF2-4F0D-BA2A-2302C7C86D68}"/>
          </ac:picMkLst>
        </pc:picChg>
        <pc:picChg chg="add mod">
          <ac:chgData name="Sivalingam, Jeyaluxmy" userId="96f68579-a127-49fa-9da1-6d3ea75fe666" providerId="ADAL" clId="{3D8F079B-8C18-4C6D-B251-354CC8A72358}" dt="2025-12-16T07:49:53.312" v="12054" actId="1076"/>
          <ac:picMkLst>
            <pc:docMk/>
            <pc:sldMk cId="3947205316" sldId="289"/>
            <ac:picMk id="7" creationId="{A081A44A-5299-F7EA-7A3E-4362A9696D46}"/>
          </ac:picMkLst>
        </pc:picChg>
        <pc:picChg chg="add mod">
          <ac:chgData name="Sivalingam, Jeyaluxmy" userId="96f68579-a127-49fa-9da1-6d3ea75fe666" providerId="ADAL" clId="{3D8F079B-8C18-4C6D-B251-354CC8A72358}" dt="2025-12-16T07:49:56.353" v="12055" actId="1076"/>
          <ac:picMkLst>
            <pc:docMk/>
            <pc:sldMk cId="3947205316" sldId="289"/>
            <ac:picMk id="8" creationId="{40F26976-B9DC-B817-2B70-5F6B75FB81C2}"/>
          </ac:picMkLst>
        </pc:picChg>
      </pc:sldChg>
      <pc:sldChg chg="addSp delSp modSp new mod ord modShow">
        <pc:chgData name="Sivalingam, Jeyaluxmy" userId="96f68579-a127-49fa-9da1-6d3ea75fe666" providerId="ADAL" clId="{3D8F079B-8C18-4C6D-B251-354CC8A72358}" dt="2025-12-21T22:00:39.379" v="14257" actId="729"/>
        <pc:sldMkLst>
          <pc:docMk/>
          <pc:sldMk cId="934877544" sldId="290"/>
        </pc:sldMkLst>
        <pc:picChg chg="add mod modCrop">
          <ac:chgData name="Sivalingam, Jeyaluxmy" userId="96f68579-a127-49fa-9da1-6d3ea75fe666" providerId="ADAL" clId="{3D8F079B-8C18-4C6D-B251-354CC8A72358}" dt="2025-12-16T07:49:31.695" v="12047" actId="1076"/>
          <ac:picMkLst>
            <pc:docMk/>
            <pc:sldMk cId="934877544" sldId="290"/>
            <ac:picMk id="3" creationId="{C0F4CF66-0FB6-5672-5D1E-4F6FBCA4B631}"/>
          </ac:picMkLst>
        </pc:picChg>
        <pc:picChg chg="add mod">
          <ac:chgData name="Sivalingam, Jeyaluxmy" userId="96f68579-a127-49fa-9da1-6d3ea75fe666" providerId="ADAL" clId="{3D8F079B-8C18-4C6D-B251-354CC8A72358}" dt="2025-12-16T07:49:35.066" v="12049" actId="1076"/>
          <ac:picMkLst>
            <pc:docMk/>
            <pc:sldMk cId="934877544" sldId="290"/>
            <ac:picMk id="4" creationId="{76DD149C-508D-2ECD-73B6-33271DB3D95D}"/>
          </ac:picMkLst>
        </pc:picChg>
        <pc:picChg chg="add mod">
          <ac:chgData name="Sivalingam, Jeyaluxmy" userId="96f68579-a127-49fa-9da1-6d3ea75fe666" providerId="ADAL" clId="{3D8F079B-8C18-4C6D-B251-354CC8A72358}" dt="2025-12-16T07:49:38.188" v="12050" actId="1076"/>
          <ac:picMkLst>
            <pc:docMk/>
            <pc:sldMk cId="934877544" sldId="290"/>
            <ac:picMk id="5" creationId="{BC43AD2D-554F-B1EC-6D7A-1F87E7DF4107}"/>
          </ac:picMkLst>
        </pc:picChg>
        <pc:picChg chg="add mod">
          <ac:chgData name="Sivalingam, Jeyaluxmy" userId="96f68579-a127-49fa-9da1-6d3ea75fe666" providerId="ADAL" clId="{3D8F079B-8C18-4C6D-B251-354CC8A72358}" dt="2025-12-16T07:49:27.686" v="12045" actId="1076"/>
          <ac:picMkLst>
            <pc:docMk/>
            <pc:sldMk cId="934877544" sldId="290"/>
            <ac:picMk id="6" creationId="{A4D0F1C0-6FFA-3575-184A-71D27EA07E74}"/>
          </ac:picMkLst>
        </pc:picChg>
      </pc:sldChg>
      <pc:sldChg chg="modSp new mod modShow">
        <pc:chgData name="Sivalingam, Jeyaluxmy" userId="96f68579-a127-49fa-9da1-6d3ea75fe666" providerId="ADAL" clId="{3D8F079B-8C18-4C6D-B251-354CC8A72358}" dt="2025-12-21T22:00:39.379" v="14257" actId="729"/>
        <pc:sldMkLst>
          <pc:docMk/>
          <pc:sldMk cId="1492115307" sldId="291"/>
        </pc:sldMkLst>
        <pc:spChg chg="mod">
          <ac:chgData name="Sivalingam, Jeyaluxmy" userId="96f68579-a127-49fa-9da1-6d3ea75fe666" providerId="ADAL" clId="{3D8F079B-8C18-4C6D-B251-354CC8A72358}" dt="2025-12-16T07:50:36.241" v="12065" actId="20577"/>
          <ac:spMkLst>
            <pc:docMk/>
            <pc:sldMk cId="1492115307" sldId="291"/>
            <ac:spMk id="2" creationId="{AB7E6007-2C4F-6A9C-4989-50E0432948E1}"/>
          </ac:spMkLst>
        </pc:spChg>
      </pc:sldChg>
      <pc:sldChg chg="add">
        <pc:chgData name="Sivalingam, Jeyaluxmy" userId="96f68579-a127-49fa-9da1-6d3ea75fe666" providerId="ADAL" clId="{3D8F079B-8C18-4C6D-B251-354CC8A72358}" dt="2025-12-17T06:30:36.992" v="12070"/>
        <pc:sldMkLst>
          <pc:docMk/>
          <pc:sldMk cId="1843042863" sldId="642"/>
        </pc:sldMkLst>
      </pc:sldChg>
      <pc:sldChg chg="add">
        <pc:chgData name="Sivalingam, Jeyaluxmy" userId="96f68579-a127-49fa-9da1-6d3ea75fe666" providerId="ADAL" clId="{3D8F079B-8C18-4C6D-B251-354CC8A72358}" dt="2025-12-19T07:23:01.338" v="12531"/>
        <pc:sldMkLst>
          <pc:docMk/>
          <pc:sldMk cId="3242043502" sldId="644"/>
        </pc:sldMkLst>
      </pc:sldChg>
      <pc:sldChg chg="addSp delSp modSp add mod">
        <pc:chgData name="Sivalingam, Jeyaluxmy" userId="96f68579-a127-49fa-9da1-6d3ea75fe666" providerId="ADAL" clId="{3D8F079B-8C18-4C6D-B251-354CC8A72358}" dt="2025-12-23T06:13:24.168" v="14860" actId="1037"/>
        <pc:sldMkLst>
          <pc:docMk/>
          <pc:sldMk cId="216910369" sldId="649"/>
        </pc:sldMkLst>
        <pc:spChg chg="mod">
          <ac:chgData name="Sivalingam, Jeyaluxmy" userId="96f68579-a127-49fa-9da1-6d3ea75fe666" providerId="ADAL" clId="{3D8F079B-8C18-4C6D-B251-354CC8A72358}" dt="2025-12-23T04:56:03.662" v="14463" actId="165"/>
          <ac:spMkLst>
            <pc:docMk/>
            <pc:sldMk cId="216910369" sldId="649"/>
            <ac:spMk id="22" creationId="{6618641B-0D97-A813-8A76-FD715D926DDE}"/>
          </ac:spMkLst>
        </pc:spChg>
        <pc:spChg chg="mod">
          <ac:chgData name="Sivalingam, Jeyaluxmy" userId="96f68579-a127-49fa-9da1-6d3ea75fe666" providerId="ADAL" clId="{3D8F079B-8C18-4C6D-B251-354CC8A72358}" dt="2025-12-23T04:56:03.662" v="14463" actId="165"/>
          <ac:spMkLst>
            <pc:docMk/>
            <pc:sldMk cId="216910369" sldId="649"/>
            <ac:spMk id="24" creationId="{5C193154-8F8D-0338-2C2A-95ABCFDB5DCD}"/>
          </ac:spMkLst>
        </pc:spChg>
        <pc:spChg chg="mod">
          <ac:chgData name="Sivalingam, Jeyaluxmy" userId="96f68579-a127-49fa-9da1-6d3ea75fe666" providerId="ADAL" clId="{3D8F079B-8C18-4C6D-B251-354CC8A72358}" dt="2025-12-23T04:56:03.662" v="14463" actId="165"/>
          <ac:spMkLst>
            <pc:docMk/>
            <pc:sldMk cId="216910369" sldId="649"/>
            <ac:spMk id="26" creationId="{4484BE69-396C-5730-7998-ABAC98AB4C3F}"/>
          </ac:spMkLst>
        </pc:spChg>
        <pc:spChg chg="mod">
          <ac:chgData name="Sivalingam, Jeyaluxmy" userId="96f68579-a127-49fa-9da1-6d3ea75fe666" providerId="ADAL" clId="{3D8F079B-8C18-4C6D-B251-354CC8A72358}" dt="2025-12-22T08:38:40.400" v="14444" actId="1037"/>
          <ac:spMkLst>
            <pc:docMk/>
            <pc:sldMk cId="216910369" sldId="649"/>
            <ac:spMk id="27" creationId="{30101BAE-6E47-FBA0-4D56-F2DBF802DE06}"/>
          </ac:spMkLst>
        </pc:spChg>
        <pc:spChg chg="mod">
          <ac:chgData name="Sivalingam, Jeyaluxmy" userId="96f68579-a127-49fa-9da1-6d3ea75fe666" providerId="ADAL" clId="{3D8F079B-8C18-4C6D-B251-354CC8A72358}" dt="2025-12-23T06:13:24.168" v="14860" actId="1037"/>
          <ac:spMkLst>
            <pc:docMk/>
            <pc:sldMk cId="216910369" sldId="649"/>
            <ac:spMk id="33" creationId="{0F23BE7A-335A-A70B-73BE-9EDCF0260DED}"/>
          </ac:spMkLst>
        </pc:spChg>
        <pc:spChg chg="mod">
          <ac:chgData name="Sivalingam, Jeyaluxmy" userId="96f68579-a127-49fa-9da1-6d3ea75fe666" providerId="ADAL" clId="{3D8F079B-8C18-4C6D-B251-354CC8A72358}" dt="2025-12-23T06:13:09.313" v="14845" actId="552"/>
          <ac:spMkLst>
            <pc:docMk/>
            <pc:sldMk cId="216910369" sldId="649"/>
            <ac:spMk id="109" creationId="{7174FA7C-C35E-C822-F945-5B919D0EF520}"/>
          </ac:spMkLst>
        </pc:spChg>
        <pc:spChg chg="mod">
          <ac:chgData name="Sivalingam, Jeyaluxmy" userId="96f68579-a127-49fa-9da1-6d3ea75fe666" providerId="ADAL" clId="{3D8F079B-8C18-4C6D-B251-354CC8A72358}" dt="2025-12-22T08:37:54.521" v="14430" actId="1037"/>
          <ac:spMkLst>
            <pc:docMk/>
            <pc:sldMk cId="216910369" sldId="649"/>
            <ac:spMk id="110" creationId="{2EBA5A6D-A714-6197-8088-F1D89705FE5E}"/>
          </ac:spMkLst>
        </pc:spChg>
        <pc:spChg chg="mod">
          <ac:chgData name="Sivalingam, Jeyaluxmy" userId="96f68579-a127-49fa-9da1-6d3ea75fe666" providerId="ADAL" clId="{3D8F079B-8C18-4C6D-B251-354CC8A72358}" dt="2025-12-23T06:13:16.843" v="14846" actId="554"/>
          <ac:spMkLst>
            <pc:docMk/>
            <pc:sldMk cId="216910369" sldId="649"/>
            <ac:spMk id="115" creationId="{62EDD3F6-8D64-666F-D1B8-361731CDE91F}"/>
          </ac:spMkLst>
        </pc:spChg>
        <pc:grpChg chg="mod topLvl">
          <ac:chgData name="Sivalingam, Jeyaluxmy" userId="96f68579-a127-49fa-9da1-6d3ea75fe666" providerId="ADAL" clId="{3D8F079B-8C18-4C6D-B251-354CC8A72358}" dt="2025-12-23T04:56:03.662" v="14463" actId="165"/>
          <ac:grpSpMkLst>
            <pc:docMk/>
            <pc:sldMk cId="216910369" sldId="649"/>
            <ac:grpSpMk id="20" creationId="{F0102CBC-CE80-4F34-FA42-DB4565532003}"/>
          </ac:grpSpMkLst>
        </pc:grpChg>
        <pc:grpChg chg="mod">
          <ac:chgData name="Sivalingam, Jeyaluxmy" userId="96f68579-a127-49fa-9da1-6d3ea75fe666" providerId="ADAL" clId="{3D8F079B-8C18-4C6D-B251-354CC8A72358}" dt="2025-12-23T04:56:03.662" v="14463" actId="165"/>
          <ac:grpSpMkLst>
            <pc:docMk/>
            <pc:sldMk cId="216910369" sldId="649"/>
            <ac:grpSpMk id="21" creationId="{241CEE65-208F-3BC2-0A36-5E940EAADE9E}"/>
          </ac:grpSpMkLst>
        </pc:grpChg>
        <pc:graphicFrameChg chg="add mod">
          <ac:chgData name="Sivalingam, Jeyaluxmy" userId="96f68579-a127-49fa-9da1-6d3ea75fe666" providerId="ADAL" clId="{3D8F079B-8C18-4C6D-B251-354CC8A72358}" dt="2025-12-22T08:38:33.444" v="14435" actId="408"/>
          <ac:graphicFrameMkLst>
            <pc:docMk/>
            <pc:sldMk cId="216910369" sldId="649"/>
            <ac:graphicFrameMk id="13" creationId="{445AB3BD-4EB8-4AD9-82C5-4118BFAC00B3}"/>
          </ac:graphicFrameMkLst>
        </pc:graphicFrameChg>
        <pc:graphicFrameChg chg="add mod">
          <ac:chgData name="Sivalingam, Jeyaluxmy" userId="96f68579-a127-49fa-9da1-6d3ea75fe666" providerId="ADAL" clId="{3D8F079B-8C18-4C6D-B251-354CC8A72358}" dt="2025-12-22T08:38:33.444" v="14435" actId="408"/>
          <ac:graphicFrameMkLst>
            <pc:docMk/>
            <pc:sldMk cId="216910369" sldId="649"/>
            <ac:graphicFrameMk id="31" creationId="{E65B00F6-5B10-0B2B-AA25-67AA7B9B691C}"/>
          </ac:graphicFrameMkLst>
        </pc:graphicFrameChg>
        <pc:graphicFrameChg chg="add mod">
          <ac:chgData name="Sivalingam, Jeyaluxmy" userId="96f68579-a127-49fa-9da1-6d3ea75fe666" providerId="ADAL" clId="{3D8F079B-8C18-4C6D-B251-354CC8A72358}" dt="2025-12-23T05:59:52.006" v="14813"/>
          <ac:graphicFrameMkLst>
            <pc:docMk/>
            <pc:sldMk cId="216910369" sldId="649"/>
            <ac:graphicFrameMk id="36" creationId="{F958D270-CD9C-FD18-4A77-9B056E198908}"/>
          </ac:graphicFrameMkLst>
        </pc:graphicFrameChg>
        <pc:graphicFrameChg chg="add mod">
          <ac:chgData name="Sivalingam, Jeyaluxmy" userId="96f68579-a127-49fa-9da1-6d3ea75fe666" providerId="ADAL" clId="{3D8F079B-8C18-4C6D-B251-354CC8A72358}" dt="2025-12-23T06:12:35.115" v="14844" actId="1076"/>
          <ac:graphicFrameMkLst>
            <pc:docMk/>
            <pc:sldMk cId="216910369" sldId="649"/>
            <ac:graphicFrameMk id="37" creationId="{D153027D-321E-4A83-845E-EB8B2A2991D5}"/>
          </ac:graphicFrameMkLst>
        </pc:graphicFrameChg>
        <pc:graphicFrameChg chg="mod">
          <ac:chgData name="Sivalingam, Jeyaluxmy" userId="96f68579-a127-49fa-9da1-6d3ea75fe666" providerId="ADAL" clId="{3D8F079B-8C18-4C6D-B251-354CC8A72358}" dt="2025-12-23T05:38:18.030" v="14495" actId="1076"/>
          <ac:graphicFrameMkLst>
            <pc:docMk/>
            <pc:sldMk cId="216910369" sldId="649"/>
            <ac:graphicFrameMk id="48" creationId="{6EC894A3-B9CF-4AD1-8B5F-7D241D42500C}"/>
          </ac:graphicFrameMkLst>
        </pc:graphicFrameChg>
        <pc:picChg chg="mod">
          <ac:chgData name="Sivalingam, Jeyaluxmy" userId="96f68579-a127-49fa-9da1-6d3ea75fe666" providerId="ADAL" clId="{3D8F079B-8C18-4C6D-B251-354CC8A72358}" dt="2025-12-23T04:56:03.662" v="14463" actId="165"/>
          <ac:picMkLst>
            <pc:docMk/>
            <pc:sldMk cId="216910369" sldId="649"/>
            <ac:picMk id="23" creationId="{52500055-3D0E-FC46-EC42-01AEC7A5CB79}"/>
          </ac:picMkLst>
        </pc:picChg>
        <pc:picChg chg="mod">
          <ac:chgData name="Sivalingam, Jeyaluxmy" userId="96f68579-a127-49fa-9da1-6d3ea75fe666" providerId="ADAL" clId="{3D8F079B-8C18-4C6D-B251-354CC8A72358}" dt="2025-12-23T04:56:03.662" v="14463" actId="165"/>
          <ac:picMkLst>
            <pc:docMk/>
            <pc:sldMk cId="216910369" sldId="649"/>
            <ac:picMk id="25" creationId="{F877AAC5-FD06-F1D3-B8A8-EBA1AF660396}"/>
          </ac:picMkLst>
        </pc:picChg>
      </pc:sldChg>
      <pc:sldChg chg="addSp delSp modSp new mod">
        <pc:chgData name="Sivalingam, Jeyaluxmy" userId="96f68579-a127-49fa-9da1-6d3ea75fe666" providerId="ADAL" clId="{3D8F079B-8C18-4C6D-B251-354CC8A72358}" dt="2025-12-23T08:29:52.220" v="14921" actId="14100"/>
        <pc:sldMkLst>
          <pc:docMk/>
          <pc:sldMk cId="1475420211" sldId="650"/>
        </pc:sldMkLst>
        <pc:spChg chg="add mod">
          <ac:chgData name="Sivalingam, Jeyaluxmy" userId="96f68579-a127-49fa-9da1-6d3ea75fe666" providerId="ADAL" clId="{3D8F079B-8C18-4C6D-B251-354CC8A72358}" dt="2025-12-21T22:00:23.479" v="14256" actId="20577"/>
          <ac:spMkLst>
            <pc:docMk/>
            <pc:sldMk cId="1475420211" sldId="650"/>
            <ac:spMk id="3" creationId="{47A38D24-2C14-5874-09FF-1074639D4646}"/>
          </ac:spMkLst>
        </pc:spChg>
        <pc:picChg chg="add mod">
          <ac:chgData name="Sivalingam, Jeyaluxmy" userId="96f68579-a127-49fa-9da1-6d3ea75fe666" providerId="ADAL" clId="{3D8F079B-8C18-4C6D-B251-354CC8A72358}" dt="2025-12-23T08:15:00.401" v="14903" actId="14100"/>
          <ac:picMkLst>
            <pc:docMk/>
            <pc:sldMk cId="1475420211" sldId="650"/>
            <ac:picMk id="6" creationId="{C6A3DB4C-69D7-266A-8843-6B1BAAB6FD11}"/>
          </ac:picMkLst>
        </pc:picChg>
      </pc:sldChg>
      <pc:sldChg chg="add mod ord modShow">
        <pc:chgData name="Sivalingam, Jeyaluxmy" userId="96f68579-a127-49fa-9da1-6d3ea75fe666" providerId="ADAL" clId="{3D8F079B-8C18-4C6D-B251-354CC8A72358}" dt="2025-12-23T04:55:27.801" v="14460"/>
        <pc:sldMkLst>
          <pc:docMk/>
          <pc:sldMk cId="3697398347" sldId="651"/>
        </pc:sldMkLst>
      </pc:sldChg>
    </pc:docChg>
  </pc:docChgLst>
  <pc:docChgLst>
    <pc:chgData name="Yu, Xiuping" userId="ac2e4f1e-fc05-4f95-96ac-8dbf0a7412b9" providerId="ADAL" clId="{0C4F8F60-2154-5A20-839A-5554B5BAE146}"/>
    <pc:docChg chg="undo custSel addSld delSld modSld">
      <pc:chgData name="Yu, Xiuping" userId="ac2e4f1e-fc05-4f95-96ac-8dbf0a7412b9" providerId="ADAL" clId="{0C4F8F60-2154-5A20-839A-5554B5BAE146}" dt="2025-12-26T21:44:32.917" v="1134" actId="1076"/>
      <pc:docMkLst>
        <pc:docMk/>
      </pc:docMkLst>
      <pc:sldChg chg="del">
        <pc:chgData name="Yu, Xiuping" userId="ac2e4f1e-fc05-4f95-96ac-8dbf0a7412b9" providerId="ADAL" clId="{0C4F8F60-2154-5A20-839A-5554B5BAE146}" dt="2025-12-26T21:44:05.012" v="1106" actId="2696"/>
        <pc:sldMkLst>
          <pc:docMk/>
          <pc:sldMk cId="3347007978" sldId="257"/>
        </pc:sldMkLst>
      </pc:sldChg>
      <pc:sldChg chg="del">
        <pc:chgData name="Yu, Xiuping" userId="ac2e4f1e-fc05-4f95-96ac-8dbf0a7412b9" providerId="ADAL" clId="{0C4F8F60-2154-5A20-839A-5554B5BAE146}" dt="2025-12-26T21:44:12.014" v="1122" actId="2696"/>
        <pc:sldMkLst>
          <pc:docMk/>
          <pc:sldMk cId="488044088" sldId="258"/>
        </pc:sldMkLst>
      </pc:sldChg>
      <pc:sldChg chg="del">
        <pc:chgData name="Yu, Xiuping" userId="ac2e4f1e-fc05-4f95-96ac-8dbf0a7412b9" providerId="ADAL" clId="{0C4F8F60-2154-5A20-839A-5554B5BAE146}" dt="2025-12-26T21:44:07.081" v="1111" actId="2696"/>
        <pc:sldMkLst>
          <pc:docMk/>
          <pc:sldMk cId="2753984768" sldId="259"/>
        </pc:sldMkLst>
      </pc:sldChg>
      <pc:sldChg chg="del">
        <pc:chgData name="Yu, Xiuping" userId="ac2e4f1e-fc05-4f95-96ac-8dbf0a7412b9" providerId="ADAL" clId="{0C4F8F60-2154-5A20-839A-5554B5BAE146}" dt="2025-12-26T21:44:11.113" v="1120" actId="2696"/>
        <pc:sldMkLst>
          <pc:docMk/>
          <pc:sldMk cId="1614047336" sldId="263"/>
        </pc:sldMkLst>
      </pc:sldChg>
      <pc:sldChg chg="modSp del mod">
        <pc:chgData name="Yu, Xiuping" userId="ac2e4f1e-fc05-4f95-96ac-8dbf0a7412b9" providerId="ADAL" clId="{0C4F8F60-2154-5A20-839A-5554B5BAE146}" dt="2025-12-26T21:44:11.528" v="1121" actId="2696"/>
        <pc:sldMkLst>
          <pc:docMk/>
          <pc:sldMk cId="3959726341" sldId="264"/>
        </pc:sldMkLst>
        <pc:picChg chg="mod">
          <ac:chgData name="Yu, Xiuping" userId="ac2e4f1e-fc05-4f95-96ac-8dbf0a7412b9" providerId="ADAL" clId="{0C4F8F60-2154-5A20-839A-5554B5BAE146}" dt="2025-12-08T22:49:38.458" v="447" actId="1076"/>
          <ac:picMkLst>
            <pc:docMk/>
            <pc:sldMk cId="3959726341" sldId="264"/>
            <ac:picMk id="5" creationId="{0D1D9DA4-57BF-31D5-55C7-0797736B0629}"/>
          </ac:picMkLst>
        </pc:picChg>
        <pc:picChg chg="mod">
          <ac:chgData name="Yu, Xiuping" userId="ac2e4f1e-fc05-4f95-96ac-8dbf0a7412b9" providerId="ADAL" clId="{0C4F8F60-2154-5A20-839A-5554B5BAE146}" dt="2025-12-08T22:49:36.931" v="446" actId="1076"/>
          <ac:picMkLst>
            <pc:docMk/>
            <pc:sldMk cId="3959726341" sldId="264"/>
            <ac:picMk id="10" creationId="{535F7CDF-D13A-4F6B-CCA2-396FED0328AE}"/>
          </ac:picMkLst>
        </pc:picChg>
      </pc:sldChg>
      <pc:sldChg chg="modSp del mod">
        <pc:chgData name="Yu, Xiuping" userId="ac2e4f1e-fc05-4f95-96ac-8dbf0a7412b9" providerId="ADAL" clId="{0C4F8F60-2154-5A20-839A-5554B5BAE146}" dt="2025-12-26T21:44:12.417" v="1123" actId="2696"/>
        <pc:sldMkLst>
          <pc:docMk/>
          <pc:sldMk cId="3943996364" sldId="267"/>
        </pc:sldMkLst>
        <pc:picChg chg="mod">
          <ac:chgData name="Yu, Xiuping" userId="ac2e4f1e-fc05-4f95-96ac-8dbf0a7412b9" providerId="ADAL" clId="{0C4F8F60-2154-5A20-839A-5554B5BAE146}" dt="2025-12-08T22:52:23.729" v="502" actId="1076"/>
          <ac:picMkLst>
            <pc:docMk/>
            <pc:sldMk cId="3943996364" sldId="267"/>
            <ac:picMk id="3" creationId="{7AF901BA-14F7-AE10-3024-F34EE0E39C3C}"/>
          </ac:picMkLst>
        </pc:picChg>
        <pc:picChg chg="mod">
          <ac:chgData name="Yu, Xiuping" userId="ac2e4f1e-fc05-4f95-96ac-8dbf0a7412b9" providerId="ADAL" clId="{0C4F8F60-2154-5A20-839A-5554B5BAE146}" dt="2025-12-08T22:53:51.385" v="510" actId="1076"/>
          <ac:picMkLst>
            <pc:docMk/>
            <pc:sldMk cId="3943996364" sldId="267"/>
            <ac:picMk id="8" creationId="{B6779870-596C-D3F7-5F15-D91E2256D72A}"/>
          </ac:picMkLst>
        </pc:picChg>
      </pc:sldChg>
      <pc:sldChg chg="modSp del mod">
        <pc:chgData name="Yu, Xiuping" userId="ac2e4f1e-fc05-4f95-96ac-8dbf0a7412b9" providerId="ADAL" clId="{0C4F8F60-2154-5A20-839A-5554B5BAE146}" dt="2025-12-26T21:44:10.296" v="1118" actId="2696"/>
        <pc:sldMkLst>
          <pc:docMk/>
          <pc:sldMk cId="3020779692" sldId="269"/>
        </pc:sldMkLst>
        <pc:graphicFrameChg chg="modGraphic">
          <ac:chgData name="Yu, Xiuping" userId="ac2e4f1e-fc05-4f95-96ac-8dbf0a7412b9" providerId="ADAL" clId="{0C4F8F60-2154-5A20-839A-5554B5BAE146}" dt="2025-12-08T22:19:19.751" v="61" actId="14100"/>
          <ac:graphicFrameMkLst>
            <pc:docMk/>
            <pc:sldMk cId="3020779692" sldId="269"/>
            <ac:graphicFrameMk id="8" creationId="{46F4624E-4593-1A54-9234-4F4A2C570176}"/>
          </ac:graphicFrameMkLst>
        </pc:graphicFrameChg>
        <pc:picChg chg="mod">
          <ac:chgData name="Yu, Xiuping" userId="ac2e4f1e-fc05-4f95-96ac-8dbf0a7412b9" providerId="ADAL" clId="{0C4F8F60-2154-5A20-839A-5554B5BAE146}" dt="2025-12-08T22:42:25.369" v="425" actId="1076"/>
          <ac:picMkLst>
            <pc:docMk/>
            <pc:sldMk cId="3020779692" sldId="269"/>
            <ac:picMk id="3" creationId="{BDEBDFDD-0ECB-E549-E722-0031B247886C}"/>
          </ac:picMkLst>
        </pc:picChg>
        <pc:picChg chg="mod">
          <ac:chgData name="Yu, Xiuping" userId="ac2e4f1e-fc05-4f95-96ac-8dbf0a7412b9" providerId="ADAL" clId="{0C4F8F60-2154-5A20-839A-5554B5BAE146}" dt="2025-12-08T22:14:01.495" v="60" actId="14100"/>
          <ac:picMkLst>
            <pc:docMk/>
            <pc:sldMk cId="3020779692" sldId="269"/>
            <ac:picMk id="10" creationId="{F9AB6F49-4C26-DBFA-3A41-1D4DC983338B}"/>
          </ac:picMkLst>
        </pc:picChg>
      </pc:sldChg>
      <pc:sldChg chg="delSp modSp add del mod">
        <pc:chgData name="Yu, Xiuping" userId="ac2e4f1e-fc05-4f95-96ac-8dbf0a7412b9" providerId="ADAL" clId="{0C4F8F60-2154-5A20-839A-5554B5BAE146}" dt="2025-12-26T21:44:12.852" v="1124" actId="2696"/>
        <pc:sldMkLst>
          <pc:docMk/>
          <pc:sldMk cId="2013092284" sldId="271"/>
        </pc:sldMkLst>
        <pc:picChg chg="mod">
          <ac:chgData name="Yu, Xiuping" userId="ac2e4f1e-fc05-4f95-96ac-8dbf0a7412b9" providerId="ADAL" clId="{0C4F8F60-2154-5A20-839A-5554B5BAE146}" dt="2025-12-08T19:11:33.101" v="7" actId="1076"/>
          <ac:picMkLst>
            <pc:docMk/>
            <pc:sldMk cId="2013092284" sldId="271"/>
            <ac:picMk id="3" creationId="{3FE8A77C-2B5E-B239-27AA-B5F1CA7D5965}"/>
          </ac:picMkLst>
        </pc:picChg>
        <pc:picChg chg="mod">
          <ac:chgData name="Yu, Xiuping" userId="ac2e4f1e-fc05-4f95-96ac-8dbf0a7412b9" providerId="ADAL" clId="{0C4F8F60-2154-5A20-839A-5554B5BAE146}" dt="2025-12-08T19:11:37.533" v="10" actId="1076"/>
          <ac:picMkLst>
            <pc:docMk/>
            <pc:sldMk cId="2013092284" sldId="271"/>
            <ac:picMk id="7" creationId="{856C73E6-4EDE-DF48-3474-375C7E71D5BF}"/>
          </ac:picMkLst>
        </pc:picChg>
      </pc:sldChg>
      <pc:sldChg chg="addSp modSp add del mod modShow">
        <pc:chgData name="Yu, Xiuping" userId="ac2e4f1e-fc05-4f95-96ac-8dbf0a7412b9" providerId="ADAL" clId="{0C4F8F60-2154-5A20-839A-5554B5BAE146}" dt="2025-12-26T21:44:09.373" v="1116" actId="2696"/>
        <pc:sldMkLst>
          <pc:docMk/>
          <pc:sldMk cId="203407010" sldId="273"/>
        </pc:sldMkLst>
        <pc:picChg chg="add mod">
          <ac:chgData name="Yu, Xiuping" userId="ac2e4f1e-fc05-4f95-96ac-8dbf0a7412b9" providerId="ADAL" clId="{0C4F8F60-2154-5A20-839A-5554B5BAE146}" dt="2025-12-08T22:30:34.690" v="215" actId="14100"/>
          <ac:picMkLst>
            <pc:docMk/>
            <pc:sldMk cId="203407010" sldId="273"/>
            <ac:picMk id="5" creationId="{D9397D4D-87F8-4211-8F72-9AC9FC259FA5}"/>
          </ac:picMkLst>
        </pc:picChg>
        <pc:picChg chg="mod">
          <ac:chgData name="Yu, Xiuping" userId="ac2e4f1e-fc05-4f95-96ac-8dbf0a7412b9" providerId="ADAL" clId="{0C4F8F60-2154-5A20-839A-5554B5BAE146}" dt="2025-12-08T23:09:24.106" v="781" actId="1076"/>
          <ac:picMkLst>
            <pc:docMk/>
            <pc:sldMk cId="203407010" sldId="273"/>
            <ac:picMk id="11" creationId="{0D643C9D-75A4-82F7-4435-7CD4A5DAEAF9}"/>
          </ac:picMkLst>
        </pc:picChg>
      </pc:sldChg>
      <pc:sldChg chg="addSp delSp modSp new del mod">
        <pc:chgData name="Yu, Xiuping" userId="ac2e4f1e-fc05-4f95-96ac-8dbf0a7412b9" providerId="ADAL" clId="{0C4F8F60-2154-5A20-839A-5554B5BAE146}" dt="2025-12-26T21:44:08.941" v="1115" actId="2696"/>
        <pc:sldMkLst>
          <pc:docMk/>
          <pc:sldMk cId="626141910" sldId="274"/>
        </pc:sldMkLst>
        <pc:spChg chg="add mod">
          <ac:chgData name="Yu, Xiuping" userId="ac2e4f1e-fc05-4f95-96ac-8dbf0a7412b9" providerId="ADAL" clId="{0C4F8F60-2154-5A20-839A-5554B5BAE146}" dt="2025-12-08T22:56:46.670" v="643" actId="1076"/>
          <ac:spMkLst>
            <pc:docMk/>
            <pc:sldMk cId="626141910" sldId="274"/>
            <ac:spMk id="3" creationId="{378F4BF4-FE72-493F-3892-201898DB82E4}"/>
          </ac:spMkLst>
        </pc:spChg>
        <pc:spChg chg="add mod">
          <ac:chgData name="Yu, Xiuping" userId="ac2e4f1e-fc05-4f95-96ac-8dbf0a7412b9" providerId="ADAL" clId="{0C4F8F60-2154-5A20-839A-5554B5BAE146}" dt="2025-12-08T22:58:02.751" v="660" actId="1076"/>
          <ac:spMkLst>
            <pc:docMk/>
            <pc:sldMk cId="626141910" sldId="274"/>
            <ac:spMk id="5" creationId="{E60A0FD2-B62A-85A7-9CBD-552ADD785015}"/>
          </ac:spMkLst>
        </pc:spChg>
        <pc:spChg chg="add mod">
          <ac:chgData name="Yu, Xiuping" userId="ac2e4f1e-fc05-4f95-96ac-8dbf0a7412b9" providerId="ADAL" clId="{0C4F8F60-2154-5A20-839A-5554B5BAE146}" dt="2025-12-08T23:08:49.553" v="780"/>
          <ac:spMkLst>
            <pc:docMk/>
            <pc:sldMk cId="626141910" sldId="274"/>
            <ac:spMk id="6" creationId="{080FB266-8AAB-6330-5D17-9E117154B444}"/>
          </ac:spMkLst>
        </pc:spChg>
        <pc:spChg chg="add mod">
          <ac:chgData name="Yu, Xiuping" userId="ac2e4f1e-fc05-4f95-96ac-8dbf0a7412b9" providerId="ADAL" clId="{0C4F8F60-2154-5A20-839A-5554B5BAE146}" dt="2025-12-08T22:56:54.714" v="656" actId="20577"/>
          <ac:spMkLst>
            <pc:docMk/>
            <pc:sldMk cId="626141910" sldId="274"/>
            <ac:spMk id="7" creationId="{203FC4C2-ED68-DA59-BFA3-8D10E66A0AA3}"/>
          </ac:spMkLst>
        </pc:spChg>
      </pc:sldChg>
      <pc:sldChg chg="addSp modSp new del mod">
        <pc:chgData name="Yu, Xiuping" userId="ac2e4f1e-fc05-4f95-96ac-8dbf0a7412b9" providerId="ADAL" clId="{0C4F8F60-2154-5A20-839A-5554B5BAE146}" dt="2025-12-26T21:44:09.834" v="1117" actId="2696"/>
        <pc:sldMkLst>
          <pc:docMk/>
          <pc:sldMk cId="365266232" sldId="275"/>
        </pc:sldMkLst>
        <pc:spChg chg="add mod">
          <ac:chgData name="Yu, Xiuping" userId="ac2e4f1e-fc05-4f95-96ac-8dbf0a7412b9" providerId="ADAL" clId="{0C4F8F60-2154-5A20-839A-5554B5BAE146}" dt="2025-12-08T22:59:06.825" v="672" actId="20577"/>
          <ac:spMkLst>
            <pc:docMk/>
            <pc:sldMk cId="365266232" sldId="275"/>
            <ac:spMk id="2" creationId="{146538AB-92F8-B541-8740-CEAE1FC40882}"/>
          </ac:spMkLst>
        </pc:spChg>
        <pc:spChg chg="add mod">
          <ac:chgData name="Yu, Xiuping" userId="ac2e4f1e-fc05-4f95-96ac-8dbf0a7412b9" providerId="ADAL" clId="{0C4F8F60-2154-5A20-839A-5554B5BAE146}" dt="2025-12-08T23:14:29.524" v="880" actId="20577"/>
          <ac:spMkLst>
            <pc:docMk/>
            <pc:sldMk cId="365266232" sldId="275"/>
            <ac:spMk id="3" creationId="{4845E9A5-2975-606A-4AD9-B5BED425ABA0}"/>
          </ac:spMkLst>
        </pc:spChg>
      </pc:sldChg>
      <pc:sldChg chg="del">
        <pc:chgData name="Yu, Xiuping" userId="ac2e4f1e-fc05-4f95-96ac-8dbf0a7412b9" providerId="ADAL" clId="{0C4F8F60-2154-5A20-839A-5554B5BAE146}" dt="2025-12-26T21:44:08.014" v="1113" actId="2696"/>
        <pc:sldMkLst>
          <pc:docMk/>
          <pc:sldMk cId="3675010219" sldId="280"/>
        </pc:sldMkLst>
      </pc:sldChg>
      <pc:sldChg chg="del">
        <pc:chgData name="Yu, Xiuping" userId="ac2e4f1e-fc05-4f95-96ac-8dbf0a7412b9" providerId="ADAL" clId="{0C4F8F60-2154-5A20-839A-5554B5BAE146}" dt="2025-12-26T21:44:06.295" v="1109" actId="2696"/>
        <pc:sldMkLst>
          <pc:docMk/>
          <pc:sldMk cId="713100700" sldId="282"/>
        </pc:sldMkLst>
      </pc:sldChg>
      <pc:sldChg chg="del">
        <pc:chgData name="Yu, Xiuping" userId="ac2e4f1e-fc05-4f95-96ac-8dbf0a7412b9" providerId="ADAL" clId="{0C4F8F60-2154-5A20-839A-5554B5BAE146}" dt="2025-12-26T21:44:05.453" v="1107" actId="2696"/>
        <pc:sldMkLst>
          <pc:docMk/>
          <pc:sldMk cId="3181386242" sldId="284"/>
        </pc:sldMkLst>
      </pc:sldChg>
      <pc:sldChg chg="del">
        <pc:chgData name="Yu, Xiuping" userId="ac2e4f1e-fc05-4f95-96ac-8dbf0a7412b9" providerId="ADAL" clId="{0C4F8F60-2154-5A20-839A-5554B5BAE146}" dt="2025-12-26T21:44:06.668" v="1110" actId="2696"/>
        <pc:sldMkLst>
          <pc:docMk/>
          <pc:sldMk cId="3585903552" sldId="287"/>
        </pc:sldMkLst>
      </pc:sldChg>
      <pc:sldChg chg="del">
        <pc:chgData name="Yu, Xiuping" userId="ac2e4f1e-fc05-4f95-96ac-8dbf0a7412b9" providerId="ADAL" clId="{0C4F8F60-2154-5A20-839A-5554B5BAE146}" dt="2025-12-26T21:44:08.502" v="1114" actId="2696"/>
        <pc:sldMkLst>
          <pc:docMk/>
          <pc:sldMk cId="1516006560" sldId="288"/>
        </pc:sldMkLst>
      </pc:sldChg>
      <pc:sldChg chg="del">
        <pc:chgData name="Yu, Xiuping" userId="ac2e4f1e-fc05-4f95-96ac-8dbf0a7412b9" providerId="ADAL" clId="{0C4F8F60-2154-5A20-839A-5554B5BAE146}" dt="2025-12-26T21:44:14.748" v="1127" actId="2696"/>
        <pc:sldMkLst>
          <pc:docMk/>
          <pc:sldMk cId="3947205316" sldId="289"/>
        </pc:sldMkLst>
      </pc:sldChg>
      <pc:sldChg chg="del">
        <pc:chgData name="Yu, Xiuping" userId="ac2e4f1e-fc05-4f95-96ac-8dbf0a7412b9" providerId="ADAL" clId="{0C4F8F60-2154-5A20-839A-5554B5BAE146}" dt="2025-12-26T21:44:14.093" v="1126" actId="2696"/>
        <pc:sldMkLst>
          <pc:docMk/>
          <pc:sldMk cId="934877544" sldId="290"/>
        </pc:sldMkLst>
      </pc:sldChg>
      <pc:sldChg chg="del">
        <pc:chgData name="Yu, Xiuping" userId="ac2e4f1e-fc05-4f95-96ac-8dbf0a7412b9" providerId="ADAL" clId="{0C4F8F60-2154-5A20-839A-5554B5BAE146}" dt="2025-12-26T21:44:13.594" v="1125" actId="2696"/>
        <pc:sldMkLst>
          <pc:docMk/>
          <pc:sldMk cId="1492115307" sldId="291"/>
        </pc:sldMkLst>
      </pc:sldChg>
      <pc:sldChg chg="del">
        <pc:chgData name="Yu, Xiuping" userId="ac2e4f1e-fc05-4f95-96ac-8dbf0a7412b9" providerId="ADAL" clId="{0C4F8F60-2154-5A20-839A-5554B5BAE146}" dt="2025-12-26T21:44:10.689" v="1119" actId="2696"/>
        <pc:sldMkLst>
          <pc:docMk/>
          <pc:sldMk cId="1843042863" sldId="642"/>
        </pc:sldMkLst>
      </pc:sldChg>
      <pc:sldChg chg="addSp delSp modSp del mod">
        <pc:chgData name="Yu, Xiuping" userId="ac2e4f1e-fc05-4f95-96ac-8dbf0a7412b9" providerId="ADAL" clId="{0C4F8F60-2154-5A20-839A-5554B5BAE146}" dt="2025-12-26T21:43:52.584" v="1095" actId="2696"/>
        <pc:sldMkLst>
          <pc:docMk/>
          <pc:sldMk cId="1728686223" sldId="643"/>
        </pc:sldMkLst>
      </pc:sldChg>
      <pc:sldChg chg="del">
        <pc:chgData name="Yu, Xiuping" userId="ac2e4f1e-fc05-4f95-96ac-8dbf0a7412b9" providerId="ADAL" clId="{0C4F8F60-2154-5A20-839A-5554B5BAE146}" dt="2025-12-26T21:44:05.895" v="1108" actId="2696"/>
        <pc:sldMkLst>
          <pc:docMk/>
          <pc:sldMk cId="3242043502" sldId="644"/>
        </pc:sldMkLst>
      </pc:sldChg>
      <pc:sldChg chg="del">
        <pc:chgData name="Yu, Xiuping" userId="ac2e4f1e-fc05-4f95-96ac-8dbf0a7412b9" providerId="ADAL" clId="{0C4F8F60-2154-5A20-839A-5554B5BAE146}" dt="2025-12-26T21:43:54.705" v="1097" actId="2696"/>
        <pc:sldMkLst>
          <pc:docMk/>
          <pc:sldMk cId="519917293" sldId="645"/>
        </pc:sldMkLst>
      </pc:sldChg>
      <pc:sldChg chg="modSp del mod">
        <pc:chgData name="Yu, Xiuping" userId="ac2e4f1e-fc05-4f95-96ac-8dbf0a7412b9" providerId="ADAL" clId="{0C4F8F60-2154-5A20-839A-5554B5BAE146}" dt="2025-12-26T21:43:54.149" v="1096" actId="2696"/>
        <pc:sldMkLst>
          <pc:docMk/>
          <pc:sldMk cId="291814838" sldId="646"/>
        </pc:sldMkLst>
      </pc:sldChg>
      <pc:sldChg chg="del">
        <pc:chgData name="Yu, Xiuping" userId="ac2e4f1e-fc05-4f95-96ac-8dbf0a7412b9" providerId="ADAL" clId="{0C4F8F60-2154-5A20-839A-5554B5BAE146}" dt="2025-12-26T21:43:55.329" v="1098" actId="2696"/>
        <pc:sldMkLst>
          <pc:docMk/>
          <pc:sldMk cId="4057417521" sldId="647"/>
        </pc:sldMkLst>
      </pc:sldChg>
      <pc:sldChg chg="del">
        <pc:chgData name="Yu, Xiuping" userId="ac2e4f1e-fc05-4f95-96ac-8dbf0a7412b9" providerId="ADAL" clId="{0C4F8F60-2154-5A20-839A-5554B5BAE146}" dt="2025-12-26T21:43:56.731" v="1099" actId="2696"/>
        <pc:sldMkLst>
          <pc:docMk/>
          <pc:sldMk cId="1117536012" sldId="648"/>
        </pc:sldMkLst>
      </pc:sldChg>
      <pc:sldChg chg="del">
        <pc:chgData name="Yu, Xiuping" userId="ac2e4f1e-fc05-4f95-96ac-8dbf0a7412b9" providerId="ADAL" clId="{0C4F8F60-2154-5A20-839A-5554B5BAE146}" dt="2025-12-26T21:44:00.762" v="1102" actId="2696"/>
        <pc:sldMkLst>
          <pc:docMk/>
          <pc:sldMk cId="216910369" sldId="649"/>
        </pc:sldMkLst>
      </pc:sldChg>
      <pc:sldChg chg="delSp modSp del mod">
        <pc:chgData name="Yu, Xiuping" userId="ac2e4f1e-fc05-4f95-96ac-8dbf0a7412b9" providerId="ADAL" clId="{0C4F8F60-2154-5A20-839A-5554B5BAE146}" dt="2025-12-26T21:44:01.404" v="1103" actId="2696"/>
        <pc:sldMkLst>
          <pc:docMk/>
          <pc:sldMk cId="1475420211" sldId="650"/>
        </pc:sldMkLst>
        <pc:spChg chg="del">
          <ac:chgData name="Yu, Xiuping" userId="ac2e4f1e-fc05-4f95-96ac-8dbf0a7412b9" providerId="ADAL" clId="{0C4F8F60-2154-5A20-839A-5554B5BAE146}" dt="2025-12-25T19:42:44.767" v="1079" actId="478"/>
          <ac:spMkLst>
            <pc:docMk/>
            <pc:sldMk cId="1475420211" sldId="650"/>
            <ac:spMk id="7" creationId="{F04C884C-CAD6-2026-BB6C-1B63E2BAC2FA}"/>
          </ac:spMkLst>
        </pc:spChg>
        <pc:spChg chg="del">
          <ac:chgData name="Yu, Xiuping" userId="ac2e4f1e-fc05-4f95-96ac-8dbf0a7412b9" providerId="ADAL" clId="{0C4F8F60-2154-5A20-839A-5554B5BAE146}" dt="2025-12-25T19:42:44.767" v="1079" actId="478"/>
          <ac:spMkLst>
            <pc:docMk/>
            <pc:sldMk cId="1475420211" sldId="650"/>
            <ac:spMk id="9" creationId="{C507A94F-84CE-9CB6-7A5C-AD24C6B348CC}"/>
          </ac:spMkLst>
        </pc:spChg>
        <pc:spChg chg="mod">
          <ac:chgData name="Yu, Xiuping" userId="ac2e4f1e-fc05-4f95-96ac-8dbf0a7412b9" providerId="ADAL" clId="{0C4F8F60-2154-5A20-839A-5554B5BAE146}" dt="2025-12-25T19:43:04.879" v="1093" actId="20577"/>
          <ac:spMkLst>
            <pc:docMk/>
            <pc:sldMk cId="1475420211" sldId="650"/>
            <ac:spMk id="11" creationId="{527519C9-223B-5823-ED3C-C96CD9356BCD}"/>
          </ac:spMkLst>
        </pc:spChg>
        <pc:spChg chg="del">
          <ac:chgData name="Yu, Xiuping" userId="ac2e4f1e-fc05-4f95-96ac-8dbf0a7412b9" providerId="ADAL" clId="{0C4F8F60-2154-5A20-839A-5554B5BAE146}" dt="2025-12-25T19:42:44.767" v="1079" actId="478"/>
          <ac:spMkLst>
            <pc:docMk/>
            <pc:sldMk cId="1475420211" sldId="650"/>
            <ac:spMk id="14" creationId="{B313C46C-B042-B155-F164-46A65C0064E4}"/>
          </ac:spMkLst>
        </pc:spChg>
        <pc:spChg chg="del">
          <ac:chgData name="Yu, Xiuping" userId="ac2e4f1e-fc05-4f95-96ac-8dbf0a7412b9" providerId="ADAL" clId="{0C4F8F60-2154-5A20-839A-5554B5BAE146}" dt="2025-12-25T19:42:44.767" v="1079" actId="478"/>
          <ac:spMkLst>
            <pc:docMk/>
            <pc:sldMk cId="1475420211" sldId="650"/>
            <ac:spMk id="16" creationId="{80A633CD-291F-22D5-AD37-8DD13A12E217}"/>
          </ac:spMkLst>
        </pc:spChg>
        <pc:spChg chg="del">
          <ac:chgData name="Yu, Xiuping" userId="ac2e4f1e-fc05-4f95-96ac-8dbf0a7412b9" providerId="ADAL" clId="{0C4F8F60-2154-5A20-839A-5554B5BAE146}" dt="2025-12-25T19:42:53.574" v="1080" actId="478"/>
          <ac:spMkLst>
            <pc:docMk/>
            <pc:sldMk cId="1475420211" sldId="650"/>
            <ac:spMk id="21" creationId="{E6934452-44AB-CCB4-3A78-9BD911DDA42A}"/>
          </ac:spMkLst>
        </pc:spChg>
        <pc:picChg chg="mod">
          <ac:chgData name="Yu, Xiuping" userId="ac2e4f1e-fc05-4f95-96ac-8dbf0a7412b9" providerId="ADAL" clId="{0C4F8F60-2154-5A20-839A-5554B5BAE146}" dt="2025-12-25T19:51:13.050" v="1094" actId="1076"/>
          <ac:picMkLst>
            <pc:docMk/>
            <pc:sldMk cId="1475420211" sldId="650"/>
            <ac:picMk id="6" creationId="{C6A3DB4C-69D7-266A-8843-6B1BAAB6FD11}"/>
          </ac:picMkLst>
        </pc:picChg>
        <pc:picChg chg="del">
          <ac:chgData name="Yu, Xiuping" userId="ac2e4f1e-fc05-4f95-96ac-8dbf0a7412b9" providerId="ADAL" clId="{0C4F8F60-2154-5A20-839A-5554B5BAE146}" dt="2025-12-25T19:42:44.767" v="1079" actId="478"/>
          <ac:picMkLst>
            <pc:docMk/>
            <pc:sldMk cId="1475420211" sldId="650"/>
            <ac:picMk id="13" creationId="{131ACA8B-1CF0-6CB5-91E4-D527F5D289EF}"/>
          </ac:picMkLst>
        </pc:picChg>
        <pc:picChg chg="del">
          <ac:chgData name="Yu, Xiuping" userId="ac2e4f1e-fc05-4f95-96ac-8dbf0a7412b9" providerId="ADAL" clId="{0C4F8F60-2154-5A20-839A-5554B5BAE146}" dt="2025-12-25T19:42:44.767" v="1079" actId="478"/>
          <ac:picMkLst>
            <pc:docMk/>
            <pc:sldMk cId="1475420211" sldId="650"/>
            <ac:picMk id="15" creationId="{DC9C8B69-0CC1-CBAA-CC9D-F8816C7A9A57}"/>
          </ac:picMkLst>
        </pc:picChg>
      </pc:sldChg>
      <pc:sldChg chg="del">
        <pc:chgData name="Yu, Xiuping" userId="ac2e4f1e-fc05-4f95-96ac-8dbf0a7412b9" providerId="ADAL" clId="{0C4F8F60-2154-5A20-839A-5554B5BAE146}" dt="2025-12-26T21:44:07.550" v="1112" actId="2696"/>
        <pc:sldMkLst>
          <pc:docMk/>
          <pc:sldMk cId="3697398347" sldId="651"/>
        </pc:sldMkLst>
      </pc:sldChg>
      <pc:sldChg chg="del">
        <pc:chgData name="Yu, Xiuping" userId="ac2e4f1e-fc05-4f95-96ac-8dbf0a7412b9" providerId="ADAL" clId="{0C4F8F60-2154-5A20-839A-5554B5BAE146}" dt="2025-12-26T21:44:03.971" v="1104" actId="2696"/>
        <pc:sldMkLst>
          <pc:docMk/>
          <pc:sldMk cId="4161354762" sldId="652"/>
        </pc:sldMkLst>
      </pc:sldChg>
      <pc:sldChg chg="del">
        <pc:chgData name="Yu, Xiuping" userId="ac2e4f1e-fc05-4f95-96ac-8dbf0a7412b9" providerId="ADAL" clId="{0C4F8F60-2154-5A20-839A-5554B5BAE146}" dt="2025-12-26T21:44:04.480" v="1105" actId="2696"/>
        <pc:sldMkLst>
          <pc:docMk/>
          <pc:sldMk cId="3595176212" sldId="653"/>
        </pc:sldMkLst>
      </pc:sldChg>
      <pc:sldChg chg="addSp delSp modSp del mod">
        <pc:chgData name="Yu, Xiuping" userId="ac2e4f1e-fc05-4f95-96ac-8dbf0a7412b9" providerId="ADAL" clId="{0C4F8F60-2154-5A20-839A-5554B5BAE146}" dt="2025-12-26T21:43:58.015" v="1100" actId="2696"/>
        <pc:sldMkLst>
          <pc:docMk/>
          <pc:sldMk cId="4027378674" sldId="654"/>
        </pc:sldMkLst>
        <pc:spChg chg="add del mod">
          <ac:chgData name="Yu, Xiuping" userId="ac2e4f1e-fc05-4f95-96ac-8dbf0a7412b9" providerId="ADAL" clId="{0C4F8F60-2154-5A20-839A-5554B5BAE146}" dt="2025-12-25T18:35:49.865" v="1077" actId="478"/>
          <ac:spMkLst>
            <pc:docMk/>
            <pc:sldMk cId="4027378674" sldId="654"/>
            <ac:spMk id="18" creationId="{0A4DECF0-A26C-AC57-7540-A97F500B568B}"/>
          </ac:spMkLst>
        </pc:spChg>
        <pc:grpChg chg="del mod">
          <ac:chgData name="Yu, Xiuping" userId="ac2e4f1e-fc05-4f95-96ac-8dbf0a7412b9" providerId="ADAL" clId="{0C4F8F60-2154-5A20-839A-5554B5BAE146}" dt="2025-12-25T18:35:49.865" v="1077" actId="478"/>
          <ac:grpSpMkLst>
            <pc:docMk/>
            <pc:sldMk cId="4027378674" sldId="654"/>
            <ac:grpSpMk id="20" creationId="{F3325F55-C36C-3607-A45D-DF006EAF3B9F}"/>
          </ac:grpSpMkLst>
        </pc:grpChg>
      </pc:sldChg>
      <pc:sldChg chg="add del">
        <pc:chgData name="Yu, Xiuping" userId="ac2e4f1e-fc05-4f95-96ac-8dbf0a7412b9" providerId="ADAL" clId="{0C4F8F60-2154-5A20-839A-5554B5BAE146}" dt="2025-12-26T21:43:58.896" v="1101" actId="2696"/>
        <pc:sldMkLst>
          <pc:docMk/>
          <pc:sldMk cId="397768212" sldId="655"/>
        </pc:sldMkLst>
      </pc:sldChg>
      <pc:sldChg chg="delSp modSp add mod">
        <pc:chgData name="Yu, Xiuping" userId="ac2e4f1e-fc05-4f95-96ac-8dbf0a7412b9" providerId="ADAL" clId="{0C4F8F60-2154-5A20-839A-5554B5BAE146}" dt="2025-12-26T21:44:32.917" v="1134" actId="1076"/>
        <pc:sldMkLst>
          <pc:docMk/>
          <pc:sldMk cId="3889193849" sldId="656"/>
        </pc:sldMkLst>
        <pc:spChg chg="del mod">
          <ac:chgData name="Yu, Xiuping" userId="ac2e4f1e-fc05-4f95-96ac-8dbf0a7412b9" providerId="ADAL" clId="{0C4F8F60-2154-5A20-839A-5554B5BAE146}" dt="2025-12-26T21:44:25.390" v="1131" actId="478"/>
          <ac:spMkLst>
            <pc:docMk/>
            <pc:sldMk cId="3889193849" sldId="656"/>
            <ac:spMk id="3" creationId="{7D0F26FA-29B3-603D-3345-18B6BC0BE0EE}"/>
          </ac:spMkLst>
        </pc:spChg>
        <pc:spChg chg="mod">
          <ac:chgData name="Yu, Xiuping" userId="ac2e4f1e-fc05-4f95-96ac-8dbf0a7412b9" providerId="ADAL" clId="{0C4F8F60-2154-5A20-839A-5554B5BAE146}" dt="2025-12-26T21:44:32.917" v="1134" actId="1076"/>
          <ac:spMkLst>
            <pc:docMk/>
            <pc:sldMk cId="3889193849" sldId="656"/>
            <ac:spMk id="7" creationId="{E80FF366-2A52-C994-5A04-AC5290FF05D9}"/>
          </ac:spMkLst>
        </pc:spChg>
        <pc:spChg chg="del">
          <ac:chgData name="Yu, Xiuping" userId="ac2e4f1e-fc05-4f95-96ac-8dbf0a7412b9" providerId="ADAL" clId="{0C4F8F60-2154-5A20-839A-5554B5BAE146}" dt="2025-12-26T21:44:28.822" v="1133" actId="478"/>
          <ac:spMkLst>
            <pc:docMk/>
            <pc:sldMk cId="3889193849" sldId="656"/>
            <ac:spMk id="9" creationId="{2B2C35D7-3C9B-BDF1-0597-05FB38532944}"/>
          </ac:spMkLst>
        </pc:spChg>
        <pc:spChg chg="del">
          <ac:chgData name="Yu, Xiuping" userId="ac2e4f1e-fc05-4f95-96ac-8dbf0a7412b9" providerId="ADAL" clId="{0C4F8F60-2154-5A20-839A-5554B5BAE146}" dt="2025-12-26T21:44:19.991" v="1129" actId="478"/>
          <ac:spMkLst>
            <pc:docMk/>
            <pc:sldMk cId="3889193849" sldId="656"/>
            <ac:spMk id="11" creationId="{CDA826B4-B13C-BBE6-FEF5-996660C03C88}"/>
          </ac:spMkLst>
        </pc:spChg>
        <pc:spChg chg="mod">
          <ac:chgData name="Yu, Xiuping" userId="ac2e4f1e-fc05-4f95-96ac-8dbf0a7412b9" providerId="ADAL" clId="{0C4F8F60-2154-5A20-839A-5554B5BAE146}" dt="2025-12-26T21:44:32.917" v="1134" actId="1076"/>
          <ac:spMkLst>
            <pc:docMk/>
            <pc:sldMk cId="3889193849" sldId="656"/>
            <ac:spMk id="14" creationId="{B023A4EB-E32E-DA67-878D-834FAF058637}"/>
          </ac:spMkLst>
        </pc:spChg>
        <pc:spChg chg="mod">
          <ac:chgData name="Yu, Xiuping" userId="ac2e4f1e-fc05-4f95-96ac-8dbf0a7412b9" providerId="ADAL" clId="{0C4F8F60-2154-5A20-839A-5554B5BAE146}" dt="2025-12-26T21:44:32.917" v="1134" actId="1076"/>
          <ac:spMkLst>
            <pc:docMk/>
            <pc:sldMk cId="3889193849" sldId="656"/>
            <ac:spMk id="16" creationId="{BDBBFEF0-1093-4603-34BB-89A7847EC7E0}"/>
          </ac:spMkLst>
        </pc:spChg>
        <pc:spChg chg="del">
          <ac:chgData name="Yu, Xiuping" userId="ac2e4f1e-fc05-4f95-96ac-8dbf0a7412b9" providerId="ADAL" clId="{0C4F8F60-2154-5A20-839A-5554B5BAE146}" dt="2025-12-26T21:44:27.259" v="1132" actId="478"/>
          <ac:spMkLst>
            <pc:docMk/>
            <pc:sldMk cId="3889193849" sldId="656"/>
            <ac:spMk id="21" creationId="{29B13534-B441-D669-75DC-CDE7577DB466}"/>
          </ac:spMkLst>
        </pc:spChg>
        <pc:picChg chg="del">
          <ac:chgData name="Yu, Xiuping" userId="ac2e4f1e-fc05-4f95-96ac-8dbf0a7412b9" providerId="ADAL" clId="{0C4F8F60-2154-5A20-839A-5554B5BAE146}" dt="2025-12-26T21:44:18.090" v="1128" actId="478"/>
          <ac:picMkLst>
            <pc:docMk/>
            <pc:sldMk cId="3889193849" sldId="656"/>
            <ac:picMk id="6" creationId="{3337D499-EE49-DD99-2C45-98F6DD6C7DCB}"/>
          </ac:picMkLst>
        </pc:picChg>
        <pc:picChg chg="mod">
          <ac:chgData name="Yu, Xiuping" userId="ac2e4f1e-fc05-4f95-96ac-8dbf0a7412b9" providerId="ADAL" clId="{0C4F8F60-2154-5A20-839A-5554B5BAE146}" dt="2025-12-26T21:44:32.917" v="1134" actId="1076"/>
          <ac:picMkLst>
            <pc:docMk/>
            <pc:sldMk cId="3889193849" sldId="656"/>
            <ac:picMk id="13" creationId="{566F7BB9-46AB-722C-5174-2C0A00BA54B3}"/>
          </ac:picMkLst>
        </pc:picChg>
        <pc:picChg chg="mod">
          <ac:chgData name="Yu, Xiuping" userId="ac2e4f1e-fc05-4f95-96ac-8dbf0a7412b9" providerId="ADAL" clId="{0C4F8F60-2154-5A20-839A-5554B5BAE146}" dt="2025-12-26T21:44:32.917" v="1134" actId="1076"/>
          <ac:picMkLst>
            <pc:docMk/>
            <pc:sldMk cId="3889193849" sldId="656"/>
            <ac:picMk id="15" creationId="{1E981A29-EC98-2DFD-2E76-D76F54D2C61A}"/>
          </ac:picMkLst>
        </pc:picChg>
      </pc:sldChg>
    </pc:docChg>
  </pc:docChgLst>
  <pc:docChgLst>
    <pc:chgData name="Sivalingam, Jeyaluxmy" userId="96f68579-a127-49fa-9da1-6d3ea75fe666" providerId="ADAL" clId="{9672C6C1-9324-409B-9F17-6D4882F253CE}"/>
    <pc:docChg chg="undo redo custSel addSld delSld modSld sldOrd modMainMaster modNotesMaster">
      <pc:chgData name="Sivalingam, Jeyaluxmy" userId="96f68579-a127-49fa-9da1-6d3ea75fe666" providerId="ADAL" clId="{9672C6C1-9324-409B-9F17-6D4882F253CE}" dt="2025-12-23T20:03:13.974" v="5007" actId="14100"/>
      <pc:docMkLst>
        <pc:docMk/>
      </pc:docMkLst>
      <pc:sldChg chg="addSp delSp modSp mod modShow modNotes">
        <pc:chgData name="Sivalingam, Jeyaluxmy" userId="96f68579-a127-49fa-9da1-6d3ea75fe666" providerId="ADAL" clId="{9672C6C1-9324-409B-9F17-6D4882F253CE}" dt="2025-12-18T20:30:55.922" v="2983" actId="729"/>
        <pc:sldMkLst>
          <pc:docMk/>
          <pc:sldMk cId="3347007978" sldId="257"/>
        </pc:sldMkLst>
      </pc:sldChg>
      <pc:sldChg chg="addSp modSp mod modShow">
        <pc:chgData name="Sivalingam, Jeyaluxmy" userId="96f68579-a127-49fa-9da1-6d3ea75fe666" providerId="ADAL" clId="{9672C6C1-9324-409B-9F17-6D4882F253CE}" dt="2025-12-15T21:19:17.789" v="2966" actId="729"/>
        <pc:sldMkLst>
          <pc:docMk/>
          <pc:sldMk cId="488044088" sldId="258"/>
        </pc:sldMkLst>
        <pc:grpChg chg="add mod">
          <ac:chgData name="Sivalingam, Jeyaluxmy" userId="96f68579-a127-49fa-9da1-6d3ea75fe666" providerId="ADAL" clId="{9672C6C1-9324-409B-9F17-6D4882F253CE}" dt="2025-12-07T22:54:53.239" v="2334"/>
          <ac:grpSpMkLst>
            <pc:docMk/>
            <pc:sldMk cId="488044088" sldId="258"/>
            <ac:grpSpMk id="20" creationId="{326EEA94-D8A2-F957-D129-141AD6BACBE5}"/>
          </ac:grpSpMkLst>
        </pc:grpChg>
        <pc:grpChg chg="mod">
          <ac:chgData name="Sivalingam, Jeyaluxmy" userId="96f68579-a127-49fa-9da1-6d3ea75fe666" providerId="ADAL" clId="{9672C6C1-9324-409B-9F17-6D4882F253CE}" dt="2025-12-07T22:54:53.239" v="2334"/>
          <ac:grpSpMkLst>
            <pc:docMk/>
            <pc:sldMk cId="488044088" sldId="258"/>
            <ac:grpSpMk id="35" creationId="{891F7A5E-2B9D-FE3E-8DB6-FAEE64F30B54}"/>
          </ac:grpSpMkLst>
        </pc:grpChg>
        <pc:graphicFrameChg chg="mod">
          <ac:chgData name="Sivalingam, Jeyaluxmy" userId="96f68579-a127-49fa-9da1-6d3ea75fe666" providerId="ADAL" clId="{9672C6C1-9324-409B-9F17-6D4882F253CE}" dt="2025-12-07T22:54:53.239" v="2334"/>
          <ac:graphicFrameMkLst>
            <pc:docMk/>
            <pc:sldMk cId="488044088" sldId="258"/>
            <ac:graphicFrameMk id="2" creationId="{323AE648-BAB4-629C-940C-8A29F3160276}"/>
          </ac:graphicFrameMkLst>
        </pc:graphicFrameChg>
        <pc:graphicFrameChg chg="mod">
          <ac:chgData name="Sivalingam, Jeyaluxmy" userId="96f68579-a127-49fa-9da1-6d3ea75fe666" providerId="ADAL" clId="{9672C6C1-9324-409B-9F17-6D4882F253CE}" dt="2025-12-07T22:54:53.239" v="2334"/>
          <ac:graphicFrameMkLst>
            <pc:docMk/>
            <pc:sldMk cId="488044088" sldId="258"/>
            <ac:graphicFrameMk id="26" creationId="{165E3DD1-1A17-C4D0-7925-3DE28EE785C7}"/>
          </ac:graphicFrameMkLst>
        </pc:graphicFrameChg>
        <pc:cxnChg chg="mod">
          <ac:chgData name="Sivalingam, Jeyaluxmy" userId="96f68579-a127-49fa-9da1-6d3ea75fe666" providerId="ADAL" clId="{9672C6C1-9324-409B-9F17-6D4882F253CE}" dt="2025-12-07T22:54:53.239" v="2334"/>
          <ac:cxnSpMkLst>
            <pc:docMk/>
            <pc:sldMk cId="488044088" sldId="258"/>
            <ac:cxnSpMk id="36" creationId="{676A5264-DD26-4E33-5AEF-7ED8FD4E458F}"/>
          </ac:cxnSpMkLst>
        </pc:cxnChg>
        <pc:cxnChg chg="mod">
          <ac:chgData name="Sivalingam, Jeyaluxmy" userId="96f68579-a127-49fa-9da1-6d3ea75fe666" providerId="ADAL" clId="{9672C6C1-9324-409B-9F17-6D4882F253CE}" dt="2025-12-07T22:54:53.239" v="2334"/>
          <ac:cxnSpMkLst>
            <pc:docMk/>
            <pc:sldMk cId="488044088" sldId="258"/>
            <ac:cxnSpMk id="37" creationId="{9C6DE323-EDFF-4124-348A-611EEAD1F10D}"/>
          </ac:cxnSpMkLst>
        </pc:cxnChg>
      </pc:sldChg>
      <pc:sldChg chg="addSp delSp modSp new mod modShow">
        <pc:chgData name="Sivalingam, Jeyaluxmy" userId="96f68579-a127-49fa-9da1-6d3ea75fe666" providerId="ADAL" clId="{9672C6C1-9324-409B-9F17-6D4882F253CE}" dt="2025-12-15T21:19:17.789" v="2966" actId="729"/>
        <pc:sldMkLst>
          <pc:docMk/>
          <pc:sldMk cId="1614047336" sldId="263"/>
        </pc:sldMkLst>
        <pc:spChg chg="add mod">
          <ac:chgData name="Sivalingam, Jeyaluxmy" userId="96f68579-a127-49fa-9da1-6d3ea75fe666" providerId="ADAL" clId="{9672C6C1-9324-409B-9F17-6D4882F253CE}" dt="2025-12-04T20:13:49.906" v="1771" actId="1076"/>
          <ac:spMkLst>
            <pc:docMk/>
            <pc:sldMk cId="1614047336" sldId="263"/>
            <ac:spMk id="7" creationId="{4592AD76-0287-8C08-E4EC-B82D5C70141F}"/>
          </ac:spMkLst>
        </pc:spChg>
        <pc:spChg chg="add mod">
          <ac:chgData name="Sivalingam, Jeyaluxmy" userId="96f68579-a127-49fa-9da1-6d3ea75fe666" providerId="ADAL" clId="{9672C6C1-9324-409B-9F17-6D4882F253CE}" dt="2025-12-04T20:14:50.126" v="1786" actId="1076"/>
          <ac:spMkLst>
            <pc:docMk/>
            <pc:sldMk cId="1614047336" sldId="263"/>
            <ac:spMk id="10" creationId="{2AB08662-368F-6F23-238D-1BBBA92653A6}"/>
          </ac:spMkLst>
        </pc:spChg>
        <pc:picChg chg="add mod ord">
          <ac:chgData name="Sivalingam, Jeyaluxmy" userId="96f68579-a127-49fa-9da1-6d3ea75fe666" providerId="ADAL" clId="{9672C6C1-9324-409B-9F17-6D4882F253CE}" dt="2025-12-05T00:31:13.700" v="2177" actId="14100"/>
          <ac:picMkLst>
            <pc:docMk/>
            <pc:sldMk cId="1614047336" sldId="263"/>
            <ac:picMk id="4" creationId="{23D3DA49-3855-9EEC-36B4-4EB8719BF8C9}"/>
          </ac:picMkLst>
        </pc:picChg>
        <pc:picChg chg="add mod">
          <ac:chgData name="Sivalingam, Jeyaluxmy" userId="96f68579-a127-49fa-9da1-6d3ea75fe666" providerId="ADAL" clId="{9672C6C1-9324-409B-9F17-6D4882F253CE}" dt="2025-12-04T20:12:39.490" v="1763" actId="1076"/>
          <ac:picMkLst>
            <pc:docMk/>
            <pc:sldMk cId="1614047336" sldId="263"/>
            <ac:picMk id="5" creationId="{BDA7D22F-62D3-E02E-CD14-9CFF6233A0E0}"/>
          </ac:picMkLst>
        </pc:picChg>
        <pc:picChg chg="add mod">
          <ac:chgData name="Sivalingam, Jeyaluxmy" userId="96f68579-a127-49fa-9da1-6d3ea75fe666" providerId="ADAL" clId="{9672C6C1-9324-409B-9F17-6D4882F253CE}" dt="2025-12-04T20:14:32.098" v="1776" actId="1076"/>
          <ac:picMkLst>
            <pc:docMk/>
            <pc:sldMk cId="1614047336" sldId="263"/>
            <ac:picMk id="8" creationId="{BC77970F-FD5A-7294-ABBF-D192D9990C8A}"/>
          </ac:picMkLst>
        </pc:picChg>
      </pc:sldChg>
      <pc:sldChg chg="addSp delSp modSp new mod modShow">
        <pc:chgData name="Sivalingam, Jeyaluxmy" userId="96f68579-a127-49fa-9da1-6d3ea75fe666" providerId="ADAL" clId="{9672C6C1-9324-409B-9F17-6D4882F253CE}" dt="2025-12-15T21:19:17.789" v="2966" actId="729"/>
        <pc:sldMkLst>
          <pc:docMk/>
          <pc:sldMk cId="3959726341" sldId="264"/>
        </pc:sldMkLst>
        <pc:spChg chg="add mod">
          <ac:chgData name="Sivalingam, Jeyaluxmy" userId="96f68579-a127-49fa-9da1-6d3ea75fe666" providerId="ADAL" clId="{9672C6C1-9324-409B-9F17-6D4882F253CE}" dt="2025-12-04T20:15:49.060" v="1802" actId="1076"/>
          <ac:spMkLst>
            <pc:docMk/>
            <pc:sldMk cId="3959726341" sldId="264"/>
            <ac:spMk id="4" creationId="{C26A5A2F-916C-7FE4-23CA-AECD7EC259D5}"/>
          </ac:spMkLst>
        </pc:spChg>
        <pc:graphicFrameChg chg="add mod modGraphic">
          <ac:chgData name="Sivalingam, Jeyaluxmy" userId="96f68579-a127-49fa-9da1-6d3ea75fe666" providerId="ADAL" clId="{9672C6C1-9324-409B-9F17-6D4882F253CE}" dt="2025-12-04T20:35:43.985" v="1815" actId="1076"/>
          <ac:graphicFrameMkLst>
            <pc:docMk/>
            <pc:sldMk cId="3959726341" sldId="264"/>
            <ac:graphicFrameMk id="8" creationId="{99146DB5-5178-CFD2-AFA8-1A727750FBD3}"/>
          </ac:graphicFrameMkLst>
        </pc:graphicFrameChg>
        <pc:picChg chg="add mod">
          <ac:chgData name="Sivalingam, Jeyaluxmy" userId="96f68579-a127-49fa-9da1-6d3ea75fe666" providerId="ADAL" clId="{9672C6C1-9324-409B-9F17-6D4882F253CE}" dt="2025-12-04T20:15:25.152" v="1791" actId="1076"/>
          <ac:picMkLst>
            <pc:docMk/>
            <pc:sldMk cId="3959726341" sldId="264"/>
            <ac:picMk id="2" creationId="{DD6F4415-7011-4612-F40E-EC05BD4F68C9}"/>
          </ac:picMkLst>
        </pc:picChg>
        <pc:picChg chg="add mod">
          <ac:chgData name="Sivalingam, Jeyaluxmy" userId="96f68579-a127-49fa-9da1-6d3ea75fe666" providerId="ADAL" clId="{9672C6C1-9324-409B-9F17-6D4882F253CE}" dt="2025-12-04T20:16:09.741" v="1805" actId="1076"/>
          <ac:picMkLst>
            <pc:docMk/>
            <pc:sldMk cId="3959726341" sldId="264"/>
            <ac:picMk id="5" creationId="{0D1D9DA4-57BF-31D5-55C7-0797736B0629}"/>
          </ac:picMkLst>
        </pc:picChg>
        <pc:picChg chg="add mod">
          <ac:chgData name="Sivalingam, Jeyaluxmy" userId="96f68579-a127-49fa-9da1-6d3ea75fe666" providerId="ADAL" clId="{9672C6C1-9324-409B-9F17-6D4882F253CE}" dt="2025-12-04T23:05:18.393" v="2144" actId="1076"/>
          <ac:picMkLst>
            <pc:docMk/>
            <pc:sldMk cId="3959726341" sldId="264"/>
            <ac:picMk id="10" creationId="{535F7CDF-D13A-4F6B-CCA2-396FED0328AE}"/>
          </ac:picMkLst>
        </pc:picChg>
      </pc:sldChg>
      <pc:sldChg chg="addSp delSp modSp new mod modShow">
        <pc:chgData name="Sivalingam, Jeyaluxmy" userId="96f68579-a127-49fa-9da1-6d3ea75fe666" providerId="ADAL" clId="{9672C6C1-9324-409B-9F17-6D4882F253CE}" dt="2025-12-05T00:29:55.560" v="2172" actId="729"/>
        <pc:sldMkLst>
          <pc:docMk/>
          <pc:sldMk cId="3943996364" sldId="267"/>
        </pc:sldMkLst>
        <pc:picChg chg="add mod">
          <ac:chgData name="Sivalingam, Jeyaluxmy" userId="96f68579-a127-49fa-9da1-6d3ea75fe666" providerId="ADAL" clId="{9672C6C1-9324-409B-9F17-6D4882F253CE}" dt="2025-12-04T23:39:02.629" v="2160" actId="1076"/>
          <ac:picMkLst>
            <pc:docMk/>
            <pc:sldMk cId="3943996364" sldId="267"/>
            <ac:picMk id="4" creationId="{7341921E-5940-7014-07C5-3860EC9CEB56}"/>
          </ac:picMkLst>
        </pc:picChg>
        <pc:picChg chg="add mod">
          <ac:chgData name="Sivalingam, Jeyaluxmy" userId="96f68579-a127-49fa-9da1-6d3ea75fe666" providerId="ADAL" clId="{9672C6C1-9324-409B-9F17-6D4882F253CE}" dt="2025-12-04T23:38:27.444" v="2158" actId="1076"/>
          <ac:picMkLst>
            <pc:docMk/>
            <pc:sldMk cId="3943996364" sldId="267"/>
            <ac:picMk id="6" creationId="{3DFCCEC5-C990-27C3-9C48-BE2C26FA4468}"/>
          </ac:picMkLst>
        </pc:picChg>
        <pc:picChg chg="add mod">
          <ac:chgData name="Sivalingam, Jeyaluxmy" userId="96f68579-a127-49fa-9da1-6d3ea75fe666" providerId="ADAL" clId="{9672C6C1-9324-409B-9F17-6D4882F253CE}" dt="2025-12-04T23:42:57.393" v="2165" actId="1076"/>
          <ac:picMkLst>
            <pc:docMk/>
            <pc:sldMk cId="3943996364" sldId="267"/>
            <ac:picMk id="8" creationId="{B6779870-596C-D3F7-5F15-D91E2256D72A}"/>
          </ac:picMkLst>
        </pc:picChg>
        <pc:picChg chg="add mod">
          <ac:chgData name="Sivalingam, Jeyaluxmy" userId="96f68579-a127-49fa-9da1-6d3ea75fe666" providerId="ADAL" clId="{9672C6C1-9324-409B-9F17-6D4882F253CE}" dt="2025-12-04T23:44:14.825" v="2170" actId="1076"/>
          <ac:picMkLst>
            <pc:docMk/>
            <pc:sldMk cId="3943996364" sldId="267"/>
            <ac:picMk id="12" creationId="{24AF34B8-DB79-55F4-45CB-D09CF3B37D74}"/>
          </ac:picMkLst>
        </pc:picChg>
      </pc:sldChg>
      <pc:sldChg chg="addSp modSp new mod modShow modNotesTx">
        <pc:chgData name="Sivalingam, Jeyaluxmy" userId="96f68579-a127-49fa-9da1-6d3ea75fe666" providerId="ADAL" clId="{9672C6C1-9324-409B-9F17-6D4882F253CE}" dt="2025-12-15T21:19:17.789" v="2966" actId="729"/>
        <pc:sldMkLst>
          <pc:docMk/>
          <pc:sldMk cId="3020779692" sldId="269"/>
        </pc:sldMkLst>
        <pc:graphicFrameChg chg="add mod modGraphic">
          <ac:chgData name="Sivalingam, Jeyaluxmy" userId="96f68579-a127-49fa-9da1-6d3ea75fe666" providerId="ADAL" clId="{9672C6C1-9324-409B-9F17-6D4882F253CE}" dt="2025-12-07T22:43:34.948" v="2286" actId="14100"/>
          <ac:graphicFrameMkLst>
            <pc:docMk/>
            <pc:sldMk cId="3020779692" sldId="269"/>
            <ac:graphicFrameMk id="8" creationId="{46F4624E-4593-1A54-9234-4F4A2C570176}"/>
          </ac:graphicFrameMkLst>
        </pc:graphicFrameChg>
        <pc:picChg chg="add mod">
          <ac:chgData name="Sivalingam, Jeyaluxmy" userId="96f68579-a127-49fa-9da1-6d3ea75fe666" providerId="ADAL" clId="{9672C6C1-9324-409B-9F17-6D4882F253CE}" dt="2025-12-07T21:28:47.915" v="2233" actId="962"/>
          <ac:picMkLst>
            <pc:docMk/>
            <pc:sldMk cId="3020779692" sldId="269"/>
            <ac:picMk id="3" creationId="{BDEBDFDD-0ECB-E549-E722-0031B247886C}"/>
          </ac:picMkLst>
        </pc:picChg>
        <pc:picChg chg="add mod">
          <ac:chgData name="Sivalingam, Jeyaluxmy" userId="96f68579-a127-49fa-9da1-6d3ea75fe666" providerId="ADAL" clId="{9672C6C1-9324-409B-9F17-6D4882F253CE}" dt="2025-12-07T22:01:45.756" v="2276" actId="14100"/>
          <ac:picMkLst>
            <pc:docMk/>
            <pc:sldMk cId="3020779692" sldId="269"/>
            <ac:picMk id="5" creationId="{6C0C31F6-C39B-0894-0EC5-5BF7F178D109}"/>
          </ac:picMkLst>
        </pc:picChg>
        <pc:picChg chg="add mod">
          <ac:chgData name="Sivalingam, Jeyaluxmy" userId="96f68579-a127-49fa-9da1-6d3ea75fe666" providerId="ADAL" clId="{9672C6C1-9324-409B-9F17-6D4882F253CE}" dt="2025-12-07T21:57:23.189" v="2260" actId="1076"/>
          <ac:picMkLst>
            <pc:docMk/>
            <pc:sldMk cId="3020779692" sldId="269"/>
            <ac:picMk id="7" creationId="{58A09450-97BA-8049-BC69-27C004994B05}"/>
          </ac:picMkLst>
        </pc:picChg>
        <pc:picChg chg="add mod">
          <ac:chgData name="Sivalingam, Jeyaluxmy" userId="96f68579-a127-49fa-9da1-6d3ea75fe666" providerId="ADAL" clId="{9672C6C1-9324-409B-9F17-6D4882F253CE}" dt="2025-12-07T22:47:25.542" v="2288" actId="14100"/>
          <ac:picMkLst>
            <pc:docMk/>
            <pc:sldMk cId="3020779692" sldId="269"/>
            <ac:picMk id="10" creationId="{F9AB6F49-4C26-DBFA-3A41-1D4DC983338B}"/>
          </ac:picMkLst>
        </pc:picChg>
      </pc:sldChg>
      <pc:sldChg chg="modSp mod">
        <pc:chgData name="Sivalingam, Jeyaluxmy" userId="96f68579-a127-49fa-9da1-6d3ea75fe666" providerId="ADAL" clId="{9672C6C1-9324-409B-9F17-6D4882F253CE}" dt="2025-12-19T19:50:51.703" v="3966" actId="14100"/>
        <pc:sldMkLst>
          <pc:docMk/>
          <pc:sldMk cId="203407010" sldId="273"/>
        </pc:sldMkLst>
        <pc:picChg chg="mod">
          <ac:chgData name="Sivalingam, Jeyaluxmy" userId="96f68579-a127-49fa-9da1-6d3ea75fe666" providerId="ADAL" clId="{9672C6C1-9324-409B-9F17-6D4882F253CE}" dt="2025-12-19T19:50:51.703" v="3966" actId="14100"/>
          <ac:picMkLst>
            <pc:docMk/>
            <pc:sldMk cId="203407010" sldId="273"/>
            <ac:picMk id="11" creationId="{0D643C9D-75A4-82F7-4435-7CD4A5DAEAF9}"/>
          </ac:picMkLst>
        </pc:picChg>
      </pc:sldChg>
      <pc:sldChg chg="mod modShow">
        <pc:chgData name="Sivalingam, Jeyaluxmy" userId="96f68579-a127-49fa-9da1-6d3ea75fe666" providerId="ADAL" clId="{9672C6C1-9324-409B-9F17-6D4882F253CE}" dt="2025-12-15T21:19:17.789" v="2966" actId="729"/>
        <pc:sldMkLst>
          <pc:docMk/>
          <pc:sldMk cId="626141910" sldId="274"/>
        </pc:sldMkLst>
      </pc:sldChg>
      <pc:sldChg chg="mod modShow">
        <pc:chgData name="Sivalingam, Jeyaluxmy" userId="96f68579-a127-49fa-9da1-6d3ea75fe666" providerId="ADAL" clId="{9672C6C1-9324-409B-9F17-6D4882F253CE}" dt="2025-12-15T21:19:17.789" v="2966" actId="729"/>
        <pc:sldMkLst>
          <pc:docMk/>
          <pc:sldMk cId="365266232" sldId="275"/>
        </pc:sldMkLst>
      </pc:sldChg>
      <pc:sldChg chg="addSp delSp modSp mod">
        <pc:chgData name="Sivalingam, Jeyaluxmy" userId="96f68579-a127-49fa-9da1-6d3ea75fe666" providerId="ADAL" clId="{9672C6C1-9324-409B-9F17-6D4882F253CE}" dt="2025-12-18T21:18:38.147" v="3464" actId="1076"/>
        <pc:sldMkLst>
          <pc:docMk/>
          <pc:sldMk cId="3675010219" sldId="280"/>
        </pc:sldMkLst>
        <pc:spChg chg="add mod">
          <ac:chgData name="Sivalingam, Jeyaluxmy" userId="96f68579-a127-49fa-9da1-6d3ea75fe666" providerId="ADAL" clId="{9672C6C1-9324-409B-9F17-6D4882F253CE}" dt="2025-12-18T21:08:16.555" v="3386" actId="13926"/>
          <ac:spMkLst>
            <pc:docMk/>
            <pc:sldMk cId="3675010219" sldId="280"/>
            <ac:spMk id="3" creationId="{84CD1FD0-2F62-69CB-B983-915BF3DAAB71}"/>
          </ac:spMkLst>
        </pc:spChg>
        <pc:spChg chg="add mod">
          <ac:chgData name="Sivalingam, Jeyaluxmy" userId="96f68579-a127-49fa-9da1-6d3ea75fe666" providerId="ADAL" clId="{9672C6C1-9324-409B-9F17-6D4882F253CE}" dt="2025-12-18T21:08:10.698" v="3385" actId="403"/>
          <ac:spMkLst>
            <pc:docMk/>
            <pc:sldMk cId="3675010219" sldId="280"/>
            <ac:spMk id="6" creationId="{4617A9EA-B7E1-3002-A7EB-8ED964B2A60F}"/>
          </ac:spMkLst>
        </pc:spChg>
        <pc:graphicFrameChg chg="add mod">
          <ac:chgData name="Sivalingam, Jeyaluxmy" userId="96f68579-a127-49fa-9da1-6d3ea75fe666" providerId="ADAL" clId="{9672C6C1-9324-409B-9F17-6D4882F253CE}" dt="2025-12-18T21:18:38.147" v="3464" actId="1076"/>
          <ac:graphicFrameMkLst>
            <pc:docMk/>
            <pc:sldMk cId="3675010219" sldId="280"/>
            <ac:graphicFrameMk id="7" creationId="{80871883-B1D8-5F5D-519A-F46E4F2FE2AC}"/>
          </ac:graphicFrameMkLst>
        </pc:graphicFrameChg>
        <pc:graphicFrameChg chg="add mod">
          <ac:chgData name="Sivalingam, Jeyaluxmy" userId="96f68579-a127-49fa-9da1-6d3ea75fe666" providerId="ADAL" clId="{9672C6C1-9324-409B-9F17-6D4882F253CE}" dt="2025-12-18T21:18:38.147" v="3464" actId="1076"/>
          <ac:graphicFrameMkLst>
            <pc:docMk/>
            <pc:sldMk cId="3675010219" sldId="280"/>
            <ac:graphicFrameMk id="12" creationId="{0B7F57CF-AC37-5C9C-D8A0-E9813486170C}"/>
          </ac:graphicFrameMkLst>
        </pc:graphicFrameChg>
      </pc:sldChg>
      <pc:sldChg chg="addSp delSp modSp mod ord modShow">
        <pc:chgData name="Sivalingam, Jeyaluxmy" userId="96f68579-a127-49fa-9da1-6d3ea75fe666" providerId="ADAL" clId="{9672C6C1-9324-409B-9F17-6D4882F253CE}" dt="2025-12-18T20:46:29.034" v="3142" actId="478"/>
        <pc:sldMkLst>
          <pc:docMk/>
          <pc:sldMk cId="3181386242" sldId="284"/>
        </pc:sldMkLst>
        <pc:graphicFrameChg chg="mod">
          <ac:chgData name="Sivalingam, Jeyaluxmy" userId="96f68579-a127-49fa-9da1-6d3ea75fe666" providerId="ADAL" clId="{9672C6C1-9324-409B-9F17-6D4882F253CE}" dt="2025-12-14T23:04:53.873" v="2748" actId="403"/>
          <ac:graphicFrameMkLst>
            <pc:docMk/>
            <pc:sldMk cId="3181386242" sldId="284"/>
            <ac:graphicFrameMk id="23" creationId="{791DB506-3C6B-AF82-20E3-D340A5BE442C}"/>
          </ac:graphicFrameMkLst>
        </pc:graphicFrameChg>
        <pc:picChg chg="mod">
          <ac:chgData name="Sivalingam, Jeyaluxmy" userId="96f68579-a127-49fa-9da1-6d3ea75fe666" providerId="ADAL" clId="{9672C6C1-9324-409B-9F17-6D4882F253CE}" dt="2025-12-14T23:05:06.826" v="2760" actId="1076"/>
          <ac:picMkLst>
            <pc:docMk/>
            <pc:sldMk cId="3181386242" sldId="284"/>
            <ac:picMk id="9" creationId="{45A506F3-36F9-A472-5449-53BD1153B91F}"/>
          </ac:picMkLst>
        </pc:picChg>
        <pc:picChg chg="add mod">
          <ac:chgData name="Sivalingam, Jeyaluxmy" userId="96f68579-a127-49fa-9da1-6d3ea75fe666" providerId="ADAL" clId="{9672C6C1-9324-409B-9F17-6D4882F253CE}" dt="2025-12-15T21:09:41.774" v="2854" actId="1076"/>
          <ac:picMkLst>
            <pc:docMk/>
            <pc:sldMk cId="3181386242" sldId="284"/>
            <ac:picMk id="16" creationId="{12713FA9-226F-8FA0-6F5D-DD45F03DDFCA}"/>
          </ac:picMkLst>
        </pc:picChg>
        <pc:picChg chg="mod">
          <ac:chgData name="Sivalingam, Jeyaluxmy" userId="96f68579-a127-49fa-9da1-6d3ea75fe666" providerId="ADAL" clId="{9672C6C1-9324-409B-9F17-6D4882F253CE}" dt="2025-12-14T23:05:06.826" v="2760" actId="1076"/>
          <ac:picMkLst>
            <pc:docMk/>
            <pc:sldMk cId="3181386242" sldId="284"/>
            <ac:picMk id="41" creationId="{1D966C84-14EF-A8A2-2FC0-3029DCC10CB4}"/>
          </ac:picMkLst>
        </pc:picChg>
      </pc:sldChg>
      <pc:sldChg chg="addSp delSp modSp mod ord modShow">
        <pc:chgData name="Sivalingam, Jeyaluxmy" userId="96f68579-a127-49fa-9da1-6d3ea75fe666" providerId="ADAL" clId="{9672C6C1-9324-409B-9F17-6D4882F253CE}" dt="2025-12-23T19:55:29.872" v="4984"/>
        <pc:sldMkLst>
          <pc:docMk/>
          <pc:sldMk cId="216910369" sldId="649"/>
        </pc:sldMkLst>
        <pc:spChg chg="mod">
          <ac:chgData name="Sivalingam, Jeyaluxmy" userId="96f68579-a127-49fa-9da1-6d3ea75fe666" providerId="ADAL" clId="{9672C6C1-9324-409B-9F17-6D4882F253CE}" dt="2025-12-23T19:51:30.449" v="4881" actId="165"/>
          <ac:spMkLst>
            <pc:docMk/>
            <pc:sldMk cId="216910369" sldId="649"/>
            <ac:spMk id="5" creationId="{2074C57B-51D7-7966-9E47-97E215FC5010}"/>
          </ac:spMkLst>
        </pc:spChg>
        <pc:spChg chg="mod">
          <ac:chgData name="Sivalingam, Jeyaluxmy" userId="96f68579-a127-49fa-9da1-6d3ea75fe666" providerId="ADAL" clId="{9672C6C1-9324-409B-9F17-6D4882F253CE}" dt="2025-12-23T19:51:30.449" v="4881" actId="165"/>
          <ac:spMkLst>
            <pc:docMk/>
            <pc:sldMk cId="216910369" sldId="649"/>
            <ac:spMk id="6" creationId="{5548BB90-F40C-8178-FC7A-44AD6DD3B010}"/>
          </ac:spMkLst>
        </pc:spChg>
        <pc:spChg chg="mod">
          <ac:chgData name="Sivalingam, Jeyaluxmy" userId="96f68579-a127-49fa-9da1-6d3ea75fe666" providerId="ADAL" clId="{9672C6C1-9324-409B-9F17-6D4882F253CE}" dt="2025-12-23T19:51:30.449" v="4881" actId="165"/>
          <ac:spMkLst>
            <pc:docMk/>
            <pc:sldMk cId="216910369" sldId="649"/>
            <ac:spMk id="7" creationId="{B45CCA44-E6B0-2ADC-3BA6-DCD5676D1A65}"/>
          </ac:spMkLst>
        </pc:spChg>
        <pc:spChg chg="mod">
          <ac:chgData name="Sivalingam, Jeyaluxmy" userId="96f68579-a127-49fa-9da1-6d3ea75fe666" providerId="ADAL" clId="{9672C6C1-9324-409B-9F17-6D4882F253CE}" dt="2025-12-23T19:51:30.449" v="4881" actId="165"/>
          <ac:spMkLst>
            <pc:docMk/>
            <pc:sldMk cId="216910369" sldId="649"/>
            <ac:spMk id="8" creationId="{50678EFC-933A-E32C-EE11-C7806AF0E437}"/>
          </ac:spMkLst>
        </pc:spChg>
        <pc:spChg chg="mod topLvl">
          <ac:chgData name="Sivalingam, Jeyaluxmy" userId="96f68579-a127-49fa-9da1-6d3ea75fe666" providerId="ADAL" clId="{9672C6C1-9324-409B-9F17-6D4882F253CE}" dt="2025-12-23T19:52:31.980" v="4886" actId="165"/>
          <ac:spMkLst>
            <pc:docMk/>
            <pc:sldMk cId="216910369" sldId="649"/>
            <ac:spMk id="61" creationId="{62AF20EF-93BA-302B-AEF0-A5AF7D9630EA}"/>
          </ac:spMkLst>
        </pc:spChg>
        <pc:spChg chg="mod topLvl">
          <ac:chgData name="Sivalingam, Jeyaluxmy" userId="96f68579-a127-49fa-9da1-6d3ea75fe666" providerId="ADAL" clId="{9672C6C1-9324-409B-9F17-6D4882F253CE}" dt="2025-12-23T19:52:31.980" v="4886" actId="165"/>
          <ac:spMkLst>
            <pc:docMk/>
            <pc:sldMk cId="216910369" sldId="649"/>
            <ac:spMk id="62" creationId="{3660BC26-18D4-44FA-E63C-F463B292B59F}"/>
          </ac:spMkLst>
        </pc:spChg>
        <pc:spChg chg="mod topLvl">
          <ac:chgData name="Sivalingam, Jeyaluxmy" userId="96f68579-a127-49fa-9da1-6d3ea75fe666" providerId="ADAL" clId="{9672C6C1-9324-409B-9F17-6D4882F253CE}" dt="2025-12-23T19:52:31.980" v="4886" actId="165"/>
          <ac:spMkLst>
            <pc:docMk/>
            <pc:sldMk cId="216910369" sldId="649"/>
            <ac:spMk id="64" creationId="{814E556B-6E1B-B2A9-F2D2-00468E1E5DB1}"/>
          </ac:spMkLst>
        </pc:spChg>
        <pc:spChg chg="mod topLvl">
          <ac:chgData name="Sivalingam, Jeyaluxmy" userId="96f68579-a127-49fa-9da1-6d3ea75fe666" providerId="ADAL" clId="{9672C6C1-9324-409B-9F17-6D4882F253CE}" dt="2025-12-23T19:52:31.980" v="4886" actId="165"/>
          <ac:spMkLst>
            <pc:docMk/>
            <pc:sldMk cId="216910369" sldId="649"/>
            <ac:spMk id="65" creationId="{AF690EAD-1318-13D1-7FAC-604478FA21EB}"/>
          </ac:spMkLst>
        </pc:spChg>
        <pc:spChg chg="mod topLvl">
          <ac:chgData name="Sivalingam, Jeyaluxmy" userId="96f68579-a127-49fa-9da1-6d3ea75fe666" providerId="ADAL" clId="{9672C6C1-9324-409B-9F17-6D4882F253CE}" dt="2025-12-23T19:52:26.539" v="4885" actId="165"/>
          <ac:spMkLst>
            <pc:docMk/>
            <pc:sldMk cId="216910369" sldId="649"/>
            <ac:spMk id="79" creationId="{F4524283-52F6-6817-18D4-492EC6756489}"/>
          </ac:spMkLst>
        </pc:spChg>
        <pc:spChg chg="mod topLvl">
          <ac:chgData name="Sivalingam, Jeyaluxmy" userId="96f68579-a127-49fa-9da1-6d3ea75fe666" providerId="ADAL" clId="{9672C6C1-9324-409B-9F17-6D4882F253CE}" dt="2025-12-23T19:52:26.539" v="4885" actId="165"/>
          <ac:spMkLst>
            <pc:docMk/>
            <pc:sldMk cId="216910369" sldId="649"/>
            <ac:spMk id="80" creationId="{3903D2E0-32F8-0406-BC62-6CF1E9743350}"/>
          </ac:spMkLst>
        </pc:spChg>
        <pc:spChg chg="mod topLvl">
          <ac:chgData name="Sivalingam, Jeyaluxmy" userId="96f68579-a127-49fa-9da1-6d3ea75fe666" providerId="ADAL" clId="{9672C6C1-9324-409B-9F17-6D4882F253CE}" dt="2025-12-23T19:52:26.539" v="4885" actId="165"/>
          <ac:spMkLst>
            <pc:docMk/>
            <pc:sldMk cId="216910369" sldId="649"/>
            <ac:spMk id="81" creationId="{9FAA83EA-3C83-D1B1-CB61-343442502B17}"/>
          </ac:spMkLst>
        </pc:spChg>
        <pc:grpChg chg="mod topLvl">
          <ac:chgData name="Sivalingam, Jeyaluxmy" userId="96f68579-a127-49fa-9da1-6d3ea75fe666" providerId="ADAL" clId="{9672C6C1-9324-409B-9F17-6D4882F253CE}" dt="2025-12-23T19:52:31.980" v="4886" actId="165"/>
          <ac:grpSpMkLst>
            <pc:docMk/>
            <pc:sldMk cId="216910369" sldId="649"/>
            <ac:grpSpMk id="67" creationId="{4AE258E5-176A-6F14-43E2-BCF78A513389}"/>
          </ac:grpSpMkLst>
        </pc:grpChg>
        <pc:grpChg chg="mod topLvl">
          <ac:chgData name="Sivalingam, Jeyaluxmy" userId="96f68579-a127-49fa-9da1-6d3ea75fe666" providerId="ADAL" clId="{9672C6C1-9324-409B-9F17-6D4882F253CE}" dt="2025-12-23T19:52:31.980" v="4886" actId="165"/>
          <ac:grpSpMkLst>
            <pc:docMk/>
            <pc:sldMk cId="216910369" sldId="649"/>
            <ac:grpSpMk id="69" creationId="{49382D3B-07B6-C6F8-3C28-AD462BA32D98}"/>
          </ac:grpSpMkLst>
        </pc:grpChg>
        <pc:grpChg chg="mod topLvl">
          <ac:chgData name="Sivalingam, Jeyaluxmy" userId="96f68579-a127-49fa-9da1-6d3ea75fe666" providerId="ADAL" clId="{9672C6C1-9324-409B-9F17-6D4882F253CE}" dt="2025-12-23T19:52:31.980" v="4886" actId="165"/>
          <ac:grpSpMkLst>
            <pc:docMk/>
            <pc:sldMk cId="216910369" sldId="649"/>
            <ac:grpSpMk id="70" creationId="{1127B2A3-B881-0C74-D1EC-9DDBF6861988}"/>
          </ac:grpSpMkLst>
        </pc:grpChg>
        <pc:graphicFrameChg chg="mod">
          <ac:chgData name="Sivalingam, Jeyaluxmy" userId="96f68579-a127-49fa-9da1-6d3ea75fe666" providerId="ADAL" clId="{9672C6C1-9324-409B-9F17-6D4882F253CE}" dt="2025-12-22T21:43:05.854" v="4394" actId="2085"/>
          <ac:graphicFrameMkLst>
            <pc:docMk/>
            <pc:sldMk cId="216910369" sldId="649"/>
            <ac:graphicFrameMk id="13" creationId="{445AB3BD-4EB8-4AD9-82C5-4118BFAC00B3}"/>
          </ac:graphicFrameMkLst>
        </pc:graphicFrameChg>
        <pc:picChg chg="add mod">
          <ac:chgData name="Sivalingam, Jeyaluxmy" userId="96f68579-a127-49fa-9da1-6d3ea75fe666" providerId="ADAL" clId="{9672C6C1-9324-409B-9F17-6D4882F253CE}" dt="2025-12-22T21:42:38.787" v="4393" actId="1076"/>
          <ac:picMkLst>
            <pc:docMk/>
            <pc:sldMk cId="216910369" sldId="649"/>
            <ac:picMk id="12" creationId="{96FDE139-63EB-8FE6-2E2C-A7D5BBA878E2}"/>
          </ac:picMkLst>
        </pc:picChg>
        <pc:picChg chg="mod topLvl">
          <ac:chgData name="Sivalingam, Jeyaluxmy" userId="96f68579-a127-49fa-9da1-6d3ea75fe666" providerId="ADAL" clId="{9672C6C1-9324-409B-9F17-6D4882F253CE}" dt="2025-12-23T19:52:31.980" v="4886" actId="165"/>
          <ac:picMkLst>
            <pc:docMk/>
            <pc:sldMk cId="216910369" sldId="649"/>
            <ac:picMk id="59" creationId="{DCE3A36D-4D7B-9071-4780-83F2130127B0}"/>
          </ac:picMkLst>
        </pc:picChg>
        <pc:picChg chg="mod topLvl">
          <ac:chgData name="Sivalingam, Jeyaluxmy" userId="96f68579-a127-49fa-9da1-6d3ea75fe666" providerId="ADAL" clId="{9672C6C1-9324-409B-9F17-6D4882F253CE}" dt="2025-12-23T19:52:31.980" v="4886" actId="165"/>
          <ac:picMkLst>
            <pc:docMk/>
            <pc:sldMk cId="216910369" sldId="649"/>
            <ac:picMk id="63" creationId="{3197C6FA-4091-8917-1507-CE40746589A8}"/>
          </ac:picMkLst>
        </pc:picChg>
      </pc:sldChg>
      <pc:sldChg chg="addSp delSp modSp mod">
        <pc:chgData name="Sivalingam, Jeyaluxmy" userId="96f68579-a127-49fa-9da1-6d3ea75fe666" providerId="ADAL" clId="{9672C6C1-9324-409B-9F17-6D4882F253CE}" dt="2025-12-23T17:52:13.033" v="4672" actId="123"/>
        <pc:sldMkLst>
          <pc:docMk/>
          <pc:sldMk cId="1475420211" sldId="650"/>
        </pc:sldMkLst>
        <pc:spChg chg="add mod">
          <ac:chgData name="Sivalingam, Jeyaluxmy" userId="96f68579-a127-49fa-9da1-6d3ea75fe666" providerId="ADAL" clId="{9672C6C1-9324-409B-9F17-6D4882F253CE}" dt="2025-12-23T17:52:13.033" v="4672" actId="123"/>
          <ac:spMkLst>
            <pc:docMk/>
            <pc:sldMk cId="1475420211" sldId="650"/>
            <ac:spMk id="11" creationId="{527519C9-223B-5823-ED3C-C96CD9356BCD}"/>
          </ac:spMkLst>
        </pc:spChg>
        <pc:picChg chg="mod">
          <ac:chgData name="Sivalingam, Jeyaluxmy" userId="96f68579-a127-49fa-9da1-6d3ea75fe666" providerId="ADAL" clId="{9672C6C1-9324-409B-9F17-6D4882F253CE}" dt="2025-12-23T16:08:45.960" v="4547" actId="14100"/>
          <ac:picMkLst>
            <pc:docMk/>
            <pc:sldMk cId="1475420211" sldId="650"/>
            <ac:picMk id="6" creationId="{C6A3DB4C-69D7-266A-8843-6B1BAAB6FD11}"/>
          </ac:picMkLst>
        </pc:picChg>
      </pc:sldChg>
      <pc:sldChg chg="addSp delSp modSp new mod">
        <pc:chgData name="Sivalingam, Jeyaluxmy" userId="96f68579-a127-49fa-9da1-6d3ea75fe666" providerId="ADAL" clId="{9672C6C1-9324-409B-9F17-6D4882F253CE}" dt="2025-12-23T18:06:34.751" v="4880" actId="20577"/>
        <pc:sldMkLst>
          <pc:docMk/>
          <pc:sldMk cId="4161354762" sldId="652"/>
        </pc:sldMkLst>
        <pc:spChg chg="add mod">
          <ac:chgData name="Sivalingam, Jeyaluxmy" userId="96f68579-a127-49fa-9da1-6d3ea75fe666" providerId="ADAL" clId="{9672C6C1-9324-409B-9F17-6D4882F253CE}" dt="2025-12-23T18:06:34.751" v="4880" actId="20577"/>
          <ac:spMkLst>
            <pc:docMk/>
            <pc:sldMk cId="4161354762" sldId="652"/>
            <ac:spMk id="6" creationId="{08E4C849-1149-B32C-9B07-5840D545CADB}"/>
          </ac:spMkLst>
        </pc:spChg>
        <pc:spChg chg="add mod">
          <ac:chgData name="Sivalingam, Jeyaluxmy" userId="96f68579-a127-49fa-9da1-6d3ea75fe666" providerId="ADAL" clId="{9672C6C1-9324-409B-9F17-6D4882F253CE}" dt="2025-12-23T18:01:30.154" v="4818" actId="14100"/>
          <ac:spMkLst>
            <pc:docMk/>
            <pc:sldMk cId="4161354762" sldId="652"/>
            <ac:spMk id="11" creationId="{49D85EDC-3735-F976-D40C-F84BCFBEC2DF}"/>
          </ac:spMkLst>
        </pc:spChg>
        <pc:spChg chg="add mod">
          <ac:chgData name="Sivalingam, Jeyaluxmy" userId="96f68579-a127-49fa-9da1-6d3ea75fe666" providerId="ADAL" clId="{9672C6C1-9324-409B-9F17-6D4882F253CE}" dt="2025-12-23T18:01:24.663" v="4817" actId="1076"/>
          <ac:spMkLst>
            <pc:docMk/>
            <pc:sldMk cId="4161354762" sldId="652"/>
            <ac:spMk id="13" creationId="{FE7A1EF3-0F93-1B4B-D2AD-EDB5DE521631}"/>
          </ac:spMkLst>
        </pc:spChg>
        <pc:spChg chg="add mod">
          <ac:chgData name="Sivalingam, Jeyaluxmy" userId="96f68579-a127-49fa-9da1-6d3ea75fe666" providerId="ADAL" clId="{9672C6C1-9324-409B-9F17-6D4882F253CE}" dt="2025-12-23T18:04:18.361" v="4855"/>
          <ac:spMkLst>
            <pc:docMk/>
            <pc:sldMk cId="4161354762" sldId="652"/>
            <ac:spMk id="15" creationId="{63B07863-B978-BF3F-E52E-4137C2605ACB}"/>
          </ac:spMkLst>
        </pc:spChg>
        <pc:spChg chg="add mod">
          <ac:chgData name="Sivalingam, Jeyaluxmy" userId="96f68579-a127-49fa-9da1-6d3ea75fe666" providerId="ADAL" clId="{9672C6C1-9324-409B-9F17-6D4882F253CE}" dt="2025-12-23T18:00:51.131" v="4802" actId="20577"/>
          <ac:spMkLst>
            <pc:docMk/>
            <pc:sldMk cId="4161354762" sldId="652"/>
            <ac:spMk id="18" creationId="{DBFE7C5F-D7FA-914A-9788-DC9B21224185}"/>
          </ac:spMkLst>
        </pc:spChg>
        <pc:spChg chg="add mod">
          <ac:chgData name="Sivalingam, Jeyaluxmy" userId="96f68579-a127-49fa-9da1-6d3ea75fe666" providerId="ADAL" clId="{9672C6C1-9324-409B-9F17-6D4882F253CE}" dt="2025-12-23T18:00:59.698" v="4805" actId="1076"/>
          <ac:spMkLst>
            <pc:docMk/>
            <pc:sldMk cId="4161354762" sldId="652"/>
            <ac:spMk id="19" creationId="{EB6EDFE3-1FB5-D4F1-1DCB-900BB043DC1C}"/>
          </ac:spMkLst>
        </pc:spChg>
        <pc:spChg chg="add mod">
          <ac:chgData name="Sivalingam, Jeyaluxmy" userId="96f68579-a127-49fa-9da1-6d3ea75fe666" providerId="ADAL" clId="{9672C6C1-9324-409B-9F17-6D4882F253CE}" dt="2025-12-23T18:01:02.404" v="4807" actId="20577"/>
          <ac:spMkLst>
            <pc:docMk/>
            <pc:sldMk cId="4161354762" sldId="652"/>
            <ac:spMk id="20" creationId="{EF65557D-2C9C-696C-9AA0-B24E996D3564}"/>
          </ac:spMkLst>
        </pc:spChg>
        <pc:spChg chg="add mod">
          <ac:chgData name="Sivalingam, Jeyaluxmy" userId="96f68579-a127-49fa-9da1-6d3ea75fe666" providerId="ADAL" clId="{9672C6C1-9324-409B-9F17-6D4882F253CE}" dt="2025-12-23T18:06:25.784" v="4876" actId="1076"/>
          <ac:spMkLst>
            <pc:docMk/>
            <pc:sldMk cId="4161354762" sldId="652"/>
            <ac:spMk id="23" creationId="{1CF1A8B7-C8E4-F998-3F31-431B0DFAE98A}"/>
          </ac:spMkLst>
        </pc:spChg>
        <pc:graphicFrameChg chg="add mod">
          <ac:chgData name="Sivalingam, Jeyaluxmy" userId="96f68579-a127-49fa-9da1-6d3ea75fe666" providerId="ADAL" clId="{9672C6C1-9324-409B-9F17-6D4882F253CE}" dt="2025-12-23T18:00:40.383" v="4797" actId="1076"/>
          <ac:graphicFrameMkLst>
            <pc:docMk/>
            <pc:sldMk cId="4161354762" sldId="652"/>
            <ac:graphicFrameMk id="4" creationId="{5F1F3D8D-A17C-0EE5-D434-AAB6DA686F2E}"/>
          </ac:graphicFrameMkLst>
        </pc:graphicFrameChg>
        <pc:picChg chg="add mod">
          <ac:chgData name="Sivalingam, Jeyaluxmy" userId="96f68579-a127-49fa-9da1-6d3ea75fe666" providerId="ADAL" clId="{9672C6C1-9324-409B-9F17-6D4882F253CE}" dt="2025-12-23T17:59:32.031" v="4783" actId="1076"/>
          <ac:picMkLst>
            <pc:docMk/>
            <pc:sldMk cId="4161354762" sldId="652"/>
            <ac:picMk id="5" creationId="{CA18BEE3-D779-1FBB-1557-6BD176AF7B07}"/>
          </ac:picMkLst>
        </pc:picChg>
        <pc:picChg chg="add mod">
          <ac:chgData name="Sivalingam, Jeyaluxmy" userId="96f68579-a127-49fa-9da1-6d3ea75fe666" providerId="ADAL" clId="{9672C6C1-9324-409B-9F17-6D4882F253CE}" dt="2025-12-23T18:00:29.216" v="4794" actId="14100"/>
          <ac:picMkLst>
            <pc:docMk/>
            <pc:sldMk cId="4161354762" sldId="652"/>
            <ac:picMk id="8" creationId="{0FA58F68-C831-1853-81CF-817714642936}"/>
          </ac:picMkLst>
        </pc:picChg>
        <pc:picChg chg="add mod">
          <ac:chgData name="Sivalingam, Jeyaluxmy" userId="96f68579-a127-49fa-9da1-6d3ea75fe666" providerId="ADAL" clId="{9672C6C1-9324-409B-9F17-6D4882F253CE}" dt="2025-12-23T18:06:22.709" v="4875" actId="1076"/>
          <ac:picMkLst>
            <pc:docMk/>
            <pc:sldMk cId="4161354762" sldId="652"/>
            <ac:picMk id="17" creationId="{2C9C0417-8670-2F8A-ECD7-471406F63AA4}"/>
          </ac:picMkLst>
        </pc:picChg>
      </pc:sldChg>
      <pc:sldChg chg="addSp delSp modSp new mod">
        <pc:chgData name="Sivalingam, Jeyaluxmy" userId="96f68579-a127-49fa-9da1-6d3ea75fe666" providerId="ADAL" clId="{9672C6C1-9324-409B-9F17-6D4882F253CE}" dt="2025-12-23T18:03:18.254" v="4846" actId="21"/>
        <pc:sldMkLst>
          <pc:docMk/>
          <pc:sldMk cId="3595176212" sldId="653"/>
        </pc:sldMkLst>
        <pc:spChg chg="add mod">
          <ac:chgData name="Sivalingam, Jeyaluxmy" userId="96f68579-a127-49fa-9da1-6d3ea75fe666" providerId="ADAL" clId="{9672C6C1-9324-409B-9F17-6D4882F253CE}" dt="2025-12-23T18:03:18.254" v="4846" actId="21"/>
          <ac:spMkLst>
            <pc:docMk/>
            <pc:sldMk cId="3595176212" sldId="653"/>
            <ac:spMk id="4" creationId="{68F2FBE5-2FF2-A0B8-29E7-06E8C261C0C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9293F-B867-498A-91E8-40B36F716F42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174181-6281-42AB-9D21-F9A469CFF4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745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1pPr>
    <a:lvl2pPr marL="347784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2pPr>
    <a:lvl3pPr marL="695567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3pPr>
    <a:lvl4pPr marL="1043350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4pPr>
    <a:lvl5pPr marL="1391133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5pPr>
    <a:lvl6pPr marL="1738916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6pPr>
    <a:lvl7pPr marL="2086700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7pPr>
    <a:lvl8pPr marL="2434482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8pPr>
    <a:lvl9pPr marL="2782266" algn="l" defTabSz="695567" rtl="0" eaLnBrk="1" latinLnBrk="0" hangingPunct="1">
      <a:defRPr sz="91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1"/>
            </a:lvl1pPr>
            <a:lvl2pPr marL="342876" indent="0" algn="ctr">
              <a:buNone/>
              <a:defRPr sz="1499"/>
            </a:lvl2pPr>
            <a:lvl3pPr marL="685754" indent="0" algn="ctr">
              <a:buNone/>
              <a:defRPr sz="1350"/>
            </a:lvl3pPr>
            <a:lvl4pPr marL="1028630" indent="0" algn="ctr">
              <a:buNone/>
              <a:defRPr sz="1200"/>
            </a:lvl4pPr>
            <a:lvl5pPr marL="1371506" indent="0" algn="ctr">
              <a:buNone/>
              <a:defRPr sz="1200"/>
            </a:lvl5pPr>
            <a:lvl6pPr marL="1714384" indent="0" algn="ctr">
              <a:buNone/>
              <a:defRPr sz="1200"/>
            </a:lvl6pPr>
            <a:lvl7pPr marL="2057260" indent="0" algn="ctr">
              <a:buNone/>
              <a:defRPr sz="1200"/>
            </a:lvl7pPr>
            <a:lvl8pPr marL="2400136" indent="0" algn="ctr">
              <a:buNone/>
              <a:defRPr sz="1200"/>
            </a:lvl8pPr>
            <a:lvl9pPr marL="2743014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556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815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26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621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4"/>
            <a:ext cx="5915025" cy="412062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7"/>
            <a:ext cx="5915025" cy="2166938"/>
          </a:xfrm>
        </p:spPr>
        <p:txBody>
          <a:bodyPr/>
          <a:lstStyle>
            <a:lvl1pPr marL="0" indent="0">
              <a:buNone/>
              <a:defRPr sz="1801">
                <a:solidFill>
                  <a:schemeClr val="tx1">
                    <a:tint val="82000"/>
                  </a:schemeClr>
                </a:solidFill>
              </a:defRPr>
            </a:lvl1pPr>
            <a:lvl2pPr marL="342876" indent="0">
              <a:buNone/>
              <a:defRPr sz="1499">
                <a:solidFill>
                  <a:schemeClr val="tx1">
                    <a:tint val="82000"/>
                  </a:schemeClr>
                </a:solidFill>
              </a:defRPr>
            </a:lvl2pPr>
            <a:lvl3pPr marL="685754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63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506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384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26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136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014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573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3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3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02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7"/>
            <a:ext cx="5915025" cy="191470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9"/>
            <a:ext cx="2901255" cy="1190096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876" indent="0">
              <a:buNone/>
              <a:defRPr sz="1499" b="1"/>
            </a:lvl2pPr>
            <a:lvl3pPr marL="685754" indent="0">
              <a:buNone/>
              <a:defRPr sz="1350" b="1"/>
            </a:lvl3pPr>
            <a:lvl4pPr marL="1028630" indent="0">
              <a:buNone/>
              <a:defRPr sz="1200" b="1"/>
            </a:lvl4pPr>
            <a:lvl5pPr marL="1371506" indent="0">
              <a:buNone/>
              <a:defRPr sz="1200" b="1"/>
            </a:lvl5pPr>
            <a:lvl6pPr marL="1714384" indent="0">
              <a:buNone/>
              <a:defRPr sz="1200" b="1"/>
            </a:lvl6pPr>
            <a:lvl7pPr marL="2057260" indent="0">
              <a:buNone/>
              <a:defRPr sz="1200" b="1"/>
            </a:lvl7pPr>
            <a:lvl8pPr marL="2400136" indent="0">
              <a:buNone/>
              <a:defRPr sz="1200" b="1"/>
            </a:lvl8pPr>
            <a:lvl9pPr marL="274301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428349"/>
            <a:ext cx="2915543" cy="1190096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876" indent="0">
              <a:buNone/>
              <a:defRPr sz="1499" b="1"/>
            </a:lvl2pPr>
            <a:lvl3pPr marL="685754" indent="0">
              <a:buNone/>
              <a:defRPr sz="1350" b="1"/>
            </a:lvl3pPr>
            <a:lvl4pPr marL="1028630" indent="0">
              <a:buNone/>
              <a:defRPr sz="1200" b="1"/>
            </a:lvl4pPr>
            <a:lvl5pPr marL="1371506" indent="0">
              <a:buNone/>
              <a:defRPr sz="1200" b="1"/>
            </a:lvl5pPr>
            <a:lvl6pPr marL="1714384" indent="0">
              <a:buNone/>
              <a:defRPr sz="1200" b="1"/>
            </a:lvl6pPr>
            <a:lvl7pPr marL="2057260" indent="0">
              <a:buNone/>
              <a:defRPr sz="1200" b="1"/>
            </a:lvl7pPr>
            <a:lvl8pPr marL="2400136" indent="0">
              <a:buNone/>
              <a:defRPr sz="1200" b="1"/>
            </a:lvl8pPr>
            <a:lvl9pPr marL="2743014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267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2153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677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2"/>
            <a:ext cx="3471863" cy="7039682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1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8"/>
          </a:xfrm>
        </p:spPr>
        <p:txBody>
          <a:bodyPr/>
          <a:lstStyle>
            <a:lvl1pPr marL="0" indent="0">
              <a:buNone/>
              <a:defRPr sz="1200"/>
            </a:lvl1pPr>
            <a:lvl2pPr marL="342876" indent="0">
              <a:buNone/>
              <a:defRPr sz="1051"/>
            </a:lvl2pPr>
            <a:lvl3pPr marL="685754" indent="0">
              <a:buNone/>
              <a:defRPr sz="899"/>
            </a:lvl3pPr>
            <a:lvl4pPr marL="1028630" indent="0">
              <a:buNone/>
              <a:defRPr sz="750"/>
            </a:lvl4pPr>
            <a:lvl5pPr marL="1371506" indent="0">
              <a:buNone/>
              <a:defRPr sz="750"/>
            </a:lvl5pPr>
            <a:lvl6pPr marL="1714384" indent="0">
              <a:buNone/>
              <a:defRPr sz="750"/>
            </a:lvl6pPr>
            <a:lvl7pPr marL="2057260" indent="0">
              <a:buNone/>
              <a:defRPr sz="750"/>
            </a:lvl7pPr>
            <a:lvl8pPr marL="2400136" indent="0">
              <a:buNone/>
              <a:defRPr sz="750"/>
            </a:lvl8pPr>
            <a:lvl9pPr marL="274301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751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2"/>
            <a:ext cx="3471863" cy="7039682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6" indent="0">
              <a:buNone/>
              <a:defRPr sz="2100"/>
            </a:lvl2pPr>
            <a:lvl3pPr marL="685754" indent="0">
              <a:buNone/>
              <a:defRPr sz="1801"/>
            </a:lvl3pPr>
            <a:lvl4pPr marL="1028630" indent="0">
              <a:buNone/>
              <a:defRPr sz="1499"/>
            </a:lvl4pPr>
            <a:lvl5pPr marL="1371506" indent="0">
              <a:buNone/>
              <a:defRPr sz="1499"/>
            </a:lvl5pPr>
            <a:lvl6pPr marL="1714384" indent="0">
              <a:buNone/>
              <a:defRPr sz="1499"/>
            </a:lvl6pPr>
            <a:lvl7pPr marL="2057260" indent="0">
              <a:buNone/>
              <a:defRPr sz="1499"/>
            </a:lvl7pPr>
            <a:lvl8pPr marL="2400136" indent="0">
              <a:buNone/>
              <a:defRPr sz="1499"/>
            </a:lvl8pPr>
            <a:lvl9pPr marL="2743014" indent="0">
              <a:buNone/>
              <a:defRPr sz="149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8"/>
          </a:xfrm>
        </p:spPr>
        <p:txBody>
          <a:bodyPr/>
          <a:lstStyle>
            <a:lvl1pPr marL="0" indent="0">
              <a:buNone/>
              <a:defRPr sz="1200"/>
            </a:lvl1pPr>
            <a:lvl2pPr marL="342876" indent="0">
              <a:buNone/>
              <a:defRPr sz="1051"/>
            </a:lvl2pPr>
            <a:lvl3pPr marL="685754" indent="0">
              <a:buNone/>
              <a:defRPr sz="899"/>
            </a:lvl3pPr>
            <a:lvl4pPr marL="1028630" indent="0">
              <a:buNone/>
              <a:defRPr sz="750"/>
            </a:lvl4pPr>
            <a:lvl5pPr marL="1371506" indent="0">
              <a:buNone/>
              <a:defRPr sz="750"/>
            </a:lvl5pPr>
            <a:lvl6pPr marL="1714384" indent="0">
              <a:buNone/>
              <a:defRPr sz="750"/>
            </a:lvl6pPr>
            <a:lvl7pPr marL="2057260" indent="0">
              <a:buNone/>
              <a:defRPr sz="750"/>
            </a:lvl7pPr>
            <a:lvl8pPr marL="2400136" indent="0">
              <a:buNone/>
              <a:defRPr sz="750"/>
            </a:lvl8pPr>
            <a:lvl9pPr marL="2743014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7092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7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3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D279DE7-04BC-4765-A621-4ECA88FD9C19}" type="datetimeFigureOut">
              <a:rPr lang="en-US" smtClean="0"/>
              <a:t>12/2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8"/>
            <a:ext cx="2314575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9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9F07EE-B704-4D77-AED3-F2FFC13C59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11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754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8" indent="-171438" algn="l" defTabSz="685754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6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857192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8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46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22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98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76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52" indent="-171438" algn="l" defTabSz="68575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6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4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30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06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84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60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36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14" algn="l" defTabSz="68575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gif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92976B0-969B-610C-91C3-8F041079C87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A close-up of a microscope&#10;&#10;AI-generated content may be incorrect.">
            <a:extLst>
              <a:ext uri="{FF2B5EF4-FFF2-40B4-BE49-F238E27FC236}">
                <a16:creationId xmlns:a16="http://schemas.microsoft.com/office/drawing/2014/main" id="{566F7BB9-46AB-722C-5174-2C0A00BA54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405" y="452955"/>
            <a:ext cx="2894832" cy="2171124"/>
          </a:xfrm>
          <a:prstGeom prst="rect">
            <a:avLst/>
          </a:prstGeom>
        </p:spPr>
      </p:pic>
      <p:pic>
        <p:nvPicPr>
          <p:cNvPr id="15" name="Picture 14" descr="A green cells on a gray surface&#10;&#10;AI-generated content may be incorrect.">
            <a:extLst>
              <a:ext uri="{FF2B5EF4-FFF2-40B4-BE49-F238E27FC236}">
                <a16:creationId xmlns:a16="http://schemas.microsoft.com/office/drawing/2014/main" id="{1E981A29-EC98-2DFD-2E76-D76F54D2C6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452955"/>
            <a:ext cx="2894831" cy="217112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BDBBFEF0-1093-4603-34BB-89A7847EC7E0}"/>
              </a:ext>
            </a:extLst>
          </p:cNvPr>
          <p:cNvSpPr txBox="1"/>
          <p:nvPr/>
        </p:nvSpPr>
        <p:spPr>
          <a:xfrm>
            <a:off x="1376417" y="2887515"/>
            <a:ext cx="965329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>
                <a:latin typeface="Times New Roman" panose="02020603050405020304" pitchFamily="18" charset="0"/>
                <a:cs typeface="Times New Roman" panose="02020603050405020304" pitchFamily="18" charset="0"/>
              </a:rPr>
              <a:t>C4-2B 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0FF366-2A52-C994-5A04-AC5290FF05D9}"/>
              </a:ext>
            </a:extLst>
          </p:cNvPr>
          <p:cNvSpPr txBox="1"/>
          <p:nvPr/>
        </p:nvSpPr>
        <p:spPr>
          <a:xfrm>
            <a:off x="4299629" y="2887514"/>
            <a:ext cx="181011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>
                <a:latin typeface="Times New Roman" panose="02020603050405020304" pitchFamily="18" charset="0"/>
                <a:cs typeface="Times New Roman" panose="02020603050405020304" pitchFamily="18" charset="0"/>
              </a:rPr>
              <a:t>C4-2B L-MYC overexpression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023A4EB-E32E-DA67-878D-834FAF058637}"/>
              </a:ext>
            </a:extLst>
          </p:cNvPr>
          <p:cNvSpPr txBox="1"/>
          <p:nvPr/>
        </p:nvSpPr>
        <p:spPr>
          <a:xfrm>
            <a:off x="380405" y="3083438"/>
            <a:ext cx="6044458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live-cell images of C4-2B control cells and C4-2B cells overexpressing MYCL, illustrating marked changes in cellular morphology upon MYCL overexpression.</a:t>
            </a:r>
            <a:endParaRPr lang="en-US" sz="1200"/>
          </a:p>
        </p:txBody>
      </p:sp>
    </p:spTree>
    <p:extLst>
      <p:ext uri="{BB962C8B-B14F-4D97-AF65-F5344CB8AC3E}">
        <p14:creationId xmlns:p14="http://schemas.microsoft.com/office/powerpoint/2010/main" val="3889193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valingam, Jeyaluxmy</dc:creator>
  <cp:lastModifiedBy>Yu, Xiuping</cp:lastModifiedBy>
  <cp:revision>1</cp:revision>
  <dcterms:created xsi:type="dcterms:W3CDTF">2025-11-22T13:31:11Z</dcterms:created>
  <dcterms:modified xsi:type="dcterms:W3CDTF">2025-12-26T21:44:40Z</dcterms:modified>
</cp:coreProperties>
</file>